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ppt/charts/chartEx2.xml" ContentType="application/vnd.ms-office.chartex+xml"/>
  <Override PartName="/ppt/charts/style2.xml" ContentType="application/vnd.ms-office.chartstyle+xml"/>
  <Override PartName="/ppt/charts/colors2.xml" ContentType="application/vnd.ms-office.chartcolorstyl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2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3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4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65" r:id="rId2"/>
    <p:sldId id="271" r:id="rId3"/>
    <p:sldId id="289" r:id="rId4"/>
    <p:sldId id="284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3B38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9342"/>
    <p:restoredTop sz="95510"/>
  </p:normalViewPr>
  <p:slideViewPr>
    <p:cSldViewPr snapToGrid="0">
      <p:cViewPr varScale="1">
        <p:scale>
          <a:sx n="113" d="100"/>
          <a:sy n="113" d="100"/>
        </p:scale>
        <p:origin x="184" y="37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79" d="100"/>
        <a:sy n="79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lair Gardiner" userId="82df923b-1f6a-4a52-9516-04bd1aa69604" providerId="ADAL" clId="{1AE17FC1-D38F-0D44-9AE1-02B55E4E34C4}"/>
    <pc:docChg chg="delSld">
      <pc:chgData name="Clair Gardiner" userId="82df923b-1f6a-4a52-9516-04bd1aa69604" providerId="ADAL" clId="{1AE17FC1-D38F-0D44-9AE1-02B55E4E34C4}" dt="2024-05-22T13:57:51.775" v="0" actId="2696"/>
      <pc:docMkLst>
        <pc:docMk/>
      </pc:docMkLst>
      <pc:sldChg chg="del">
        <pc:chgData name="Clair Gardiner" userId="82df923b-1f6a-4a52-9516-04bd1aa69604" providerId="ADAL" clId="{1AE17FC1-D38F-0D44-9AE1-02B55E4E34C4}" dt="2024-05-22T13:57:51.775" v="0" actId="2696"/>
        <pc:sldMkLst>
          <pc:docMk/>
          <pc:sldMk cId="405632498" sldId="267"/>
        </pc:sldMkLst>
      </pc:sldChg>
      <pc:sldChg chg="del">
        <pc:chgData name="Clair Gardiner" userId="82df923b-1f6a-4a52-9516-04bd1aa69604" providerId="ADAL" clId="{1AE17FC1-D38F-0D44-9AE1-02B55E4E34C4}" dt="2024-05-22T13:57:51.775" v="0" actId="2696"/>
        <pc:sldMkLst>
          <pc:docMk/>
          <pc:sldMk cId="3154612806" sldId="273"/>
        </pc:sldMkLst>
      </pc:sldChg>
      <pc:sldChg chg="del">
        <pc:chgData name="Clair Gardiner" userId="82df923b-1f6a-4a52-9516-04bd1aa69604" providerId="ADAL" clId="{1AE17FC1-D38F-0D44-9AE1-02B55E4E34C4}" dt="2024-05-22T13:57:51.775" v="0" actId="2696"/>
        <pc:sldMkLst>
          <pc:docMk/>
          <pc:sldMk cId="2964562355" sldId="276"/>
        </pc:sldMkLst>
      </pc:sldChg>
      <pc:sldChg chg="del">
        <pc:chgData name="Clair Gardiner" userId="82df923b-1f6a-4a52-9516-04bd1aa69604" providerId="ADAL" clId="{1AE17FC1-D38F-0D44-9AE1-02B55E4E34C4}" dt="2024-05-22T13:57:51.775" v="0" actId="2696"/>
        <pc:sldMkLst>
          <pc:docMk/>
          <pc:sldMk cId="957727469" sldId="287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tcdud-my.sharepoint.com/personal/gardinec_tcd_ie/Documents/Covid-19/IFNlambda/Stats%20Caroline%20Brophy/Corrected%20DSS%20data%20OJ%20IFNL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tcdud-my.sharepoint.com/personal/gardinec_tcd_ie/Documents/Covid-19/IFNlambda/Stats%20Caroline%20Brophy/Corrected%20DSS%20data%20OJ%20IFNL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tcdud-my.sharepoint.com/personal/gardinec_tcd_ie/Documents/Covid-19/IFNlambda/Stats%20Caroline%20Brophy/Corrected%20DSS%20data%20OJ%20IFNL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tcdud-my.sharepoint.com/personal/gardinec_tcd_ie/Documents/Covid-19/IFNlambda/Stats%20Caroline%20Brophy/Corrected%20DSS%20data%20OJ%20IFNL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https://tcdud-my.sharepoint.com/personal/gardinec_tcd_ie/Documents/Covid-19/IFNlambda/Files%20from%20Adriana/figures%20colour%20and%20b%20and%20w.xlsx" TargetMode="External"/></Relationships>
</file>

<file path=ppt/charts/_rels/chartEx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https://tcdud-my.sharepoint.com/personal/gardinec_tcd_ie/Documents/Covid-19/IFNlambda/Paper%20info/from%20Emily%20Carr/SGULIFNLData_COVIDPositiveOnly%20DM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Corrected DSS data OJ IFNL.xlsx]DfSO, IFNL by WHO OJ (2)'!$P$505</c:f>
              <c:strCache>
                <c:ptCount val="1"/>
                <c:pt idx="0">
                  <c:v>WHO 1-2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cat>
            <c:strRef>
              <c:f>'[Corrected DSS data OJ IFNL.xlsx]DfSO, IFNL by WHO OJ (2)'!$Q$504:$T$504</c:f>
              <c:strCache>
                <c:ptCount val="4"/>
                <c:pt idx="0">
                  <c:v>d0-d7</c:v>
                </c:pt>
                <c:pt idx="1">
                  <c:v>d8-14</c:v>
                </c:pt>
                <c:pt idx="2">
                  <c:v>d15-30</c:v>
                </c:pt>
                <c:pt idx="3">
                  <c:v>d31-60</c:v>
                </c:pt>
              </c:strCache>
            </c:strRef>
          </c:cat>
          <c:val>
            <c:numRef>
              <c:f>'[Corrected DSS data OJ IFNL.xlsx]DfSO, IFNL by WHO OJ (2)'!$Q$505:$T$505</c:f>
              <c:numCache>
                <c:formatCode>0</c:formatCode>
                <c:ptCount val="4"/>
                <c:pt idx="0">
                  <c:v>397.35</c:v>
                </c:pt>
                <c:pt idx="1">
                  <c:v>470.8</c:v>
                </c:pt>
                <c:pt idx="2">
                  <c:v>383.4</c:v>
                </c:pt>
                <c:pt idx="3">
                  <c:v>311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40E-1142-9BD6-0DAC50A2E196}"/>
            </c:ext>
          </c:extLst>
        </c:ser>
        <c:ser>
          <c:idx val="1"/>
          <c:order val="1"/>
          <c:tx>
            <c:strRef>
              <c:f>'[Corrected DSS data OJ IFNL.xlsx]DfSO, IFNL by WHO OJ (2)'!$P$506</c:f>
              <c:strCache>
                <c:ptCount val="1"/>
                <c:pt idx="0">
                  <c:v>WHO 3-4</c:v>
                </c:pt>
              </c:strCache>
            </c:strRef>
          </c:tx>
          <c:spPr>
            <a:solidFill>
              <a:srgbClr val="3B3838"/>
            </a:solidFill>
            <a:ln>
              <a:noFill/>
            </a:ln>
            <a:effectLst/>
          </c:spPr>
          <c:invertIfNegative val="0"/>
          <c:cat>
            <c:strRef>
              <c:f>'[Corrected DSS data OJ IFNL.xlsx]DfSO, IFNL by WHO OJ (2)'!$Q$504:$T$504</c:f>
              <c:strCache>
                <c:ptCount val="4"/>
                <c:pt idx="0">
                  <c:v>d0-d7</c:v>
                </c:pt>
                <c:pt idx="1">
                  <c:v>d8-14</c:v>
                </c:pt>
                <c:pt idx="2">
                  <c:v>d15-30</c:v>
                </c:pt>
                <c:pt idx="3">
                  <c:v>d31-60</c:v>
                </c:pt>
              </c:strCache>
            </c:strRef>
          </c:cat>
          <c:val>
            <c:numRef>
              <c:f>'[Corrected DSS data OJ IFNL.xlsx]DfSO, IFNL by WHO OJ (2)'!$Q$506:$T$506</c:f>
              <c:numCache>
                <c:formatCode>0</c:formatCode>
                <c:ptCount val="4"/>
                <c:pt idx="0">
                  <c:v>221.7</c:v>
                </c:pt>
                <c:pt idx="1">
                  <c:v>653.1</c:v>
                </c:pt>
                <c:pt idx="2">
                  <c:v>346.7</c:v>
                </c:pt>
                <c:pt idx="3">
                  <c:v>816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40E-1142-9BD6-0DAC50A2E196}"/>
            </c:ext>
          </c:extLst>
        </c:ser>
        <c:ser>
          <c:idx val="2"/>
          <c:order val="2"/>
          <c:tx>
            <c:strRef>
              <c:f>'[Corrected DSS data OJ IFNL.xlsx]DfSO, IFNL by WHO OJ (2)'!$P$507</c:f>
              <c:strCache>
                <c:ptCount val="1"/>
                <c:pt idx="0">
                  <c:v>WHO 5-8</c:v>
                </c:pt>
              </c:strCache>
            </c:strRef>
          </c:tx>
          <c:spPr>
            <a:solidFill>
              <a:srgbClr val="000000"/>
            </a:solidFill>
            <a:ln>
              <a:noFill/>
            </a:ln>
            <a:effectLst/>
          </c:spPr>
          <c:invertIfNegative val="0"/>
          <c:cat>
            <c:strRef>
              <c:f>'[Corrected DSS data OJ IFNL.xlsx]DfSO, IFNL by WHO OJ (2)'!$Q$504:$T$504</c:f>
              <c:strCache>
                <c:ptCount val="4"/>
                <c:pt idx="0">
                  <c:v>d0-d7</c:v>
                </c:pt>
                <c:pt idx="1">
                  <c:v>d8-14</c:v>
                </c:pt>
                <c:pt idx="2">
                  <c:v>d15-30</c:v>
                </c:pt>
                <c:pt idx="3">
                  <c:v>d31-60</c:v>
                </c:pt>
              </c:strCache>
            </c:strRef>
          </c:cat>
          <c:val>
            <c:numRef>
              <c:f>'[Corrected DSS data OJ IFNL.xlsx]DfSO, IFNL by WHO OJ (2)'!$Q$507:$T$507</c:f>
              <c:numCache>
                <c:formatCode>0</c:formatCode>
                <c:ptCount val="4"/>
                <c:pt idx="0">
                  <c:v>336.8</c:v>
                </c:pt>
                <c:pt idx="1">
                  <c:v>387.8</c:v>
                </c:pt>
                <c:pt idx="2">
                  <c:v>754.84999999999991</c:v>
                </c:pt>
                <c:pt idx="3">
                  <c:v>177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40E-1142-9BD6-0DAC50A2E1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36825520"/>
        <c:axId val="52687295"/>
      </c:barChart>
      <c:catAx>
        <c:axId val="16368255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687295"/>
        <c:crosses val="autoZero"/>
        <c:auto val="1"/>
        <c:lblAlgn val="ctr"/>
        <c:lblOffset val="100"/>
        <c:noMultiLvlLbl val="0"/>
      </c:catAx>
      <c:valAx>
        <c:axId val="5268729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Median</a:t>
                </a:r>
                <a:r>
                  <a:rPr lang="en-US" baseline="0" dirty="0"/>
                  <a:t> IFNL3 (</a:t>
                </a:r>
                <a:r>
                  <a:rPr lang="en-US" baseline="0" dirty="0" err="1"/>
                  <a:t>pg</a:t>
                </a:r>
                <a:r>
                  <a:rPr lang="en-US" baseline="0" dirty="0"/>
                  <a:t>/ml)</a:t>
                </a:r>
                <a:endParaRPr lang="en-US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368255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dk1">
                  <a:tint val="885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xVal>
            <c:numRef>
              <c:f>'[Corrected DSS data OJ IFNL.xlsx]Scatter plot DfSO WHO IFNL3'!$A$8:$A$146</c:f>
              <c:numCache>
                <c:formatCode>General</c:formatCode>
                <c:ptCount val="139"/>
                <c:pt idx="0">
                  <c:v>2</c:v>
                </c:pt>
                <c:pt idx="1">
                  <c:v>0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5</c:v>
                </c:pt>
                <c:pt idx="6">
                  <c:v>7</c:v>
                </c:pt>
                <c:pt idx="7">
                  <c:v>6</c:v>
                </c:pt>
                <c:pt idx="8">
                  <c:v>5</c:v>
                </c:pt>
                <c:pt idx="9">
                  <c:v>6</c:v>
                </c:pt>
                <c:pt idx="10">
                  <c:v>8</c:v>
                </c:pt>
                <c:pt idx="11">
                  <c:v>10</c:v>
                </c:pt>
                <c:pt idx="12">
                  <c:v>10</c:v>
                </c:pt>
                <c:pt idx="13">
                  <c:v>8</c:v>
                </c:pt>
                <c:pt idx="14">
                  <c:v>11</c:v>
                </c:pt>
                <c:pt idx="15">
                  <c:v>10</c:v>
                </c:pt>
                <c:pt idx="16">
                  <c:v>10</c:v>
                </c:pt>
                <c:pt idx="17">
                  <c:v>11</c:v>
                </c:pt>
                <c:pt idx="18">
                  <c:v>12</c:v>
                </c:pt>
                <c:pt idx="19">
                  <c:v>12</c:v>
                </c:pt>
                <c:pt idx="20">
                  <c:v>13</c:v>
                </c:pt>
                <c:pt idx="21">
                  <c:v>14</c:v>
                </c:pt>
                <c:pt idx="22">
                  <c:v>14</c:v>
                </c:pt>
                <c:pt idx="23">
                  <c:v>13</c:v>
                </c:pt>
                <c:pt idx="24">
                  <c:v>14</c:v>
                </c:pt>
                <c:pt idx="25">
                  <c:v>16</c:v>
                </c:pt>
                <c:pt idx="26">
                  <c:v>20</c:v>
                </c:pt>
                <c:pt idx="27">
                  <c:v>20</c:v>
                </c:pt>
                <c:pt idx="28">
                  <c:v>15</c:v>
                </c:pt>
                <c:pt idx="30">
                  <c:v>16</c:v>
                </c:pt>
                <c:pt idx="31">
                  <c:v>16</c:v>
                </c:pt>
                <c:pt idx="32">
                  <c:v>16</c:v>
                </c:pt>
                <c:pt idx="33">
                  <c:v>19</c:v>
                </c:pt>
                <c:pt idx="34">
                  <c:v>19</c:v>
                </c:pt>
                <c:pt idx="35">
                  <c:v>19</c:v>
                </c:pt>
                <c:pt idx="36">
                  <c:v>20</c:v>
                </c:pt>
                <c:pt idx="37">
                  <c:v>20</c:v>
                </c:pt>
                <c:pt idx="38">
                  <c:v>21</c:v>
                </c:pt>
                <c:pt idx="39">
                  <c:v>22</c:v>
                </c:pt>
                <c:pt idx="40">
                  <c:v>23</c:v>
                </c:pt>
                <c:pt idx="41">
                  <c:v>24</c:v>
                </c:pt>
                <c:pt idx="42">
                  <c:v>24</c:v>
                </c:pt>
                <c:pt idx="43">
                  <c:v>25</c:v>
                </c:pt>
                <c:pt idx="44">
                  <c:v>27</c:v>
                </c:pt>
                <c:pt idx="45">
                  <c:v>27</c:v>
                </c:pt>
                <c:pt idx="46">
                  <c:v>28</c:v>
                </c:pt>
                <c:pt idx="47">
                  <c:v>29</c:v>
                </c:pt>
                <c:pt idx="48">
                  <c:v>29</c:v>
                </c:pt>
                <c:pt idx="49">
                  <c:v>30</c:v>
                </c:pt>
                <c:pt idx="50">
                  <c:v>19</c:v>
                </c:pt>
                <c:pt idx="51">
                  <c:v>22</c:v>
                </c:pt>
                <c:pt idx="52">
                  <c:v>30</c:v>
                </c:pt>
                <c:pt idx="53">
                  <c:v>33</c:v>
                </c:pt>
                <c:pt idx="54">
                  <c:v>37</c:v>
                </c:pt>
                <c:pt idx="55">
                  <c:v>40</c:v>
                </c:pt>
                <c:pt idx="56">
                  <c:v>40</c:v>
                </c:pt>
                <c:pt idx="57">
                  <c:v>41</c:v>
                </c:pt>
                <c:pt idx="58">
                  <c:v>45</c:v>
                </c:pt>
                <c:pt idx="59">
                  <c:v>47</c:v>
                </c:pt>
                <c:pt idx="60">
                  <c:v>54</c:v>
                </c:pt>
                <c:pt idx="61">
                  <c:v>56</c:v>
                </c:pt>
                <c:pt idx="62">
                  <c:v>57</c:v>
                </c:pt>
                <c:pt idx="63">
                  <c:v>60</c:v>
                </c:pt>
                <c:pt idx="64">
                  <c:v>60</c:v>
                </c:pt>
                <c:pt idx="65">
                  <c:v>31</c:v>
                </c:pt>
                <c:pt idx="66">
                  <c:v>34</c:v>
                </c:pt>
                <c:pt idx="67">
                  <c:v>34</c:v>
                </c:pt>
                <c:pt idx="68">
                  <c:v>35</c:v>
                </c:pt>
                <c:pt idx="69">
                  <c:v>36</c:v>
                </c:pt>
                <c:pt idx="70">
                  <c:v>36</c:v>
                </c:pt>
                <c:pt idx="71">
                  <c:v>36</c:v>
                </c:pt>
                <c:pt idx="72">
                  <c:v>39</c:v>
                </c:pt>
                <c:pt idx="73">
                  <c:v>40</c:v>
                </c:pt>
                <c:pt idx="74">
                  <c:v>40</c:v>
                </c:pt>
                <c:pt idx="75">
                  <c:v>41</c:v>
                </c:pt>
                <c:pt idx="76">
                  <c:v>42</c:v>
                </c:pt>
                <c:pt idx="77">
                  <c:v>42</c:v>
                </c:pt>
                <c:pt idx="78">
                  <c:v>43</c:v>
                </c:pt>
                <c:pt idx="79">
                  <c:v>43</c:v>
                </c:pt>
                <c:pt idx="80">
                  <c:v>48</c:v>
                </c:pt>
                <c:pt idx="81">
                  <c:v>48</c:v>
                </c:pt>
                <c:pt idx="82">
                  <c:v>49</c:v>
                </c:pt>
                <c:pt idx="83">
                  <c:v>50</c:v>
                </c:pt>
                <c:pt idx="84">
                  <c:v>52</c:v>
                </c:pt>
                <c:pt idx="85">
                  <c:v>53</c:v>
                </c:pt>
                <c:pt idx="86">
                  <c:v>53</c:v>
                </c:pt>
                <c:pt idx="87">
                  <c:v>53</c:v>
                </c:pt>
                <c:pt idx="88">
                  <c:v>53</c:v>
                </c:pt>
                <c:pt idx="89">
                  <c:v>55</c:v>
                </c:pt>
                <c:pt idx="90">
                  <c:v>56</c:v>
                </c:pt>
                <c:pt idx="91">
                  <c:v>57</c:v>
                </c:pt>
                <c:pt idx="92">
                  <c:v>58</c:v>
                </c:pt>
                <c:pt idx="93">
                  <c:v>59</c:v>
                </c:pt>
                <c:pt idx="94">
                  <c:v>36</c:v>
                </c:pt>
                <c:pt idx="95">
                  <c:v>52</c:v>
                </c:pt>
                <c:pt idx="96">
                  <c:v>59</c:v>
                </c:pt>
                <c:pt idx="97">
                  <c:v>63</c:v>
                </c:pt>
                <c:pt idx="98">
                  <c:v>68</c:v>
                </c:pt>
                <c:pt idx="99">
                  <c:v>70</c:v>
                </c:pt>
                <c:pt idx="100">
                  <c:v>71</c:v>
                </c:pt>
                <c:pt idx="101">
                  <c:v>85</c:v>
                </c:pt>
                <c:pt idx="102">
                  <c:v>101</c:v>
                </c:pt>
                <c:pt idx="103">
                  <c:v>108</c:v>
                </c:pt>
                <c:pt idx="104">
                  <c:v>114</c:v>
                </c:pt>
                <c:pt idx="105">
                  <c:v>140</c:v>
                </c:pt>
                <c:pt idx="106">
                  <c:v>255</c:v>
                </c:pt>
                <c:pt idx="107">
                  <c:v>61</c:v>
                </c:pt>
                <c:pt idx="108">
                  <c:v>61</c:v>
                </c:pt>
                <c:pt idx="109">
                  <c:v>61</c:v>
                </c:pt>
                <c:pt idx="110">
                  <c:v>62</c:v>
                </c:pt>
                <c:pt idx="111">
                  <c:v>62</c:v>
                </c:pt>
                <c:pt idx="112">
                  <c:v>63</c:v>
                </c:pt>
                <c:pt idx="113">
                  <c:v>65</c:v>
                </c:pt>
                <c:pt idx="114">
                  <c:v>66</c:v>
                </c:pt>
                <c:pt idx="115">
                  <c:v>66</c:v>
                </c:pt>
                <c:pt idx="116">
                  <c:v>68</c:v>
                </c:pt>
                <c:pt idx="117">
                  <c:v>69</c:v>
                </c:pt>
                <c:pt idx="118">
                  <c:v>71</c:v>
                </c:pt>
                <c:pt idx="119">
                  <c:v>71</c:v>
                </c:pt>
                <c:pt idx="120">
                  <c:v>76</c:v>
                </c:pt>
                <c:pt idx="121">
                  <c:v>78</c:v>
                </c:pt>
                <c:pt idx="122">
                  <c:v>79</c:v>
                </c:pt>
                <c:pt idx="123">
                  <c:v>86</c:v>
                </c:pt>
                <c:pt idx="124">
                  <c:v>88</c:v>
                </c:pt>
                <c:pt idx="125">
                  <c:v>92</c:v>
                </c:pt>
                <c:pt idx="126">
                  <c:v>95</c:v>
                </c:pt>
                <c:pt idx="127">
                  <c:v>100</c:v>
                </c:pt>
                <c:pt idx="128">
                  <c:v>105</c:v>
                </c:pt>
                <c:pt idx="129">
                  <c:v>110</c:v>
                </c:pt>
                <c:pt idx="130">
                  <c:v>110</c:v>
                </c:pt>
                <c:pt idx="131">
                  <c:v>61</c:v>
                </c:pt>
                <c:pt idx="132">
                  <c:v>104</c:v>
                </c:pt>
                <c:pt idx="133">
                  <c:v>110</c:v>
                </c:pt>
                <c:pt idx="134">
                  <c:v>123</c:v>
                </c:pt>
                <c:pt idx="135">
                  <c:v>124</c:v>
                </c:pt>
                <c:pt idx="136">
                  <c:v>95</c:v>
                </c:pt>
                <c:pt idx="137">
                  <c:v>135</c:v>
                </c:pt>
                <c:pt idx="138">
                  <c:v>185</c:v>
                </c:pt>
              </c:numCache>
            </c:numRef>
          </c:xVal>
          <c:yVal>
            <c:numRef>
              <c:f>'[Corrected DSS data OJ IFNL.xlsx]Scatter plot DfSO WHO IFNL3'!$B$8:$B$146</c:f>
            </c:numRef>
          </c:yVal>
          <c:smooth val="0"/>
          <c:extLst>
            <c:ext xmlns:c16="http://schemas.microsoft.com/office/drawing/2014/chart" uri="{C3380CC4-5D6E-409C-BE32-E72D297353CC}">
              <c16:uniqueId val="{00000000-6BF5-8F43-8903-07F467A44C99}"/>
            </c:ext>
          </c:extLst>
        </c:ser>
        <c:ser>
          <c:idx val="1"/>
          <c:order val="1"/>
          <c:tx>
            <c:v>WHO1-2</c:v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5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xVal>
            <c:numRef>
              <c:f>'[Corrected DSS data OJ IFNL.xlsx]Scatter plot DfSO WHO IFNL3'!$A$8:$A$146</c:f>
              <c:numCache>
                <c:formatCode>General</c:formatCode>
                <c:ptCount val="139"/>
                <c:pt idx="0">
                  <c:v>2</c:v>
                </c:pt>
                <c:pt idx="1">
                  <c:v>0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5</c:v>
                </c:pt>
                <c:pt idx="6">
                  <c:v>7</c:v>
                </c:pt>
                <c:pt idx="7">
                  <c:v>6</c:v>
                </c:pt>
                <c:pt idx="8">
                  <c:v>5</c:v>
                </c:pt>
                <c:pt idx="9">
                  <c:v>6</c:v>
                </c:pt>
                <c:pt idx="10">
                  <c:v>8</c:v>
                </c:pt>
                <c:pt idx="11">
                  <c:v>10</c:v>
                </c:pt>
                <c:pt idx="12">
                  <c:v>10</c:v>
                </c:pt>
                <c:pt idx="13">
                  <c:v>8</c:v>
                </c:pt>
                <c:pt idx="14">
                  <c:v>11</c:v>
                </c:pt>
                <c:pt idx="15">
                  <c:v>10</c:v>
                </c:pt>
                <c:pt idx="16">
                  <c:v>10</c:v>
                </c:pt>
                <c:pt idx="17">
                  <c:v>11</c:v>
                </c:pt>
                <c:pt idx="18">
                  <c:v>12</c:v>
                </c:pt>
                <c:pt idx="19">
                  <c:v>12</c:v>
                </c:pt>
                <c:pt idx="20">
                  <c:v>13</c:v>
                </c:pt>
                <c:pt idx="21">
                  <c:v>14</c:v>
                </c:pt>
                <c:pt idx="22">
                  <c:v>14</c:v>
                </c:pt>
                <c:pt idx="23">
                  <c:v>13</c:v>
                </c:pt>
                <c:pt idx="24">
                  <c:v>14</c:v>
                </c:pt>
                <c:pt idx="25">
                  <c:v>16</c:v>
                </c:pt>
                <c:pt idx="26">
                  <c:v>20</c:v>
                </c:pt>
                <c:pt idx="27">
                  <c:v>20</c:v>
                </c:pt>
                <c:pt idx="28">
                  <c:v>15</c:v>
                </c:pt>
                <c:pt idx="30">
                  <c:v>16</c:v>
                </c:pt>
                <c:pt idx="31">
                  <c:v>16</c:v>
                </c:pt>
                <c:pt idx="32">
                  <c:v>16</c:v>
                </c:pt>
                <c:pt idx="33">
                  <c:v>19</c:v>
                </c:pt>
                <c:pt idx="34">
                  <c:v>19</c:v>
                </c:pt>
                <c:pt idx="35">
                  <c:v>19</c:v>
                </c:pt>
                <c:pt idx="36">
                  <c:v>20</c:v>
                </c:pt>
                <c:pt idx="37">
                  <c:v>20</c:v>
                </c:pt>
                <c:pt idx="38">
                  <c:v>21</c:v>
                </c:pt>
                <c:pt idx="39">
                  <c:v>22</c:v>
                </c:pt>
                <c:pt idx="40">
                  <c:v>23</c:v>
                </c:pt>
                <c:pt idx="41">
                  <c:v>24</c:v>
                </c:pt>
                <c:pt idx="42">
                  <c:v>24</c:v>
                </c:pt>
                <c:pt idx="43">
                  <c:v>25</c:v>
                </c:pt>
                <c:pt idx="44">
                  <c:v>27</c:v>
                </c:pt>
                <c:pt idx="45">
                  <c:v>27</c:v>
                </c:pt>
                <c:pt idx="46">
                  <c:v>28</c:v>
                </c:pt>
                <c:pt idx="47">
                  <c:v>29</c:v>
                </c:pt>
                <c:pt idx="48">
                  <c:v>29</c:v>
                </c:pt>
                <c:pt idx="49">
                  <c:v>30</c:v>
                </c:pt>
                <c:pt idx="50">
                  <c:v>19</c:v>
                </c:pt>
                <c:pt idx="51">
                  <c:v>22</c:v>
                </c:pt>
                <c:pt idx="52">
                  <c:v>30</c:v>
                </c:pt>
                <c:pt idx="53">
                  <c:v>33</c:v>
                </c:pt>
                <c:pt idx="54">
                  <c:v>37</c:v>
                </c:pt>
                <c:pt idx="55">
                  <c:v>40</c:v>
                </c:pt>
                <c:pt idx="56">
                  <c:v>40</c:v>
                </c:pt>
                <c:pt idx="57">
                  <c:v>41</c:v>
                </c:pt>
                <c:pt idx="58">
                  <c:v>45</c:v>
                </c:pt>
                <c:pt idx="59">
                  <c:v>47</c:v>
                </c:pt>
                <c:pt idx="60">
                  <c:v>54</c:v>
                </c:pt>
                <c:pt idx="61">
                  <c:v>56</c:v>
                </c:pt>
                <c:pt idx="62">
                  <c:v>57</c:v>
                </c:pt>
                <c:pt idx="63">
                  <c:v>60</c:v>
                </c:pt>
                <c:pt idx="64">
                  <c:v>60</c:v>
                </c:pt>
                <c:pt idx="65">
                  <c:v>31</c:v>
                </c:pt>
                <c:pt idx="66">
                  <c:v>34</c:v>
                </c:pt>
                <c:pt idx="67">
                  <c:v>34</c:v>
                </c:pt>
                <c:pt idx="68">
                  <c:v>35</c:v>
                </c:pt>
                <c:pt idx="69">
                  <c:v>36</c:v>
                </c:pt>
                <c:pt idx="70">
                  <c:v>36</c:v>
                </c:pt>
                <c:pt idx="71">
                  <c:v>36</c:v>
                </c:pt>
                <c:pt idx="72">
                  <c:v>39</c:v>
                </c:pt>
                <c:pt idx="73">
                  <c:v>40</c:v>
                </c:pt>
                <c:pt idx="74">
                  <c:v>40</c:v>
                </c:pt>
                <c:pt idx="75">
                  <c:v>41</c:v>
                </c:pt>
                <c:pt idx="76">
                  <c:v>42</c:v>
                </c:pt>
                <c:pt idx="77">
                  <c:v>42</c:v>
                </c:pt>
                <c:pt idx="78">
                  <c:v>43</c:v>
                </c:pt>
                <c:pt idx="79">
                  <c:v>43</c:v>
                </c:pt>
                <c:pt idx="80">
                  <c:v>48</c:v>
                </c:pt>
                <c:pt idx="81">
                  <c:v>48</c:v>
                </c:pt>
                <c:pt idx="82">
                  <c:v>49</c:v>
                </c:pt>
                <c:pt idx="83">
                  <c:v>50</c:v>
                </c:pt>
                <c:pt idx="84">
                  <c:v>52</c:v>
                </c:pt>
                <c:pt idx="85">
                  <c:v>53</c:v>
                </c:pt>
                <c:pt idx="86">
                  <c:v>53</c:v>
                </c:pt>
                <c:pt idx="87">
                  <c:v>53</c:v>
                </c:pt>
                <c:pt idx="88">
                  <c:v>53</c:v>
                </c:pt>
                <c:pt idx="89">
                  <c:v>55</c:v>
                </c:pt>
                <c:pt idx="90">
                  <c:v>56</c:v>
                </c:pt>
                <c:pt idx="91">
                  <c:v>57</c:v>
                </c:pt>
                <c:pt idx="92">
                  <c:v>58</c:v>
                </c:pt>
                <c:pt idx="93">
                  <c:v>59</c:v>
                </c:pt>
                <c:pt idx="94">
                  <c:v>36</c:v>
                </c:pt>
                <c:pt idx="95">
                  <c:v>52</c:v>
                </c:pt>
                <c:pt idx="96">
                  <c:v>59</c:v>
                </c:pt>
                <c:pt idx="97">
                  <c:v>63</c:v>
                </c:pt>
                <c:pt idx="98">
                  <c:v>68</c:v>
                </c:pt>
                <c:pt idx="99">
                  <c:v>70</c:v>
                </c:pt>
                <c:pt idx="100">
                  <c:v>71</c:v>
                </c:pt>
                <c:pt idx="101">
                  <c:v>85</c:v>
                </c:pt>
                <c:pt idx="102">
                  <c:v>101</c:v>
                </c:pt>
                <c:pt idx="103">
                  <c:v>108</c:v>
                </c:pt>
                <c:pt idx="104">
                  <c:v>114</c:v>
                </c:pt>
                <c:pt idx="105">
                  <c:v>140</c:v>
                </c:pt>
                <c:pt idx="106">
                  <c:v>255</c:v>
                </c:pt>
                <c:pt idx="107">
                  <c:v>61</c:v>
                </c:pt>
                <c:pt idx="108">
                  <c:v>61</c:v>
                </c:pt>
                <c:pt idx="109">
                  <c:v>61</c:v>
                </c:pt>
                <c:pt idx="110">
                  <c:v>62</c:v>
                </c:pt>
                <c:pt idx="111">
                  <c:v>62</c:v>
                </c:pt>
                <c:pt idx="112">
                  <c:v>63</c:v>
                </c:pt>
                <c:pt idx="113">
                  <c:v>65</c:v>
                </c:pt>
                <c:pt idx="114">
                  <c:v>66</c:v>
                </c:pt>
                <c:pt idx="115">
                  <c:v>66</c:v>
                </c:pt>
                <c:pt idx="116">
                  <c:v>68</c:v>
                </c:pt>
                <c:pt idx="117">
                  <c:v>69</c:v>
                </c:pt>
                <c:pt idx="118">
                  <c:v>71</c:v>
                </c:pt>
                <c:pt idx="119">
                  <c:v>71</c:v>
                </c:pt>
                <c:pt idx="120">
                  <c:v>76</c:v>
                </c:pt>
                <c:pt idx="121">
                  <c:v>78</c:v>
                </c:pt>
                <c:pt idx="122">
                  <c:v>79</c:v>
                </c:pt>
                <c:pt idx="123">
                  <c:v>86</c:v>
                </c:pt>
                <c:pt idx="124">
                  <c:v>88</c:v>
                </c:pt>
                <c:pt idx="125">
                  <c:v>92</c:v>
                </c:pt>
                <c:pt idx="126">
                  <c:v>95</c:v>
                </c:pt>
                <c:pt idx="127">
                  <c:v>100</c:v>
                </c:pt>
                <c:pt idx="128">
                  <c:v>105</c:v>
                </c:pt>
                <c:pt idx="129">
                  <c:v>110</c:v>
                </c:pt>
                <c:pt idx="130">
                  <c:v>110</c:v>
                </c:pt>
                <c:pt idx="131">
                  <c:v>61</c:v>
                </c:pt>
                <c:pt idx="132">
                  <c:v>104</c:v>
                </c:pt>
                <c:pt idx="133">
                  <c:v>110</c:v>
                </c:pt>
                <c:pt idx="134">
                  <c:v>123</c:v>
                </c:pt>
                <c:pt idx="135">
                  <c:v>124</c:v>
                </c:pt>
                <c:pt idx="136">
                  <c:v>95</c:v>
                </c:pt>
                <c:pt idx="137">
                  <c:v>135</c:v>
                </c:pt>
                <c:pt idx="138">
                  <c:v>185</c:v>
                </c:pt>
              </c:numCache>
            </c:numRef>
          </c:xVal>
          <c:yVal>
            <c:numRef>
              <c:f>'[Corrected DSS data OJ IFNL.xlsx]Scatter plot DfSO WHO IFNL3'!$C$8:$C$146</c:f>
              <c:numCache>
                <c:formatCode>General</c:formatCode>
                <c:ptCount val="139"/>
                <c:pt idx="0">
                  <c:v>3.7375901662857216</c:v>
                </c:pt>
                <c:pt idx="1">
                  <c:v>2.3760291817281805</c:v>
                </c:pt>
                <c:pt idx="2">
                  <c:v>2.5121505369220305</c:v>
                </c:pt>
                <c:pt idx="3">
                  <c:v>3.7797407511767407</c:v>
                </c:pt>
                <c:pt idx="4">
                  <c:v>2.6573427368146261</c:v>
                </c:pt>
                <c:pt idx="5">
                  <c:v>2.5747255835940734</c:v>
                </c:pt>
                <c:pt idx="6">
                  <c:v>2.3541084391474008</c:v>
                </c:pt>
                <c:pt idx="7">
                  <c:v>2.7849737099544005</c:v>
                </c:pt>
                <c:pt idx="8">
                  <c:v>2.6243852414202653</c:v>
                </c:pt>
                <c:pt idx="9">
                  <c:v>2.3352572564345317</c:v>
                </c:pt>
                <c:pt idx="10">
                  <c:v>2.6835873175727669</c:v>
                </c:pt>
                <c:pt idx="11">
                  <c:v>2.3604040547299387</c:v>
                </c:pt>
                <c:pt idx="12">
                  <c:v>3.13640344813399</c:v>
                </c:pt>
                <c:pt idx="13">
                  <c:v>2.7816835845073506</c:v>
                </c:pt>
                <c:pt idx="14">
                  <c:v>2.9650605206111984</c:v>
                </c:pt>
                <c:pt idx="15">
                  <c:v>2.6737579365495767</c:v>
                </c:pt>
                <c:pt idx="16">
                  <c:v>2.2988530764097068</c:v>
                </c:pt>
                <c:pt idx="17">
                  <c:v>2.4530123911214554</c:v>
                </c:pt>
                <c:pt idx="18">
                  <c:v>3.4353665066126613</c:v>
                </c:pt>
                <c:pt idx="19">
                  <c:v>2.1122697684172707</c:v>
                </c:pt>
                <c:pt idx="20">
                  <c:v>2.469822015978163</c:v>
                </c:pt>
                <c:pt idx="21">
                  <c:v>0</c:v>
                </c:pt>
                <c:pt idx="22">
                  <c:v>3.330819466495837</c:v>
                </c:pt>
                <c:pt idx="23">
                  <c:v>2.60788374435699</c:v>
                </c:pt>
                <c:pt idx="24">
                  <c:v>2.9194964878630616</c:v>
                </c:pt>
                <c:pt idx="25">
                  <c:v>3.5504729571065634</c:v>
                </c:pt>
                <c:pt idx="26">
                  <c:v>3.0606978403536118</c:v>
                </c:pt>
                <c:pt idx="27">
                  <c:v>0</c:v>
                </c:pt>
                <c:pt idx="28">
                  <c:v>2.875697761980208</c:v>
                </c:pt>
                <c:pt idx="29">
                  <c:v>0</c:v>
                </c:pt>
                <c:pt idx="30">
                  <c:v>2.1126050015345745</c:v>
                </c:pt>
                <c:pt idx="31">
                  <c:v>2.7628285531890904</c:v>
                </c:pt>
                <c:pt idx="32">
                  <c:v>2.3115419584011949</c:v>
                </c:pt>
                <c:pt idx="33">
                  <c:v>0</c:v>
                </c:pt>
                <c:pt idx="34">
                  <c:v>2.7335182514344876</c:v>
                </c:pt>
                <c:pt idx="35">
                  <c:v>2.2387985627139169</c:v>
                </c:pt>
                <c:pt idx="36">
                  <c:v>0</c:v>
                </c:pt>
                <c:pt idx="37">
                  <c:v>2.8868853589860088</c:v>
                </c:pt>
                <c:pt idx="38">
                  <c:v>2.265996370495079</c:v>
                </c:pt>
                <c:pt idx="39">
                  <c:v>3.1684974835230326</c:v>
                </c:pt>
                <c:pt idx="40">
                  <c:v>2.7512020945883533</c:v>
                </c:pt>
                <c:pt idx="41">
                  <c:v>2.4237372499823291</c:v>
                </c:pt>
                <c:pt idx="42">
                  <c:v>2.667452952889954</c:v>
                </c:pt>
                <c:pt idx="43">
                  <c:v>2.5689054149828787</c:v>
                </c:pt>
                <c:pt idx="44">
                  <c:v>2.5847833789965078</c:v>
                </c:pt>
                <c:pt idx="45">
                  <c:v>2.3443922736851106</c:v>
                </c:pt>
                <c:pt idx="46">
                  <c:v>2.6480671294489344</c:v>
                </c:pt>
                <c:pt idx="47">
                  <c:v>2.6058435390580894</c:v>
                </c:pt>
                <c:pt idx="48">
                  <c:v>2.5477747053878224</c:v>
                </c:pt>
                <c:pt idx="49">
                  <c:v>2.9210098014970343</c:v>
                </c:pt>
                <c:pt idx="50">
                  <c:v>0</c:v>
                </c:pt>
                <c:pt idx="51">
                  <c:v>2.398981066658131</c:v>
                </c:pt>
                <c:pt idx="52">
                  <c:v>2.4379090355394983</c:v>
                </c:pt>
                <c:pt idx="53">
                  <c:v>2.2332500095411003</c:v>
                </c:pt>
                <c:pt idx="54">
                  <c:v>1.8555191556678001</c:v>
                </c:pt>
                <c:pt idx="55">
                  <c:v>2.5014700721004122</c:v>
                </c:pt>
                <c:pt idx="56">
                  <c:v>2.8474492624991727</c:v>
                </c:pt>
                <c:pt idx="57">
                  <c:v>3.6784273224338673</c:v>
                </c:pt>
                <c:pt idx="58">
                  <c:v>2.5770319856260313</c:v>
                </c:pt>
                <c:pt idx="59">
                  <c:v>2.5169318088680126</c:v>
                </c:pt>
                <c:pt idx="60">
                  <c:v>2.4136349971985558</c:v>
                </c:pt>
                <c:pt idx="61">
                  <c:v>2.764325605625984</c:v>
                </c:pt>
                <c:pt idx="62">
                  <c:v>2.3634239329171765</c:v>
                </c:pt>
                <c:pt idx="63">
                  <c:v>2.375297738217339</c:v>
                </c:pt>
                <c:pt idx="64">
                  <c:v>2.5626496722119168</c:v>
                </c:pt>
                <c:pt idx="65">
                  <c:v>2.3424226808222062</c:v>
                </c:pt>
                <c:pt idx="66">
                  <c:v>2.4121244061733171</c:v>
                </c:pt>
                <c:pt idx="67">
                  <c:v>2.3134453704264142</c:v>
                </c:pt>
                <c:pt idx="68">
                  <c:v>2.1565491513317814</c:v>
                </c:pt>
                <c:pt idx="69">
                  <c:v>2.9346499229007108</c:v>
                </c:pt>
                <c:pt idx="70">
                  <c:v>2.7377490738915573</c:v>
                </c:pt>
                <c:pt idx="71">
                  <c:v>2.9939209588012869</c:v>
                </c:pt>
                <c:pt idx="72">
                  <c:v>2.5579881482249132</c:v>
                </c:pt>
                <c:pt idx="73">
                  <c:v>2.7974060496763822</c:v>
                </c:pt>
                <c:pt idx="74">
                  <c:v>2.5796692935547205</c:v>
                </c:pt>
                <c:pt idx="75">
                  <c:v>0</c:v>
                </c:pt>
                <c:pt idx="76">
                  <c:v>2.3533390953113047</c:v>
                </c:pt>
                <c:pt idx="77">
                  <c:v>2.3025473724874854</c:v>
                </c:pt>
                <c:pt idx="78">
                  <c:v>2.5016069224188295</c:v>
                </c:pt>
                <c:pt idx="79">
                  <c:v>2.4670158184384356</c:v>
                </c:pt>
                <c:pt idx="80">
                  <c:v>2.2221960463017201</c:v>
                </c:pt>
                <c:pt idx="81">
                  <c:v>2.5972562829251418</c:v>
                </c:pt>
                <c:pt idx="82">
                  <c:v>3.5626496722119168</c:v>
                </c:pt>
                <c:pt idx="83">
                  <c:v>2.0606978403536118</c:v>
                </c:pt>
                <c:pt idx="84">
                  <c:v>2.2367890994092927</c:v>
                </c:pt>
                <c:pt idx="85">
                  <c:v>2.5471591213274176</c:v>
                </c:pt>
                <c:pt idx="86">
                  <c:v>2.4747988188006311</c:v>
                </c:pt>
                <c:pt idx="87">
                  <c:v>2.388988785124714</c:v>
                </c:pt>
                <c:pt idx="88">
                  <c:v>2.4292676664331685</c:v>
                </c:pt>
                <c:pt idx="89">
                  <c:v>2.8857003801283301</c:v>
                </c:pt>
                <c:pt idx="90">
                  <c:v>2.3163897510731952</c:v>
                </c:pt>
                <c:pt idx="91">
                  <c:v>2.9027641439240859</c:v>
                </c:pt>
                <c:pt idx="92">
                  <c:v>2.7900035203904894</c:v>
                </c:pt>
                <c:pt idx="93">
                  <c:v>2.5464192668351915</c:v>
                </c:pt>
                <c:pt idx="94">
                  <c:v>2.4874212113594742</c:v>
                </c:pt>
                <c:pt idx="95">
                  <c:v>2.6380897219845059</c:v>
                </c:pt>
                <c:pt idx="96">
                  <c:v>2.2975416678181597</c:v>
                </c:pt>
                <c:pt idx="97">
                  <c:v>2.6516656039229356</c:v>
                </c:pt>
                <c:pt idx="98">
                  <c:v>2.6770591773921613</c:v>
                </c:pt>
                <c:pt idx="99">
                  <c:v>2.6030360562505215</c:v>
                </c:pt>
                <c:pt idx="100">
                  <c:v>2.3727279408855955</c:v>
                </c:pt>
                <c:pt idx="101">
                  <c:v>2.6604860157849677</c:v>
                </c:pt>
                <c:pt idx="102">
                  <c:v>2.5323721335678773</c:v>
                </c:pt>
                <c:pt idx="103">
                  <c:v>2.5970366649776535</c:v>
                </c:pt>
                <c:pt idx="104">
                  <c:v>2.8060442357480881</c:v>
                </c:pt>
                <c:pt idx="105">
                  <c:v>2.3496659840966299</c:v>
                </c:pt>
                <c:pt idx="106">
                  <c:v>2.5097400155703822</c:v>
                </c:pt>
                <c:pt idx="107">
                  <c:v>2.5254335534288201</c:v>
                </c:pt>
                <c:pt idx="108">
                  <c:v>2.3893433112520781</c:v>
                </c:pt>
                <c:pt idx="109">
                  <c:v>2.6351820486562678</c:v>
                </c:pt>
                <c:pt idx="110">
                  <c:v>2.7264826967848297</c:v>
                </c:pt>
                <c:pt idx="111">
                  <c:v>2.5699588180965942</c:v>
                </c:pt>
                <c:pt idx="112">
                  <c:v>2.6854730197227594</c:v>
                </c:pt>
                <c:pt idx="113">
                  <c:v>2.5588285248170117</c:v>
                </c:pt>
                <c:pt idx="114">
                  <c:v>2.2417954312951989</c:v>
                </c:pt>
                <c:pt idx="115">
                  <c:v>2.6594407818703178</c:v>
                </c:pt>
                <c:pt idx="116">
                  <c:v>2.2638726768652235</c:v>
                </c:pt>
                <c:pt idx="117">
                  <c:v>2.3712526291249394</c:v>
                </c:pt>
                <c:pt idx="118">
                  <c:v>2.4282968139828798</c:v>
                </c:pt>
                <c:pt idx="119">
                  <c:v>2.8151791301394185</c:v>
                </c:pt>
                <c:pt idx="120">
                  <c:v>2.5710096723093048</c:v>
                </c:pt>
                <c:pt idx="121">
                  <c:v>2.472171146692363</c:v>
                </c:pt>
                <c:pt idx="122">
                  <c:v>3.1589652603834102</c:v>
                </c:pt>
                <c:pt idx="123">
                  <c:v>2.781755374652469</c:v>
                </c:pt>
                <c:pt idx="124">
                  <c:v>2.4643404846276673</c:v>
                </c:pt>
                <c:pt idx="125">
                  <c:v>2.3070679506612985</c:v>
                </c:pt>
                <c:pt idx="126">
                  <c:v>2.7191654940892134</c:v>
                </c:pt>
                <c:pt idx="127">
                  <c:v>2.4197905861063629</c:v>
                </c:pt>
                <c:pt idx="128">
                  <c:v>2.2990712600274095</c:v>
                </c:pt>
                <c:pt idx="129">
                  <c:v>2.6706168864003255</c:v>
                </c:pt>
                <c:pt idx="130">
                  <c:v>2.7660408603813891</c:v>
                </c:pt>
                <c:pt idx="131">
                  <c:v>2.6938148538894167</c:v>
                </c:pt>
                <c:pt idx="132">
                  <c:v>2.4222614508136027</c:v>
                </c:pt>
                <c:pt idx="133">
                  <c:v>2.5440680443502757</c:v>
                </c:pt>
                <c:pt idx="134">
                  <c:v>2.4935974490005268</c:v>
                </c:pt>
                <c:pt idx="135">
                  <c:v>2.8300751664297503</c:v>
                </c:pt>
                <c:pt idx="136">
                  <c:v>2.7632033003707717</c:v>
                </c:pt>
                <c:pt idx="137">
                  <c:v>2.6404814369704219</c:v>
                </c:pt>
                <c:pt idx="138">
                  <c:v>2.63908787108373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BF5-8F43-8903-07F467A44C99}"/>
            </c:ext>
          </c:extLst>
        </c:ser>
        <c:ser>
          <c:idx val="2"/>
          <c:order val="2"/>
          <c:tx>
            <c:v>WHO3-4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75000"/>
                </a:schemeClr>
              </a:solidFill>
              <a:ln w="9525">
                <a:solidFill>
                  <a:schemeClr val="dk1">
                    <a:tint val="75000"/>
                  </a:schemeClr>
                </a:solidFill>
              </a:ln>
              <a:effectLst/>
            </c:spPr>
          </c:marker>
          <c:xVal>
            <c:numRef>
              <c:f>'[Corrected DSS data OJ IFNL.xlsx]Scatter plot DfSO WHO IFNL3'!$D$8:$D$106</c:f>
              <c:numCache>
                <c:formatCode>General</c:formatCode>
                <c:ptCount val="99"/>
                <c:pt idx="0">
                  <c:v>3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6</c:v>
                </c:pt>
                <c:pt idx="5">
                  <c:v>1</c:v>
                </c:pt>
                <c:pt idx="6">
                  <c:v>2</c:v>
                </c:pt>
                <c:pt idx="7">
                  <c:v>2</c:v>
                </c:pt>
                <c:pt idx="8">
                  <c:v>3</c:v>
                </c:pt>
                <c:pt idx="9">
                  <c:v>3</c:v>
                </c:pt>
                <c:pt idx="10">
                  <c:v>4</c:v>
                </c:pt>
                <c:pt idx="11">
                  <c:v>4</c:v>
                </c:pt>
                <c:pt idx="12">
                  <c:v>7</c:v>
                </c:pt>
                <c:pt idx="13">
                  <c:v>6</c:v>
                </c:pt>
                <c:pt idx="14">
                  <c:v>6</c:v>
                </c:pt>
                <c:pt idx="15">
                  <c:v>10</c:v>
                </c:pt>
                <c:pt idx="16">
                  <c:v>10</c:v>
                </c:pt>
                <c:pt idx="17">
                  <c:v>12</c:v>
                </c:pt>
                <c:pt idx="18">
                  <c:v>10</c:v>
                </c:pt>
                <c:pt idx="19">
                  <c:v>12</c:v>
                </c:pt>
                <c:pt idx="20">
                  <c:v>12</c:v>
                </c:pt>
                <c:pt idx="21">
                  <c:v>8</c:v>
                </c:pt>
                <c:pt idx="22">
                  <c:v>9</c:v>
                </c:pt>
                <c:pt idx="23">
                  <c:v>10</c:v>
                </c:pt>
                <c:pt idx="24">
                  <c:v>10</c:v>
                </c:pt>
                <c:pt idx="25">
                  <c:v>10</c:v>
                </c:pt>
                <c:pt idx="26">
                  <c:v>12</c:v>
                </c:pt>
                <c:pt idx="27">
                  <c:v>12</c:v>
                </c:pt>
                <c:pt idx="28">
                  <c:v>13</c:v>
                </c:pt>
                <c:pt idx="29">
                  <c:v>10</c:v>
                </c:pt>
                <c:pt idx="30">
                  <c:v>13</c:v>
                </c:pt>
                <c:pt idx="31">
                  <c:v>13</c:v>
                </c:pt>
                <c:pt idx="32">
                  <c:v>17</c:v>
                </c:pt>
                <c:pt idx="33">
                  <c:v>15</c:v>
                </c:pt>
                <c:pt idx="34">
                  <c:v>19</c:v>
                </c:pt>
                <c:pt idx="35">
                  <c:v>16</c:v>
                </c:pt>
                <c:pt idx="36">
                  <c:v>15</c:v>
                </c:pt>
                <c:pt idx="37">
                  <c:v>18</c:v>
                </c:pt>
                <c:pt idx="38">
                  <c:v>21</c:v>
                </c:pt>
                <c:pt idx="39">
                  <c:v>24</c:v>
                </c:pt>
                <c:pt idx="40">
                  <c:v>28</c:v>
                </c:pt>
                <c:pt idx="41">
                  <c:v>25</c:v>
                </c:pt>
                <c:pt idx="42">
                  <c:v>28</c:v>
                </c:pt>
                <c:pt idx="43">
                  <c:v>33</c:v>
                </c:pt>
                <c:pt idx="44">
                  <c:v>36</c:v>
                </c:pt>
                <c:pt idx="45">
                  <c:v>39</c:v>
                </c:pt>
                <c:pt idx="46">
                  <c:v>41</c:v>
                </c:pt>
                <c:pt idx="47">
                  <c:v>49</c:v>
                </c:pt>
                <c:pt idx="48">
                  <c:v>55</c:v>
                </c:pt>
                <c:pt idx="49">
                  <c:v>57</c:v>
                </c:pt>
                <c:pt idx="50">
                  <c:v>39</c:v>
                </c:pt>
                <c:pt idx="51">
                  <c:v>40</c:v>
                </c:pt>
                <c:pt idx="52">
                  <c:v>50</c:v>
                </c:pt>
                <c:pt idx="53">
                  <c:v>54</c:v>
                </c:pt>
                <c:pt idx="54">
                  <c:v>31</c:v>
                </c:pt>
                <c:pt idx="55">
                  <c:v>58</c:v>
                </c:pt>
                <c:pt idx="56">
                  <c:v>103</c:v>
                </c:pt>
                <c:pt idx="57">
                  <c:v>112</c:v>
                </c:pt>
                <c:pt idx="58">
                  <c:v>114</c:v>
                </c:pt>
                <c:pt idx="59">
                  <c:v>114</c:v>
                </c:pt>
                <c:pt idx="60">
                  <c:v>121</c:v>
                </c:pt>
                <c:pt idx="61">
                  <c:v>109</c:v>
                </c:pt>
                <c:pt idx="62">
                  <c:v>123</c:v>
                </c:pt>
                <c:pt idx="63">
                  <c:v>123</c:v>
                </c:pt>
                <c:pt idx="64">
                  <c:v>123</c:v>
                </c:pt>
                <c:pt idx="65">
                  <c:v>123</c:v>
                </c:pt>
                <c:pt idx="66">
                  <c:v>115</c:v>
                </c:pt>
                <c:pt idx="67">
                  <c:v>127</c:v>
                </c:pt>
                <c:pt idx="68">
                  <c:v>128</c:v>
                </c:pt>
                <c:pt idx="69">
                  <c:v>128</c:v>
                </c:pt>
                <c:pt idx="70">
                  <c:v>132</c:v>
                </c:pt>
                <c:pt idx="71">
                  <c:v>118</c:v>
                </c:pt>
                <c:pt idx="72">
                  <c:v>145</c:v>
                </c:pt>
                <c:pt idx="73">
                  <c:v>150</c:v>
                </c:pt>
                <c:pt idx="74">
                  <c:v>155</c:v>
                </c:pt>
                <c:pt idx="75">
                  <c:v>194</c:v>
                </c:pt>
                <c:pt idx="76">
                  <c:v>236</c:v>
                </c:pt>
                <c:pt idx="77">
                  <c:v>69</c:v>
                </c:pt>
                <c:pt idx="78">
                  <c:v>69</c:v>
                </c:pt>
                <c:pt idx="79">
                  <c:v>85</c:v>
                </c:pt>
                <c:pt idx="80">
                  <c:v>87</c:v>
                </c:pt>
                <c:pt idx="81">
                  <c:v>89</c:v>
                </c:pt>
                <c:pt idx="82">
                  <c:v>94</c:v>
                </c:pt>
                <c:pt idx="83">
                  <c:v>94</c:v>
                </c:pt>
                <c:pt idx="84">
                  <c:v>96</c:v>
                </c:pt>
                <c:pt idx="85">
                  <c:v>107</c:v>
                </c:pt>
                <c:pt idx="86">
                  <c:v>107</c:v>
                </c:pt>
                <c:pt idx="87">
                  <c:v>108</c:v>
                </c:pt>
                <c:pt idx="88">
                  <c:v>108</c:v>
                </c:pt>
                <c:pt idx="89">
                  <c:v>113</c:v>
                </c:pt>
                <c:pt idx="90">
                  <c:v>117</c:v>
                </c:pt>
                <c:pt idx="91">
                  <c:v>115</c:v>
                </c:pt>
                <c:pt idx="92">
                  <c:v>117</c:v>
                </c:pt>
                <c:pt idx="93">
                  <c:v>119</c:v>
                </c:pt>
                <c:pt idx="94">
                  <c:v>126</c:v>
                </c:pt>
                <c:pt idx="95">
                  <c:v>174</c:v>
                </c:pt>
                <c:pt idx="96">
                  <c:v>205</c:v>
                </c:pt>
                <c:pt idx="97">
                  <c:v>129</c:v>
                </c:pt>
                <c:pt idx="98">
                  <c:v>237</c:v>
                </c:pt>
              </c:numCache>
            </c:numRef>
          </c:xVal>
          <c:yVal>
            <c:numRef>
              <c:f>'[Corrected DSS data OJ IFNL.xlsx]Scatter plot DfSO WHO IFNL3'!$F$8:$F$106</c:f>
              <c:numCache>
                <c:formatCode>General</c:formatCode>
                <c:ptCount val="99"/>
                <c:pt idx="0">
                  <c:v>2.3477202170340381</c:v>
                </c:pt>
                <c:pt idx="1">
                  <c:v>2.6153186566114788</c:v>
                </c:pt>
                <c:pt idx="2">
                  <c:v>2.4456042032735974</c:v>
                </c:pt>
                <c:pt idx="3">
                  <c:v>2.4817291969600159</c:v>
                </c:pt>
                <c:pt idx="4">
                  <c:v>2.0595634179012676</c:v>
                </c:pt>
                <c:pt idx="5">
                  <c:v>2.0565237240791006</c:v>
                </c:pt>
                <c:pt idx="6">
                  <c:v>3.1829849670035819</c:v>
                </c:pt>
                <c:pt idx="7">
                  <c:v>2.3432115901797474</c:v>
                </c:pt>
                <c:pt idx="8">
                  <c:v>2.3168087520530221</c:v>
                </c:pt>
                <c:pt idx="9">
                  <c:v>2.5324995860946626</c:v>
                </c:pt>
                <c:pt idx="10">
                  <c:v>2.635785235533652</c:v>
                </c:pt>
                <c:pt idx="11">
                  <c:v>2.3001605369513523</c:v>
                </c:pt>
                <c:pt idx="12">
                  <c:v>0</c:v>
                </c:pt>
                <c:pt idx="13">
                  <c:v>3.6515687388657918</c:v>
                </c:pt>
                <c:pt idx="14">
                  <c:v>0</c:v>
                </c:pt>
                <c:pt idx="15">
                  <c:v>0</c:v>
                </c:pt>
                <c:pt idx="16">
                  <c:v>4.3550873800749041</c:v>
                </c:pt>
                <c:pt idx="17">
                  <c:v>0</c:v>
                </c:pt>
                <c:pt idx="18">
                  <c:v>2.7129021250472225</c:v>
                </c:pt>
                <c:pt idx="19">
                  <c:v>3.9564565834098997</c:v>
                </c:pt>
                <c:pt idx="20">
                  <c:v>3.1335389083702174</c:v>
                </c:pt>
                <c:pt idx="21">
                  <c:v>0</c:v>
                </c:pt>
                <c:pt idx="22">
                  <c:v>2.8942052591420837</c:v>
                </c:pt>
                <c:pt idx="23">
                  <c:v>2.9544354863284825</c:v>
                </c:pt>
                <c:pt idx="24">
                  <c:v>3.0831441431430524</c:v>
                </c:pt>
                <c:pt idx="25">
                  <c:v>2.0809870469108871</c:v>
                </c:pt>
                <c:pt idx="26">
                  <c:v>2.6909045540549665</c:v>
                </c:pt>
                <c:pt idx="27">
                  <c:v>2.6176292977578419</c:v>
                </c:pt>
                <c:pt idx="28">
                  <c:v>3.1109262422664203</c:v>
                </c:pt>
                <c:pt idx="29">
                  <c:v>2.8156441491319653</c:v>
                </c:pt>
                <c:pt idx="30">
                  <c:v>3.8812705039293576</c:v>
                </c:pt>
                <c:pt idx="31">
                  <c:v>2.3410386316775229</c:v>
                </c:pt>
                <c:pt idx="32">
                  <c:v>2.1580607939366052</c:v>
                </c:pt>
                <c:pt idx="33">
                  <c:v>3.6939906104607769</c:v>
                </c:pt>
                <c:pt idx="34">
                  <c:v>2.8553374044695405</c:v>
                </c:pt>
                <c:pt idx="35">
                  <c:v>0</c:v>
                </c:pt>
                <c:pt idx="36">
                  <c:v>2.5412046906832586</c:v>
                </c:pt>
                <c:pt idx="37">
                  <c:v>2.6348801407665263</c:v>
                </c:pt>
                <c:pt idx="38">
                  <c:v>3.9905164440282292</c:v>
                </c:pt>
                <c:pt idx="39">
                  <c:v>2.1027766148834415</c:v>
                </c:pt>
                <c:pt idx="40">
                  <c:v>3.9529860651970554</c:v>
                </c:pt>
                <c:pt idx="41">
                  <c:v>0</c:v>
                </c:pt>
                <c:pt idx="42">
                  <c:v>0</c:v>
                </c:pt>
                <c:pt idx="43">
                  <c:v>2.6274682724597098</c:v>
                </c:pt>
                <c:pt idx="44">
                  <c:v>3.6127838567197355</c:v>
                </c:pt>
                <c:pt idx="45">
                  <c:v>2.5706596700215343</c:v>
                </c:pt>
                <c:pt idx="46">
                  <c:v>2.5964871337365443</c:v>
                </c:pt>
                <c:pt idx="47">
                  <c:v>3.8100307864058394</c:v>
                </c:pt>
                <c:pt idx="48">
                  <c:v>2.9854264740830017</c:v>
                </c:pt>
                <c:pt idx="49">
                  <c:v>3.1829849670035819</c:v>
                </c:pt>
                <c:pt idx="50">
                  <c:v>3.4039779636693548</c:v>
                </c:pt>
                <c:pt idx="51">
                  <c:v>3.4079005401426352</c:v>
                </c:pt>
                <c:pt idx="52">
                  <c:v>2.4788549675286631</c:v>
                </c:pt>
                <c:pt idx="53">
                  <c:v>2.6319508262592168</c:v>
                </c:pt>
                <c:pt idx="54">
                  <c:v>0</c:v>
                </c:pt>
                <c:pt idx="55">
                  <c:v>2.9125939977521056</c:v>
                </c:pt>
                <c:pt idx="56">
                  <c:v>2.4983105537896004</c:v>
                </c:pt>
                <c:pt idx="57">
                  <c:v>2.472171146692363</c:v>
                </c:pt>
                <c:pt idx="58">
                  <c:v>2.4885507165004443</c:v>
                </c:pt>
                <c:pt idx="59">
                  <c:v>2.840983837320378</c:v>
                </c:pt>
                <c:pt idx="60">
                  <c:v>2.7223047868743278</c:v>
                </c:pt>
                <c:pt idx="61">
                  <c:v>2.6518592692469491</c:v>
                </c:pt>
                <c:pt idx="62">
                  <c:v>2.600428325732131</c:v>
                </c:pt>
                <c:pt idx="63">
                  <c:v>2.3979400086720375</c:v>
                </c:pt>
                <c:pt idx="64">
                  <c:v>2.5041989185394451</c:v>
                </c:pt>
                <c:pt idx="65">
                  <c:v>2.5360531551592049</c:v>
                </c:pt>
                <c:pt idx="66">
                  <c:v>2.5625307688622612</c:v>
                </c:pt>
                <c:pt idx="67">
                  <c:v>2.4056877866727775</c:v>
                </c:pt>
                <c:pt idx="68">
                  <c:v>2.6056282220076188</c:v>
                </c:pt>
                <c:pt idx="69">
                  <c:v>2.9610887197678961</c:v>
                </c:pt>
                <c:pt idx="70">
                  <c:v>2.5254335534288201</c:v>
                </c:pt>
                <c:pt idx="71">
                  <c:v>2.7169210731667612</c:v>
                </c:pt>
                <c:pt idx="72">
                  <c:v>2.1357685145678222</c:v>
                </c:pt>
                <c:pt idx="73">
                  <c:v>2.550105999347593</c:v>
                </c:pt>
                <c:pt idx="74">
                  <c:v>2.5873741720730656</c:v>
                </c:pt>
                <c:pt idx="75">
                  <c:v>3.1495270137543478</c:v>
                </c:pt>
                <c:pt idx="76">
                  <c:v>2.5796692935547205</c:v>
                </c:pt>
                <c:pt idx="77">
                  <c:v>2.7307822756663893</c:v>
                </c:pt>
                <c:pt idx="78">
                  <c:v>3.0546130545568877</c:v>
                </c:pt>
                <c:pt idx="79">
                  <c:v>2.9009130677376689</c:v>
                </c:pt>
                <c:pt idx="80">
                  <c:v>2.5225746326911769</c:v>
                </c:pt>
                <c:pt idx="81">
                  <c:v>2.6662370958958044</c:v>
                </c:pt>
                <c:pt idx="82">
                  <c:v>2.7294887691795613</c:v>
                </c:pt>
                <c:pt idx="83">
                  <c:v>2.5449357658815024</c:v>
                </c:pt>
                <c:pt idx="84">
                  <c:v>2.6524397475894204</c:v>
                </c:pt>
                <c:pt idx="85">
                  <c:v>2.7291647896927702</c:v>
                </c:pt>
                <c:pt idx="86">
                  <c:v>2.5335178620169674</c:v>
                </c:pt>
                <c:pt idx="87">
                  <c:v>2.6183619311098782</c:v>
                </c:pt>
                <c:pt idx="88">
                  <c:v>2.6100210246641451</c:v>
                </c:pt>
                <c:pt idx="89">
                  <c:v>2.7901443650429005</c:v>
                </c:pt>
                <c:pt idx="90">
                  <c:v>2.426673888021373</c:v>
                </c:pt>
                <c:pt idx="91">
                  <c:v>2.531223374533027</c:v>
                </c:pt>
                <c:pt idx="92">
                  <c:v>2.5693739096150461</c:v>
                </c:pt>
                <c:pt idx="93">
                  <c:v>2.8278859827898559</c:v>
                </c:pt>
                <c:pt idx="94">
                  <c:v>2.2986347831244354</c:v>
                </c:pt>
                <c:pt idx="95">
                  <c:v>2.9610887197678961</c:v>
                </c:pt>
                <c:pt idx="96">
                  <c:v>2.7781512503836434</c:v>
                </c:pt>
                <c:pt idx="97">
                  <c:v>2.6145808669974859</c:v>
                </c:pt>
                <c:pt idx="98">
                  <c:v>2.951580344903391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BF5-8F43-8903-07F467A44C99}"/>
            </c:ext>
          </c:extLst>
        </c:ser>
        <c:ser>
          <c:idx val="3"/>
          <c:order val="3"/>
          <c:tx>
            <c:v>WHO5-8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98500"/>
                </a:schemeClr>
              </a:solidFill>
              <a:ln w="9525">
                <a:solidFill>
                  <a:schemeClr val="dk1">
                    <a:tint val="98500"/>
                  </a:schemeClr>
                </a:solidFill>
              </a:ln>
              <a:effectLst/>
            </c:spPr>
          </c:marker>
          <c:xVal>
            <c:numRef>
              <c:f>'[Corrected DSS data OJ IFNL.xlsx]Scatter plot DfSO WHO IFNL3'!$G$8:$G$54</c:f>
              <c:numCache>
                <c:formatCode>General</c:formatCode>
                <c:ptCount val="47"/>
                <c:pt idx="0">
                  <c:v>0</c:v>
                </c:pt>
                <c:pt idx="1">
                  <c:v>3</c:v>
                </c:pt>
                <c:pt idx="2">
                  <c:v>4</c:v>
                </c:pt>
                <c:pt idx="3">
                  <c:v>1</c:v>
                </c:pt>
                <c:pt idx="4">
                  <c:v>2</c:v>
                </c:pt>
                <c:pt idx="5">
                  <c:v>4</c:v>
                </c:pt>
                <c:pt idx="6">
                  <c:v>7</c:v>
                </c:pt>
                <c:pt idx="7">
                  <c:v>3</c:v>
                </c:pt>
                <c:pt idx="8">
                  <c:v>6</c:v>
                </c:pt>
                <c:pt idx="9">
                  <c:v>2</c:v>
                </c:pt>
                <c:pt idx="10">
                  <c:v>3</c:v>
                </c:pt>
                <c:pt idx="11">
                  <c:v>5</c:v>
                </c:pt>
                <c:pt idx="12">
                  <c:v>5</c:v>
                </c:pt>
                <c:pt idx="13">
                  <c:v>6</c:v>
                </c:pt>
                <c:pt idx="14">
                  <c:v>5</c:v>
                </c:pt>
                <c:pt idx="15">
                  <c:v>8</c:v>
                </c:pt>
                <c:pt idx="16">
                  <c:v>8</c:v>
                </c:pt>
                <c:pt idx="17">
                  <c:v>8</c:v>
                </c:pt>
                <c:pt idx="18">
                  <c:v>13</c:v>
                </c:pt>
                <c:pt idx="19">
                  <c:v>9</c:v>
                </c:pt>
                <c:pt idx="20">
                  <c:v>13</c:v>
                </c:pt>
                <c:pt idx="21">
                  <c:v>8</c:v>
                </c:pt>
                <c:pt idx="22">
                  <c:v>8</c:v>
                </c:pt>
                <c:pt idx="23">
                  <c:v>12</c:v>
                </c:pt>
                <c:pt idx="24">
                  <c:v>17</c:v>
                </c:pt>
                <c:pt idx="25">
                  <c:v>17</c:v>
                </c:pt>
                <c:pt idx="26">
                  <c:v>20</c:v>
                </c:pt>
                <c:pt idx="27">
                  <c:v>24</c:v>
                </c:pt>
                <c:pt idx="28">
                  <c:v>26</c:v>
                </c:pt>
                <c:pt idx="29">
                  <c:v>16</c:v>
                </c:pt>
                <c:pt idx="30">
                  <c:v>37</c:v>
                </c:pt>
                <c:pt idx="31">
                  <c:v>41</c:v>
                </c:pt>
                <c:pt idx="32">
                  <c:v>31</c:v>
                </c:pt>
                <c:pt idx="33">
                  <c:v>114</c:v>
                </c:pt>
                <c:pt idx="34">
                  <c:v>120</c:v>
                </c:pt>
                <c:pt idx="35">
                  <c:v>123</c:v>
                </c:pt>
                <c:pt idx="36">
                  <c:v>124</c:v>
                </c:pt>
                <c:pt idx="37">
                  <c:v>128</c:v>
                </c:pt>
                <c:pt idx="38">
                  <c:v>131</c:v>
                </c:pt>
                <c:pt idx="39">
                  <c:v>162</c:v>
                </c:pt>
                <c:pt idx="40">
                  <c:v>216</c:v>
                </c:pt>
                <c:pt idx="41">
                  <c:v>116</c:v>
                </c:pt>
                <c:pt idx="42">
                  <c:v>117</c:v>
                </c:pt>
                <c:pt idx="43">
                  <c:v>137</c:v>
                </c:pt>
                <c:pt idx="44">
                  <c:v>192</c:v>
                </c:pt>
                <c:pt idx="45">
                  <c:v>114</c:v>
                </c:pt>
                <c:pt idx="46">
                  <c:v>216</c:v>
                </c:pt>
              </c:numCache>
            </c:numRef>
          </c:xVal>
          <c:yVal>
            <c:numRef>
              <c:f>'[Corrected DSS data OJ IFNL.xlsx]Scatter plot DfSO WHO IFNL3'!$I$8:$I$54</c:f>
              <c:numCache>
                <c:formatCode>General</c:formatCode>
                <c:ptCount val="47"/>
                <c:pt idx="0">
                  <c:v>2.9776778876739938</c:v>
                </c:pt>
                <c:pt idx="1">
                  <c:v>2.4899584794248346</c:v>
                </c:pt>
                <c:pt idx="2">
                  <c:v>2.4745076391169758</c:v>
                </c:pt>
                <c:pt idx="3">
                  <c:v>1.9576551669434912</c:v>
                </c:pt>
                <c:pt idx="4">
                  <c:v>2.4000196350651586</c:v>
                </c:pt>
                <c:pt idx="5">
                  <c:v>2.4661258704181992</c:v>
                </c:pt>
                <c:pt idx="6">
                  <c:v>2.5286596452349901</c:v>
                </c:pt>
                <c:pt idx="7">
                  <c:v>4.0678516605123525</c:v>
                </c:pt>
                <c:pt idx="8">
                  <c:v>2.4371160930480786</c:v>
                </c:pt>
                <c:pt idx="9">
                  <c:v>2.603793704136963</c:v>
                </c:pt>
                <c:pt idx="10">
                  <c:v>2.5728716022004803</c:v>
                </c:pt>
                <c:pt idx="11">
                  <c:v>2.4442009888641594</c:v>
                </c:pt>
                <c:pt idx="12">
                  <c:v>2.9020028913507296</c:v>
                </c:pt>
                <c:pt idx="13">
                  <c:v>2.6574383227029625</c:v>
                </c:pt>
                <c:pt idx="14">
                  <c:v>3.0472748673841794</c:v>
                </c:pt>
                <c:pt idx="15">
                  <c:v>2.913760886412323</c:v>
                </c:pt>
                <c:pt idx="16">
                  <c:v>2.4114513421379375</c:v>
                </c:pt>
                <c:pt idx="17">
                  <c:v>2.3590762260592628</c:v>
                </c:pt>
                <c:pt idx="18">
                  <c:v>2.5897262562542371</c:v>
                </c:pt>
                <c:pt idx="19">
                  <c:v>2.7680458141024169</c:v>
                </c:pt>
                <c:pt idx="20">
                  <c:v>3.1020905255118367</c:v>
                </c:pt>
                <c:pt idx="21">
                  <c:v>2.8858698609039064</c:v>
                </c:pt>
                <c:pt idx="22">
                  <c:v>2.476976465759527</c:v>
                </c:pt>
                <c:pt idx="23">
                  <c:v>2.2474822606770544</c:v>
                </c:pt>
                <c:pt idx="24">
                  <c:v>2.9565525919173989</c:v>
                </c:pt>
                <c:pt idx="25">
                  <c:v>3.5017437296279943</c:v>
                </c:pt>
                <c:pt idx="26">
                  <c:v>0</c:v>
                </c:pt>
                <c:pt idx="27">
                  <c:v>3.1156105116742996</c:v>
                </c:pt>
                <c:pt idx="28">
                  <c:v>2.5850092799024611</c:v>
                </c:pt>
                <c:pt idx="29">
                  <c:v>2.7831171374904673</c:v>
                </c:pt>
                <c:pt idx="30">
                  <c:v>2.2513948500401044</c:v>
                </c:pt>
                <c:pt idx="31">
                  <c:v>4.1258389639950046</c:v>
                </c:pt>
                <c:pt idx="32">
                  <c:v>0</c:v>
                </c:pt>
                <c:pt idx="33">
                  <c:v>2.8880671134074367</c:v>
                </c:pt>
                <c:pt idx="34">
                  <c:v>2.6269559514354475</c:v>
                </c:pt>
                <c:pt idx="35">
                  <c:v>2.6222140229662951</c:v>
                </c:pt>
                <c:pt idx="36">
                  <c:v>2.5058280338548364</c:v>
                </c:pt>
                <c:pt idx="37">
                  <c:v>2.598571663482141</c:v>
                </c:pt>
                <c:pt idx="38">
                  <c:v>2.6015167836500104</c:v>
                </c:pt>
                <c:pt idx="39">
                  <c:v>2.7838321433844411</c:v>
                </c:pt>
                <c:pt idx="40">
                  <c:v>2.518382315545344</c:v>
                </c:pt>
                <c:pt idx="41">
                  <c:v>2.5368108659915416</c:v>
                </c:pt>
                <c:pt idx="42">
                  <c:v>2.6901074394563307</c:v>
                </c:pt>
                <c:pt idx="43">
                  <c:v>2.5703093854358796</c:v>
                </c:pt>
                <c:pt idx="44">
                  <c:v>2.4670158184384356</c:v>
                </c:pt>
                <c:pt idx="45">
                  <c:v>2.6521496054016529</c:v>
                </c:pt>
                <c:pt idx="46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6BF5-8F43-8903-07F467A44C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81644816"/>
        <c:axId val="1271041312"/>
      </c:scatterChart>
      <c:valAx>
        <c:axId val="138164481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DfSO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1041312"/>
        <c:crosses val="autoZero"/>
        <c:crossBetween val="midCat"/>
      </c:valAx>
      <c:valAx>
        <c:axId val="12710413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IFNL3</a:t>
                </a:r>
                <a:r>
                  <a:rPr lang="en-GB" baseline="0"/>
                  <a:t> (log 10)</a:t>
                </a:r>
                <a:endParaRPr lang="en-GB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8164481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WHO 1-2</c:v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xVal>
            <c:numRef>
              <c:f>'[Corrected DSS data OJ IFNL.xlsx]Scatter plot DfSO WHO IFNL2'!$C$8:$C$145</c:f>
              <c:numCache>
                <c:formatCode>General</c:formatCode>
                <c:ptCount val="138"/>
                <c:pt idx="0">
                  <c:v>2</c:v>
                </c:pt>
                <c:pt idx="1">
                  <c:v>0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5</c:v>
                </c:pt>
                <c:pt idx="6">
                  <c:v>7</c:v>
                </c:pt>
                <c:pt idx="7">
                  <c:v>6</c:v>
                </c:pt>
                <c:pt idx="8">
                  <c:v>5</c:v>
                </c:pt>
                <c:pt idx="9">
                  <c:v>6</c:v>
                </c:pt>
                <c:pt idx="10">
                  <c:v>8</c:v>
                </c:pt>
                <c:pt idx="11">
                  <c:v>10</c:v>
                </c:pt>
                <c:pt idx="12">
                  <c:v>10</c:v>
                </c:pt>
                <c:pt idx="13">
                  <c:v>8</c:v>
                </c:pt>
                <c:pt idx="14">
                  <c:v>11</c:v>
                </c:pt>
                <c:pt idx="15">
                  <c:v>10</c:v>
                </c:pt>
                <c:pt idx="16">
                  <c:v>10</c:v>
                </c:pt>
                <c:pt idx="17">
                  <c:v>11</c:v>
                </c:pt>
                <c:pt idx="18">
                  <c:v>12</c:v>
                </c:pt>
                <c:pt idx="19">
                  <c:v>12</c:v>
                </c:pt>
                <c:pt idx="20">
                  <c:v>13</c:v>
                </c:pt>
                <c:pt idx="21">
                  <c:v>14</c:v>
                </c:pt>
                <c:pt idx="22">
                  <c:v>14</c:v>
                </c:pt>
                <c:pt idx="23">
                  <c:v>13</c:v>
                </c:pt>
                <c:pt idx="24">
                  <c:v>14</c:v>
                </c:pt>
                <c:pt idx="25">
                  <c:v>16</c:v>
                </c:pt>
                <c:pt idx="26">
                  <c:v>20</c:v>
                </c:pt>
                <c:pt idx="27">
                  <c:v>20</c:v>
                </c:pt>
                <c:pt idx="28">
                  <c:v>15</c:v>
                </c:pt>
                <c:pt idx="29">
                  <c:v>16</c:v>
                </c:pt>
                <c:pt idx="30">
                  <c:v>16</c:v>
                </c:pt>
                <c:pt idx="31">
                  <c:v>16</c:v>
                </c:pt>
                <c:pt idx="32">
                  <c:v>16</c:v>
                </c:pt>
                <c:pt idx="33">
                  <c:v>19</c:v>
                </c:pt>
                <c:pt idx="34">
                  <c:v>19</c:v>
                </c:pt>
                <c:pt idx="35">
                  <c:v>19</c:v>
                </c:pt>
                <c:pt idx="36">
                  <c:v>20</c:v>
                </c:pt>
                <c:pt idx="37">
                  <c:v>20</c:v>
                </c:pt>
                <c:pt idx="38">
                  <c:v>21</c:v>
                </c:pt>
                <c:pt idx="39">
                  <c:v>22</c:v>
                </c:pt>
                <c:pt idx="40">
                  <c:v>23</c:v>
                </c:pt>
                <c:pt idx="41">
                  <c:v>24</c:v>
                </c:pt>
                <c:pt idx="42">
                  <c:v>24</c:v>
                </c:pt>
                <c:pt idx="43">
                  <c:v>25</c:v>
                </c:pt>
                <c:pt idx="44">
                  <c:v>27</c:v>
                </c:pt>
                <c:pt idx="45">
                  <c:v>27</c:v>
                </c:pt>
                <c:pt idx="46">
                  <c:v>28</c:v>
                </c:pt>
                <c:pt idx="47">
                  <c:v>29</c:v>
                </c:pt>
                <c:pt idx="48">
                  <c:v>29</c:v>
                </c:pt>
                <c:pt idx="49">
                  <c:v>30</c:v>
                </c:pt>
                <c:pt idx="50">
                  <c:v>19</c:v>
                </c:pt>
                <c:pt idx="51">
                  <c:v>22</c:v>
                </c:pt>
                <c:pt idx="52">
                  <c:v>30</c:v>
                </c:pt>
                <c:pt idx="53">
                  <c:v>33</c:v>
                </c:pt>
                <c:pt idx="54">
                  <c:v>37</c:v>
                </c:pt>
                <c:pt idx="55">
                  <c:v>40</c:v>
                </c:pt>
                <c:pt idx="56">
                  <c:v>40</c:v>
                </c:pt>
                <c:pt idx="57">
                  <c:v>41</c:v>
                </c:pt>
                <c:pt idx="58">
                  <c:v>45</c:v>
                </c:pt>
                <c:pt idx="59">
                  <c:v>47</c:v>
                </c:pt>
                <c:pt idx="60">
                  <c:v>54</c:v>
                </c:pt>
                <c:pt idx="61">
                  <c:v>56</c:v>
                </c:pt>
                <c:pt idx="62">
                  <c:v>57</c:v>
                </c:pt>
                <c:pt idx="63">
                  <c:v>60</c:v>
                </c:pt>
                <c:pt idx="64">
                  <c:v>60</c:v>
                </c:pt>
                <c:pt idx="65">
                  <c:v>31</c:v>
                </c:pt>
                <c:pt idx="66">
                  <c:v>34</c:v>
                </c:pt>
                <c:pt idx="67">
                  <c:v>34</c:v>
                </c:pt>
                <c:pt idx="68">
                  <c:v>35</c:v>
                </c:pt>
                <c:pt idx="69">
                  <c:v>36</c:v>
                </c:pt>
                <c:pt idx="70">
                  <c:v>36</c:v>
                </c:pt>
                <c:pt idx="71">
                  <c:v>36</c:v>
                </c:pt>
                <c:pt idx="72">
                  <c:v>39</c:v>
                </c:pt>
                <c:pt idx="73">
                  <c:v>40</c:v>
                </c:pt>
                <c:pt idx="74">
                  <c:v>40</c:v>
                </c:pt>
                <c:pt idx="75">
                  <c:v>41</c:v>
                </c:pt>
                <c:pt idx="76">
                  <c:v>42</c:v>
                </c:pt>
                <c:pt idx="77">
                  <c:v>42</c:v>
                </c:pt>
                <c:pt idx="78">
                  <c:v>43</c:v>
                </c:pt>
                <c:pt idx="79">
                  <c:v>43</c:v>
                </c:pt>
                <c:pt idx="80">
                  <c:v>48</c:v>
                </c:pt>
                <c:pt idx="81">
                  <c:v>48</c:v>
                </c:pt>
                <c:pt idx="82">
                  <c:v>49</c:v>
                </c:pt>
                <c:pt idx="83">
                  <c:v>50</c:v>
                </c:pt>
                <c:pt idx="84">
                  <c:v>52</c:v>
                </c:pt>
                <c:pt idx="85">
                  <c:v>53</c:v>
                </c:pt>
                <c:pt idx="86">
                  <c:v>53</c:v>
                </c:pt>
                <c:pt idx="87">
                  <c:v>53</c:v>
                </c:pt>
                <c:pt idx="88">
                  <c:v>53</c:v>
                </c:pt>
                <c:pt idx="89">
                  <c:v>55</c:v>
                </c:pt>
                <c:pt idx="90">
                  <c:v>56</c:v>
                </c:pt>
                <c:pt idx="91">
                  <c:v>57</c:v>
                </c:pt>
                <c:pt idx="92">
                  <c:v>58</c:v>
                </c:pt>
                <c:pt idx="93">
                  <c:v>59</c:v>
                </c:pt>
                <c:pt idx="94">
                  <c:v>36</c:v>
                </c:pt>
                <c:pt idx="95">
                  <c:v>52</c:v>
                </c:pt>
                <c:pt idx="96">
                  <c:v>59</c:v>
                </c:pt>
                <c:pt idx="97">
                  <c:v>63</c:v>
                </c:pt>
                <c:pt idx="98">
                  <c:v>68</c:v>
                </c:pt>
                <c:pt idx="99">
                  <c:v>70</c:v>
                </c:pt>
                <c:pt idx="100">
                  <c:v>71</c:v>
                </c:pt>
                <c:pt idx="101">
                  <c:v>85</c:v>
                </c:pt>
                <c:pt idx="102">
                  <c:v>101</c:v>
                </c:pt>
                <c:pt idx="103">
                  <c:v>108</c:v>
                </c:pt>
                <c:pt idx="104">
                  <c:v>114</c:v>
                </c:pt>
                <c:pt idx="105">
                  <c:v>140</c:v>
                </c:pt>
                <c:pt idx="106">
                  <c:v>255</c:v>
                </c:pt>
                <c:pt idx="107">
                  <c:v>61</c:v>
                </c:pt>
                <c:pt idx="108">
                  <c:v>61</c:v>
                </c:pt>
                <c:pt idx="109">
                  <c:v>61</c:v>
                </c:pt>
                <c:pt idx="110">
                  <c:v>62</c:v>
                </c:pt>
                <c:pt idx="111">
                  <c:v>62</c:v>
                </c:pt>
                <c:pt idx="112">
                  <c:v>63</c:v>
                </c:pt>
                <c:pt idx="113">
                  <c:v>65</c:v>
                </c:pt>
                <c:pt idx="114">
                  <c:v>66</c:v>
                </c:pt>
                <c:pt idx="115">
                  <c:v>66</c:v>
                </c:pt>
                <c:pt idx="116">
                  <c:v>68</c:v>
                </c:pt>
                <c:pt idx="117">
                  <c:v>69</c:v>
                </c:pt>
                <c:pt idx="118">
                  <c:v>71</c:v>
                </c:pt>
                <c:pt idx="119">
                  <c:v>71</c:v>
                </c:pt>
                <c:pt idx="120">
                  <c:v>76</c:v>
                </c:pt>
                <c:pt idx="121">
                  <c:v>78</c:v>
                </c:pt>
                <c:pt idx="122">
                  <c:v>79</c:v>
                </c:pt>
                <c:pt idx="123">
                  <c:v>88</c:v>
                </c:pt>
                <c:pt idx="124">
                  <c:v>92</c:v>
                </c:pt>
                <c:pt idx="125">
                  <c:v>95</c:v>
                </c:pt>
                <c:pt idx="126">
                  <c:v>100</c:v>
                </c:pt>
                <c:pt idx="127">
                  <c:v>105</c:v>
                </c:pt>
                <c:pt idx="128">
                  <c:v>110</c:v>
                </c:pt>
                <c:pt idx="129">
                  <c:v>110</c:v>
                </c:pt>
                <c:pt idx="130">
                  <c:v>61</c:v>
                </c:pt>
                <c:pt idx="131">
                  <c:v>104</c:v>
                </c:pt>
                <c:pt idx="132">
                  <c:v>110</c:v>
                </c:pt>
                <c:pt idx="133">
                  <c:v>123</c:v>
                </c:pt>
                <c:pt idx="134">
                  <c:v>124</c:v>
                </c:pt>
                <c:pt idx="135">
                  <c:v>95</c:v>
                </c:pt>
                <c:pt idx="136">
                  <c:v>135</c:v>
                </c:pt>
                <c:pt idx="137">
                  <c:v>185</c:v>
                </c:pt>
              </c:numCache>
            </c:numRef>
          </c:xVal>
          <c:yVal>
            <c:numRef>
              <c:f>'[Corrected DSS data OJ IFNL.xlsx]Scatter plot DfSO WHO IFNL2'!$D$8:$D$145</c:f>
              <c:numCache>
                <c:formatCode>General</c:formatCode>
                <c:ptCount val="138"/>
                <c:pt idx="0">
                  <c:v>1.36679638328673</c:v>
                </c:pt>
                <c:pt idx="1">
                  <c:v>2.2884728005997825</c:v>
                </c:pt>
                <c:pt idx="2">
                  <c:v>3.020775488193558</c:v>
                </c:pt>
                <c:pt idx="3">
                  <c:v>2.9613736275948011</c:v>
                </c:pt>
                <c:pt idx="4">
                  <c:v>2.7965049515532963</c:v>
                </c:pt>
                <c:pt idx="5">
                  <c:v>3.1280760126687155</c:v>
                </c:pt>
                <c:pt idx="6">
                  <c:v>2.8794399659952172</c:v>
                </c:pt>
                <c:pt idx="7">
                  <c:v>3.5169318088680126</c:v>
                </c:pt>
                <c:pt idx="8">
                  <c:v>2.8069935136821074</c:v>
                </c:pt>
                <c:pt idx="9">
                  <c:v>3.249198357391113</c:v>
                </c:pt>
                <c:pt idx="10">
                  <c:v>2.9088065994056742</c:v>
                </c:pt>
                <c:pt idx="11">
                  <c:v>2.7272158209084925</c:v>
                </c:pt>
                <c:pt idx="12">
                  <c:v>1.5956064348656029</c:v>
                </c:pt>
                <c:pt idx="13">
                  <c:v>3.8771985152717896</c:v>
                </c:pt>
                <c:pt idx="14">
                  <c:v>0.93323412871480804</c:v>
                </c:pt>
                <c:pt idx="15">
                  <c:v>3.5379449592914867</c:v>
                </c:pt>
                <c:pt idx="16">
                  <c:v>2.3694014136966244</c:v>
                </c:pt>
                <c:pt idx="17">
                  <c:v>3.2683439139510648</c:v>
                </c:pt>
                <c:pt idx="18">
                  <c:v>1.3664229572259727</c:v>
                </c:pt>
                <c:pt idx="19">
                  <c:v>0</c:v>
                </c:pt>
                <c:pt idx="20">
                  <c:v>2.1737688231366499</c:v>
                </c:pt>
                <c:pt idx="21">
                  <c:v>3.2559957267224018</c:v>
                </c:pt>
                <c:pt idx="22">
                  <c:v>1.2615007731982801</c:v>
                </c:pt>
                <c:pt idx="23">
                  <c:v>3.430075055551939</c:v>
                </c:pt>
                <c:pt idx="24">
                  <c:v>3.4860051863622421</c:v>
                </c:pt>
                <c:pt idx="25">
                  <c:v>2.6425634371043878</c:v>
                </c:pt>
                <c:pt idx="26">
                  <c:v>3.4171394097273255</c:v>
                </c:pt>
                <c:pt idx="27">
                  <c:v>0</c:v>
                </c:pt>
                <c:pt idx="28">
                  <c:v>0.79211140908716837</c:v>
                </c:pt>
                <c:pt idx="29">
                  <c:v>2.7693773260761385</c:v>
                </c:pt>
                <c:pt idx="30">
                  <c:v>1.5403294747908738</c:v>
                </c:pt>
                <c:pt idx="31">
                  <c:v>3.5830853663476878</c:v>
                </c:pt>
                <c:pt idx="32">
                  <c:v>2.2273724422896364</c:v>
                </c:pt>
                <c:pt idx="33">
                  <c:v>3.6725596277632757</c:v>
                </c:pt>
                <c:pt idx="34">
                  <c:v>3.2960066693136723</c:v>
                </c:pt>
                <c:pt idx="35">
                  <c:v>0</c:v>
                </c:pt>
                <c:pt idx="36">
                  <c:v>4.0577041315340301</c:v>
                </c:pt>
                <c:pt idx="37">
                  <c:v>0</c:v>
                </c:pt>
                <c:pt idx="38">
                  <c:v>3.2557547866430441</c:v>
                </c:pt>
                <c:pt idx="39">
                  <c:v>3.9576551669434914</c:v>
                </c:pt>
                <c:pt idx="40">
                  <c:v>3.5742628297070267</c:v>
                </c:pt>
                <c:pt idx="41">
                  <c:v>0</c:v>
                </c:pt>
                <c:pt idx="42">
                  <c:v>3.7983052820219765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3.3242824552976926</c:v>
                </c:pt>
                <c:pt idx="47">
                  <c:v>1.9607085516885565</c:v>
                </c:pt>
                <c:pt idx="48">
                  <c:v>2.6353832040474985</c:v>
                </c:pt>
                <c:pt idx="49">
                  <c:v>3.8580557180503643</c:v>
                </c:pt>
                <c:pt idx="50">
                  <c:v>1.7139103541289553</c:v>
                </c:pt>
                <c:pt idx="51">
                  <c:v>0</c:v>
                </c:pt>
                <c:pt idx="52">
                  <c:v>2.2595938788859486</c:v>
                </c:pt>
                <c:pt idx="53">
                  <c:v>1.7245216271185626</c:v>
                </c:pt>
                <c:pt idx="54">
                  <c:v>0</c:v>
                </c:pt>
                <c:pt idx="55">
                  <c:v>2.1031192535457137</c:v>
                </c:pt>
                <c:pt idx="56">
                  <c:v>3.1821292140529982</c:v>
                </c:pt>
                <c:pt idx="57">
                  <c:v>2.6171052305023781</c:v>
                </c:pt>
                <c:pt idx="58">
                  <c:v>2.3651134316275773</c:v>
                </c:pt>
                <c:pt idx="59">
                  <c:v>3.2245330626060857</c:v>
                </c:pt>
                <c:pt idx="60">
                  <c:v>3.8107028609471167</c:v>
                </c:pt>
                <c:pt idx="61">
                  <c:v>3.3756636139608855</c:v>
                </c:pt>
                <c:pt idx="62">
                  <c:v>1.2607866686549762</c:v>
                </c:pt>
                <c:pt idx="63">
                  <c:v>1.8036619232362243</c:v>
                </c:pt>
                <c:pt idx="64">
                  <c:v>3.1829849670035819</c:v>
                </c:pt>
                <c:pt idx="65">
                  <c:v>0</c:v>
                </c:pt>
                <c:pt idx="66">
                  <c:v>1.6668922110665363</c:v>
                </c:pt>
                <c:pt idx="67">
                  <c:v>0</c:v>
                </c:pt>
                <c:pt idx="68">
                  <c:v>3.2229764498933915</c:v>
                </c:pt>
                <c:pt idx="69">
                  <c:v>2.6329631681672612</c:v>
                </c:pt>
                <c:pt idx="70">
                  <c:v>3.7939998009844706</c:v>
                </c:pt>
                <c:pt idx="71">
                  <c:v>3.1136091510730277</c:v>
                </c:pt>
                <c:pt idx="72">
                  <c:v>3.8211203237768236</c:v>
                </c:pt>
                <c:pt idx="73">
                  <c:v>1.8845121591903939</c:v>
                </c:pt>
                <c:pt idx="74">
                  <c:v>3.5851221863068155</c:v>
                </c:pt>
                <c:pt idx="75">
                  <c:v>2.469674772551798</c:v>
                </c:pt>
                <c:pt idx="76">
                  <c:v>0.75358305889290655</c:v>
                </c:pt>
                <c:pt idx="77">
                  <c:v>0</c:v>
                </c:pt>
                <c:pt idx="78">
                  <c:v>3.7206553565517244</c:v>
                </c:pt>
                <c:pt idx="79">
                  <c:v>3.0762762554042178</c:v>
                </c:pt>
                <c:pt idx="80">
                  <c:v>2.4878451201114355</c:v>
                </c:pt>
                <c:pt idx="81">
                  <c:v>3.7627535649333739</c:v>
                </c:pt>
                <c:pt idx="82">
                  <c:v>3.7301360039966776</c:v>
                </c:pt>
                <c:pt idx="83">
                  <c:v>0</c:v>
                </c:pt>
                <c:pt idx="84">
                  <c:v>0</c:v>
                </c:pt>
                <c:pt idx="85">
                  <c:v>3.2405492482825999</c:v>
                </c:pt>
                <c:pt idx="86">
                  <c:v>0</c:v>
                </c:pt>
                <c:pt idx="87">
                  <c:v>0</c:v>
                </c:pt>
                <c:pt idx="88">
                  <c:v>1.9702073588068547</c:v>
                </c:pt>
                <c:pt idx="89">
                  <c:v>8.5825533520743083E-2</c:v>
                </c:pt>
                <c:pt idx="90">
                  <c:v>3.4906606533561368</c:v>
                </c:pt>
                <c:pt idx="91">
                  <c:v>1.9518230353159121</c:v>
                </c:pt>
                <c:pt idx="92">
                  <c:v>3.1357685145678222</c:v>
                </c:pt>
                <c:pt idx="93">
                  <c:v>3.5150786750759226</c:v>
                </c:pt>
                <c:pt idx="94">
                  <c:v>3.0542299098633974</c:v>
                </c:pt>
                <c:pt idx="95">
                  <c:v>0</c:v>
                </c:pt>
                <c:pt idx="96">
                  <c:v>2.3816564825857869</c:v>
                </c:pt>
                <c:pt idx="97">
                  <c:v>2.860397905127313</c:v>
                </c:pt>
                <c:pt idx="98">
                  <c:v>3.4566696294237578</c:v>
                </c:pt>
                <c:pt idx="99">
                  <c:v>2.7744439689249649</c:v>
                </c:pt>
                <c:pt idx="100">
                  <c:v>3.441538038702161</c:v>
                </c:pt>
                <c:pt idx="101">
                  <c:v>0</c:v>
                </c:pt>
                <c:pt idx="102">
                  <c:v>1.9910044403307552</c:v>
                </c:pt>
                <c:pt idx="103">
                  <c:v>0</c:v>
                </c:pt>
                <c:pt idx="104">
                  <c:v>2.111262513659065</c:v>
                </c:pt>
                <c:pt idx="105">
                  <c:v>0</c:v>
                </c:pt>
                <c:pt idx="106">
                  <c:v>3.3016809492935764</c:v>
                </c:pt>
                <c:pt idx="107">
                  <c:v>3.185542154854375</c:v>
                </c:pt>
                <c:pt idx="108">
                  <c:v>2.8846821042060249</c:v>
                </c:pt>
                <c:pt idx="109">
                  <c:v>3.6229389692114902</c:v>
                </c:pt>
                <c:pt idx="110">
                  <c:v>3.683407299132095</c:v>
                </c:pt>
                <c:pt idx="111">
                  <c:v>3.7231271587956916</c:v>
                </c:pt>
                <c:pt idx="112">
                  <c:v>3.5215303412787109</c:v>
                </c:pt>
                <c:pt idx="113">
                  <c:v>2.4245549766067134</c:v>
                </c:pt>
                <c:pt idx="114">
                  <c:v>2.2304489213782741</c:v>
                </c:pt>
                <c:pt idx="115">
                  <c:v>3.5476516583599693</c:v>
                </c:pt>
                <c:pt idx="116">
                  <c:v>2.2309595557485689</c:v>
                </c:pt>
                <c:pt idx="117">
                  <c:v>0</c:v>
                </c:pt>
                <c:pt idx="118">
                  <c:v>3.4271614029259654</c:v>
                </c:pt>
                <c:pt idx="119">
                  <c:v>3.6757783416740852</c:v>
                </c:pt>
                <c:pt idx="120">
                  <c:v>3.0979510709941498</c:v>
                </c:pt>
                <c:pt idx="121">
                  <c:v>0</c:v>
                </c:pt>
                <c:pt idx="122">
                  <c:v>3.8356905714924254</c:v>
                </c:pt>
                <c:pt idx="123">
                  <c:v>0</c:v>
                </c:pt>
                <c:pt idx="124">
                  <c:v>1.7115541682501696</c:v>
                </c:pt>
                <c:pt idx="125">
                  <c:v>3.5293019977879805</c:v>
                </c:pt>
                <c:pt idx="126">
                  <c:v>2.6850247851057141</c:v>
                </c:pt>
                <c:pt idx="127">
                  <c:v>3.9427519204298136</c:v>
                </c:pt>
                <c:pt idx="128">
                  <c:v>3.0644579892269186</c:v>
                </c:pt>
                <c:pt idx="129">
                  <c:v>3.7959494989028033</c:v>
                </c:pt>
                <c:pt idx="130">
                  <c:v>1.7282725978950171</c:v>
                </c:pt>
                <c:pt idx="131">
                  <c:v>2.6173149332982937</c:v>
                </c:pt>
                <c:pt idx="132">
                  <c:v>2.8570911546735136</c:v>
                </c:pt>
                <c:pt idx="133">
                  <c:v>3.2973227142053028</c:v>
                </c:pt>
                <c:pt idx="134">
                  <c:v>3.6605809124272994</c:v>
                </c:pt>
                <c:pt idx="135">
                  <c:v>0</c:v>
                </c:pt>
                <c:pt idx="136">
                  <c:v>2.896415976473123</c:v>
                </c:pt>
                <c:pt idx="137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051-194B-B538-246EBBF1979C}"/>
            </c:ext>
          </c:extLst>
        </c:ser>
        <c:ser>
          <c:idx val="1"/>
          <c:order val="1"/>
          <c:tx>
            <c:v>WHO 3-4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5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xVal>
            <c:numRef>
              <c:f>'[Corrected DSS data OJ IFNL.xlsx]Scatter plot DfSO WHO IFNL2'!$E$8:$E$106</c:f>
              <c:numCache>
                <c:formatCode>General</c:formatCode>
                <c:ptCount val="99"/>
                <c:pt idx="0">
                  <c:v>3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6</c:v>
                </c:pt>
                <c:pt idx="5">
                  <c:v>1</c:v>
                </c:pt>
                <c:pt idx="6">
                  <c:v>2</c:v>
                </c:pt>
                <c:pt idx="7">
                  <c:v>2</c:v>
                </c:pt>
                <c:pt idx="8">
                  <c:v>3</c:v>
                </c:pt>
                <c:pt idx="9">
                  <c:v>3</c:v>
                </c:pt>
                <c:pt idx="10">
                  <c:v>4</c:v>
                </c:pt>
                <c:pt idx="11">
                  <c:v>4</c:v>
                </c:pt>
                <c:pt idx="12">
                  <c:v>7</c:v>
                </c:pt>
                <c:pt idx="13">
                  <c:v>6</c:v>
                </c:pt>
                <c:pt idx="14">
                  <c:v>6</c:v>
                </c:pt>
                <c:pt idx="15">
                  <c:v>10</c:v>
                </c:pt>
                <c:pt idx="16">
                  <c:v>10</c:v>
                </c:pt>
                <c:pt idx="17">
                  <c:v>12</c:v>
                </c:pt>
                <c:pt idx="18">
                  <c:v>10</c:v>
                </c:pt>
                <c:pt idx="19">
                  <c:v>12</c:v>
                </c:pt>
                <c:pt idx="20">
                  <c:v>12</c:v>
                </c:pt>
                <c:pt idx="21">
                  <c:v>8</c:v>
                </c:pt>
                <c:pt idx="22">
                  <c:v>9</c:v>
                </c:pt>
                <c:pt idx="23">
                  <c:v>10</c:v>
                </c:pt>
                <c:pt idx="24">
                  <c:v>10</c:v>
                </c:pt>
                <c:pt idx="25">
                  <c:v>10</c:v>
                </c:pt>
                <c:pt idx="26">
                  <c:v>12</c:v>
                </c:pt>
                <c:pt idx="27">
                  <c:v>12</c:v>
                </c:pt>
                <c:pt idx="28">
                  <c:v>13</c:v>
                </c:pt>
                <c:pt idx="29">
                  <c:v>10</c:v>
                </c:pt>
                <c:pt idx="30">
                  <c:v>13</c:v>
                </c:pt>
                <c:pt idx="31">
                  <c:v>13</c:v>
                </c:pt>
                <c:pt idx="32">
                  <c:v>17</c:v>
                </c:pt>
                <c:pt idx="33">
                  <c:v>15</c:v>
                </c:pt>
                <c:pt idx="34">
                  <c:v>19</c:v>
                </c:pt>
                <c:pt idx="35">
                  <c:v>16</c:v>
                </c:pt>
                <c:pt idx="36">
                  <c:v>15</c:v>
                </c:pt>
                <c:pt idx="37">
                  <c:v>18</c:v>
                </c:pt>
                <c:pt idx="38">
                  <c:v>21</c:v>
                </c:pt>
                <c:pt idx="39">
                  <c:v>24</c:v>
                </c:pt>
                <c:pt idx="40">
                  <c:v>28</c:v>
                </c:pt>
                <c:pt idx="41">
                  <c:v>25</c:v>
                </c:pt>
                <c:pt idx="42">
                  <c:v>28</c:v>
                </c:pt>
                <c:pt idx="43">
                  <c:v>33</c:v>
                </c:pt>
                <c:pt idx="44">
                  <c:v>36</c:v>
                </c:pt>
                <c:pt idx="45">
                  <c:v>39</c:v>
                </c:pt>
                <c:pt idx="46">
                  <c:v>41</c:v>
                </c:pt>
                <c:pt idx="47">
                  <c:v>49</c:v>
                </c:pt>
                <c:pt idx="48">
                  <c:v>55</c:v>
                </c:pt>
                <c:pt idx="49">
                  <c:v>57</c:v>
                </c:pt>
                <c:pt idx="50">
                  <c:v>39</c:v>
                </c:pt>
                <c:pt idx="51">
                  <c:v>40</c:v>
                </c:pt>
                <c:pt idx="52">
                  <c:v>50</c:v>
                </c:pt>
                <c:pt idx="53">
                  <c:v>54</c:v>
                </c:pt>
                <c:pt idx="54">
                  <c:v>31</c:v>
                </c:pt>
                <c:pt idx="55">
                  <c:v>58</c:v>
                </c:pt>
                <c:pt idx="56">
                  <c:v>103</c:v>
                </c:pt>
                <c:pt idx="57">
                  <c:v>112</c:v>
                </c:pt>
                <c:pt idx="58">
                  <c:v>114</c:v>
                </c:pt>
                <c:pt idx="59">
                  <c:v>114</c:v>
                </c:pt>
                <c:pt idx="60">
                  <c:v>121</c:v>
                </c:pt>
                <c:pt idx="61">
                  <c:v>109</c:v>
                </c:pt>
                <c:pt idx="62">
                  <c:v>123</c:v>
                </c:pt>
                <c:pt idx="63">
                  <c:v>123</c:v>
                </c:pt>
                <c:pt idx="64">
                  <c:v>123</c:v>
                </c:pt>
                <c:pt idx="65">
                  <c:v>123</c:v>
                </c:pt>
                <c:pt idx="66">
                  <c:v>115</c:v>
                </c:pt>
                <c:pt idx="67">
                  <c:v>127</c:v>
                </c:pt>
                <c:pt idx="68">
                  <c:v>128</c:v>
                </c:pt>
                <c:pt idx="69">
                  <c:v>128</c:v>
                </c:pt>
                <c:pt idx="70">
                  <c:v>132</c:v>
                </c:pt>
                <c:pt idx="71">
                  <c:v>118</c:v>
                </c:pt>
                <c:pt idx="72">
                  <c:v>145</c:v>
                </c:pt>
                <c:pt idx="73">
                  <c:v>150</c:v>
                </c:pt>
                <c:pt idx="74">
                  <c:v>155</c:v>
                </c:pt>
                <c:pt idx="75">
                  <c:v>194</c:v>
                </c:pt>
                <c:pt idx="76">
                  <c:v>236</c:v>
                </c:pt>
                <c:pt idx="77">
                  <c:v>69</c:v>
                </c:pt>
                <c:pt idx="78">
                  <c:v>69</c:v>
                </c:pt>
                <c:pt idx="79">
                  <c:v>85</c:v>
                </c:pt>
                <c:pt idx="80">
                  <c:v>87</c:v>
                </c:pt>
                <c:pt idx="81">
                  <c:v>89</c:v>
                </c:pt>
                <c:pt idx="82">
                  <c:v>94</c:v>
                </c:pt>
                <c:pt idx="83">
                  <c:v>94</c:v>
                </c:pt>
                <c:pt idx="84">
                  <c:v>96</c:v>
                </c:pt>
                <c:pt idx="85">
                  <c:v>107</c:v>
                </c:pt>
                <c:pt idx="86">
                  <c:v>107</c:v>
                </c:pt>
                <c:pt idx="87">
                  <c:v>108</c:v>
                </c:pt>
                <c:pt idx="88">
                  <c:v>108</c:v>
                </c:pt>
                <c:pt idx="89">
                  <c:v>113</c:v>
                </c:pt>
                <c:pt idx="90">
                  <c:v>117</c:v>
                </c:pt>
                <c:pt idx="91">
                  <c:v>115</c:v>
                </c:pt>
                <c:pt idx="92">
                  <c:v>117</c:v>
                </c:pt>
                <c:pt idx="93">
                  <c:v>119</c:v>
                </c:pt>
                <c:pt idx="94">
                  <c:v>126</c:v>
                </c:pt>
                <c:pt idx="95">
                  <c:v>174</c:v>
                </c:pt>
                <c:pt idx="96">
                  <c:v>205</c:v>
                </c:pt>
                <c:pt idx="97">
                  <c:v>129</c:v>
                </c:pt>
                <c:pt idx="98">
                  <c:v>237</c:v>
                </c:pt>
              </c:numCache>
            </c:numRef>
          </c:xVal>
          <c:yVal>
            <c:numRef>
              <c:f>'[Corrected DSS data OJ IFNL.xlsx]Scatter plot DfSO WHO IFNL2'!$G$8:$G$106</c:f>
              <c:numCache>
                <c:formatCode>General</c:formatCode>
                <c:ptCount val="99"/>
                <c:pt idx="0">
                  <c:v>0</c:v>
                </c:pt>
                <c:pt idx="1">
                  <c:v>2.926136571067449</c:v>
                </c:pt>
                <c:pt idx="2">
                  <c:v>2.7168377232995247</c:v>
                </c:pt>
                <c:pt idx="3">
                  <c:v>0</c:v>
                </c:pt>
                <c:pt idx="4">
                  <c:v>0</c:v>
                </c:pt>
                <c:pt idx="5">
                  <c:v>1.6968803716827623</c:v>
                </c:pt>
                <c:pt idx="6">
                  <c:v>2.7044079273868409</c:v>
                </c:pt>
                <c:pt idx="7">
                  <c:v>0</c:v>
                </c:pt>
                <c:pt idx="8">
                  <c:v>0</c:v>
                </c:pt>
                <c:pt idx="9">
                  <c:v>2.5991185650553628</c:v>
                </c:pt>
                <c:pt idx="10">
                  <c:v>0</c:v>
                </c:pt>
                <c:pt idx="11">
                  <c:v>3.3418300569205104</c:v>
                </c:pt>
                <c:pt idx="12">
                  <c:v>2.9960298284110767</c:v>
                </c:pt>
                <c:pt idx="13">
                  <c:v>3.3228392726863212</c:v>
                </c:pt>
                <c:pt idx="14">
                  <c:v>1.3836358683618797</c:v>
                </c:pt>
                <c:pt idx="15">
                  <c:v>1.7935110057928578</c:v>
                </c:pt>
                <c:pt idx="16">
                  <c:v>3.9046614579155245</c:v>
                </c:pt>
                <c:pt idx="17">
                  <c:v>1.7042363373087877</c:v>
                </c:pt>
                <c:pt idx="18">
                  <c:v>0</c:v>
                </c:pt>
                <c:pt idx="19">
                  <c:v>2.1408221801093106</c:v>
                </c:pt>
                <c:pt idx="20">
                  <c:v>3.2068258760318495</c:v>
                </c:pt>
                <c:pt idx="21">
                  <c:v>0</c:v>
                </c:pt>
                <c:pt idx="22">
                  <c:v>2.5078558716958308</c:v>
                </c:pt>
                <c:pt idx="23">
                  <c:v>0</c:v>
                </c:pt>
                <c:pt idx="24">
                  <c:v>3.284881714655453</c:v>
                </c:pt>
                <c:pt idx="25">
                  <c:v>0</c:v>
                </c:pt>
                <c:pt idx="26">
                  <c:v>2.5361795321372251</c:v>
                </c:pt>
                <c:pt idx="27">
                  <c:v>2.2697463731307672</c:v>
                </c:pt>
                <c:pt idx="28">
                  <c:v>0</c:v>
                </c:pt>
                <c:pt idx="29">
                  <c:v>3.7722483399718536</c:v>
                </c:pt>
                <c:pt idx="30">
                  <c:v>1.735519058815171</c:v>
                </c:pt>
                <c:pt idx="31">
                  <c:v>2.6343764940883676</c:v>
                </c:pt>
                <c:pt idx="32">
                  <c:v>3.0711452904510828</c:v>
                </c:pt>
                <c:pt idx="33">
                  <c:v>2.295127085252191</c:v>
                </c:pt>
                <c:pt idx="34">
                  <c:v>2.6091673743020198</c:v>
                </c:pt>
                <c:pt idx="35">
                  <c:v>2.3036279763838898</c:v>
                </c:pt>
                <c:pt idx="36">
                  <c:v>0</c:v>
                </c:pt>
                <c:pt idx="37">
                  <c:v>2.6231458746379395</c:v>
                </c:pt>
                <c:pt idx="38">
                  <c:v>2.5158738437116792</c:v>
                </c:pt>
                <c:pt idx="39">
                  <c:v>0</c:v>
                </c:pt>
                <c:pt idx="40">
                  <c:v>2.852601969338235</c:v>
                </c:pt>
                <c:pt idx="41">
                  <c:v>2.7268901407418218</c:v>
                </c:pt>
                <c:pt idx="42">
                  <c:v>1.6184664921990803</c:v>
                </c:pt>
                <c:pt idx="43">
                  <c:v>2.8294967497201826</c:v>
                </c:pt>
                <c:pt idx="44">
                  <c:v>1.5819496583733179</c:v>
                </c:pt>
                <c:pt idx="45">
                  <c:v>2.9023836844324715</c:v>
                </c:pt>
                <c:pt idx="46">
                  <c:v>2.0561422620590522</c:v>
                </c:pt>
                <c:pt idx="47">
                  <c:v>1.2803506930460056</c:v>
                </c:pt>
                <c:pt idx="48">
                  <c:v>3.802705327074352</c:v>
                </c:pt>
                <c:pt idx="49">
                  <c:v>2.8768526476013436</c:v>
                </c:pt>
                <c:pt idx="50">
                  <c:v>2.1869563354654122</c:v>
                </c:pt>
                <c:pt idx="51">
                  <c:v>1.2723058444020865</c:v>
                </c:pt>
                <c:pt idx="52">
                  <c:v>0</c:v>
                </c:pt>
                <c:pt idx="53">
                  <c:v>2.8014037100173552</c:v>
                </c:pt>
                <c:pt idx="54">
                  <c:v>3.7305400364771191</c:v>
                </c:pt>
                <c:pt idx="55">
                  <c:v>3.3896975482063856</c:v>
                </c:pt>
                <c:pt idx="56">
                  <c:v>3.2435341018320618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3.9252605095194353</c:v>
                </c:pt>
                <c:pt idx="61">
                  <c:v>1.9223620967847901</c:v>
                </c:pt>
                <c:pt idx="62">
                  <c:v>2.3261309567107946</c:v>
                </c:pt>
                <c:pt idx="63">
                  <c:v>0</c:v>
                </c:pt>
                <c:pt idx="64">
                  <c:v>2.1568519010700111</c:v>
                </c:pt>
                <c:pt idx="65">
                  <c:v>0</c:v>
                </c:pt>
                <c:pt idx="66">
                  <c:v>0</c:v>
                </c:pt>
                <c:pt idx="67">
                  <c:v>3.7712934426290596</c:v>
                </c:pt>
                <c:pt idx="68">
                  <c:v>3.9593276459721709</c:v>
                </c:pt>
                <c:pt idx="69">
                  <c:v>2.4101020766428607</c:v>
                </c:pt>
                <c:pt idx="70">
                  <c:v>0</c:v>
                </c:pt>
                <c:pt idx="71">
                  <c:v>0</c:v>
                </c:pt>
                <c:pt idx="72">
                  <c:v>3.8167714123333463</c:v>
                </c:pt>
                <c:pt idx="73">
                  <c:v>3.0549958615291417</c:v>
                </c:pt>
                <c:pt idx="74">
                  <c:v>2.8208579894397001</c:v>
                </c:pt>
                <c:pt idx="75">
                  <c:v>3.5395778833453089</c:v>
                </c:pt>
                <c:pt idx="76">
                  <c:v>3.0674428427763805</c:v>
                </c:pt>
                <c:pt idx="77">
                  <c:v>0</c:v>
                </c:pt>
                <c:pt idx="78">
                  <c:v>2.5160062303860475</c:v>
                </c:pt>
                <c:pt idx="79">
                  <c:v>1.1684974835230326</c:v>
                </c:pt>
                <c:pt idx="80">
                  <c:v>1.9365640051352659</c:v>
                </c:pt>
                <c:pt idx="81">
                  <c:v>2.1939589780191868</c:v>
                </c:pt>
                <c:pt idx="82">
                  <c:v>3.3096301674258988</c:v>
                </c:pt>
                <c:pt idx="83">
                  <c:v>3.7511250715355837</c:v>
                </c:pt>
                <c:pt idx="84">
                  <c:v>2.0216027160282422</c:v>
                </c:pt>
                <c:pt idx="85">
                  <c:v>2.9024924211586036</c:v>
                </c:pt>
                <c:pt idx="86">
                  <c:v>0</c:v>
                </c:pt>
                <c:pt idx="87">
                  <c:v>1.9971678714458339</c:v>
                </c:pt>
                <c:pt idx="88">
                  <c:v>2.8162412999917832</c:v>
                </c:pt>
                <c:pt idx="89">
                  <c:v>2.1238516409670858</c:v>
                </c:pt>
                <c:pt idx="90">
                  <c:v>1.7964355588101746</c:v>
                </c:pt>
                <c:pt idx="91">
                  <c:v>0</c:v>
                </c:pt>
                <c:pt idx="92">
                  <c:v>1.2390490931401914</c:v>
                </c:pt>
                <c:pt idx="93">
                  <c:v>3.1176026916900841</c:v>
                </c:pt>
                <c:pt idx="94">
                  <c:v>0</c:v>
                </c:pt>
                <c:pt idx="95">
                  <c:v>2.5515719736742537</c:v>
                </c:pt>
                <c:pt idx="96">
                  <c:v>4.0618669721385627</c:v>
                </c:pt>
                <c:pt idx="97">
                  <c:v>0</c:v>
                </c:pt>
                <c:pt idx="98">
                  <c:v>3.63477945814595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051-194B-B538-246EBBF1979C}"/>
            </c:ext>
          </c:extLst>
        </c:ser>
        <c:ser>
          <c:idx val="2"/>
          <c:order val="2"/>
          <c:tx>
            <c:v>WHO 5-8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75000"/>
                </a:schemeClr>
              </a:solidFill>
              <a:ln w="9525">
                <a:solidFill>
                  <a:schemeClr val="dk1">
                    <a:tint val="75000"/>
                  </a:schemeClr>
                </a:solidFill>
              </a:ln>
              <a:effectLst/>
            </c:spPr>
          </c:marker>
          <c:xVal>
            <c:numRef>
              <c:f>'[Corrected DSS data OJ IFNL.xlsx]Scatter plot DfSO WHO IFNL2'!$H$8:$H$54</c:f>
              <c:numCache>
                <c:formatCode>General</c:formatCode>
                <c:ptCount val="47"/>
                <c:pt idx="0">
                  <c:v>0</c:v>
                </c:pt>
                <c:pt idx="1">
                  <c:v>3</c:v>
                </c:pt>
                <c:pt idx="2">
                  <c:v>4</c:v>
                </c:pt>
                <c:pt idx="3">
                  <c:v>1</c:v>
                </c:pt>
                <c:pt idx="4">
                  <c:v>2</c:v>
                </c:pt>
                <c:pt idx="5">
                  <c:v>4</c:v>
                </c:pt>
                <c:pt idx="6">
                  <c:v>7</c:v>
                </c:pt>
                <c:pt idx="7">
                  <c:v>3</c:v>
                </c:pt>
                <c:pt idx="8">
                  <c:v>6</c:v>
                </c:pt>
                <c:pt idx="9">
                  <c:v>2</c:v>
                </c:pt>
                <c:pt idx="10">
                  <c:v>3</c:v>
                </c:pt>
                <c:pt idx="11">
                  <c:v>5</c:v>
                </c:pt>
                <c:pt idx="12">
                  <c:v>5</c:v>
                </c:pt>
                <c:pt idx="13">
                  <c:v>6</c:v>
                </c:pt>
                <c:pt idx="14">
                  <c:v>5</c:v>
                </c:pt>
                <c:pt idx="15">
                  <c:v>8</c:v>
                </c:pt>
                <c:pt idx="16">
                  <c:v>8</c:v>
                </c:pt>
                <c:pt idx="17">
                  <c:v>8</c:v>
                </c:pt>
                <c:pt idx="18">
                  <c:v>13</c:v>
                </c:pt>
                <c:pt idx="19">
                  <c:v>9</c:v>
                </c:pt>
                <c:pt idx="20">
                  <c:v>13</c:v>
                </c:pt>
                <c:pt idx="21">
                  <c:v>8</c:v>
                </c:pt>
                <c:pt idx="22">
                  <c:v>8</c:v>
                </c:pt>
                <c:pt idx="23">
                  <c:v>12</c:v>
                </c:pt>
                <c:pt idx="24">
                  <c:v>17</c:v>
                </c:pt>
                <c:pt idx="25">
                  <c:v>17</c:v>
                </c:pt>
                <c:pt idx="26">
                  <c:v>20</c:v>
                </c:pt>
                <c:pt idx="27">
                  <c:v>24</c:v>
                </c:pt>
                <c:pt idx="28">
                  <c:v>26</c:v>
                </c:pt>
                <c:pt idx="29">
                  <c:v>16</c:v>
                </c:pt>
                <c:pt idx="30">
                  <c:v>37</c:v>
                </c:pt>
                <c:pt idx="31">
                  <c:v>41</c:v>
                </c:pt>
                <c:pt idx="32">
                  <c:v>31</c:v>
                </c:pt>
                <c:pt idx="33">
                  <c:v>114</c:v>
                </c:pt>
                <c:pt idx="34">
                  <c:v>120</c:v>
                </c:pt>
                <c:pt idx="35">
                  <c:v>123</c:v>
                </c:pt>
                <c:pt idx="36">
                  <c:v>124</c:v>
                </c:pt>
                <c:pt idx="37">
                  <c:v>128</c:v>
                </c:pt>
                <c:pt idx="38">
                  <c:v>131</c:v>
                </c:pt>
                <c:pt idx="39">
                  <c:v>162</c:v>
                </c:pt>
                <c:pt idx="40">
                  <c:v>216</c:v>
                </c:pt>
                <c:pt idx="41">
                  <c:v>116</c:v>
                </c:pt>
                <c:pt idx="42">
                  <c:v>117</c:v>
                </c:pt>
                <c:pt idx="43">
                  <c:v>137</c:v>
                </c:pt>
                <c:pt idx="44">
                  <c:v>192</c:v>
                </c:pt>
                <c:pt idx="45">
                  <c:v>114</c:v>
                </c:pt>
                <c:pt idx="46">
                  <c:v>216</c:v>
                </c:pt>
              </c:numCache>
            </c:numRef>
          </c:xVal>
          <c:yVal>
            <c:numRef>
              <c:f>'[Corrected DSS data OJ IFNL.xlsx]Scatter plot DfSO WHO IFNL2'!$J$8:$J$54</c:f>
              <c:numCache>
                <c:formatCode>General</c:formatCode>
                <c:ptCount val="47"/>
                <c:pt idx="0">
                  <c:v>0</c:v>
                </c:pt>
                <c:pt idx="1">
                  <c:v>2.697578033651113</c:v>
                </c:pt>
                <c:pt idx="2">
                  <c:v>3.4601458174917501</c:v>
                </c:pt>
                <c:pt idx="3">
                  <c:v>0</c:v>
                </c:pt>
                <c:pt idx="4">
                  <c:v>0</c:v>
                </c:pt>
                <c:pt idx="5">
                  <c:v>2.4679039465228003</c:v>
                </c:pt>
                <c:pt idx="6">
                  <c:v>2.500373714353374</c:v>
                </c:pt>
                <c:pt idx="7">
                  <c:v>1.2743887955503788</c:v>
                </c:pt>
                <c:pt idx="8">
                  <c:v>0</c:v>
                </c:pt>
                <c:pt idx="9">
                  <c:v>0</c:v>
                </c:pt>
                <c:pt idx="10">
                  <c:v>3.318272080211627</c:v>
                </c:pt>
                <c:pt idx="11">
                  <c:v>1.9641181431514849</c:v>
                </c:pt>
                <c:pt idx="12">
                  <c:v>0.96146855535078635</c:v>
                </c:pt>
                <c:pt idx="13">
                  <c:v>2.7502769151539925</c:v>
                </c:pt>
                <c:pt idx="14">
                  <c:v>0</c:v>
                </c:pt>
                <c:pt idx="15">
                  <c:v>0</c:v>
                </c:pt>
                <c:pt idx="16">
                  <c:v>1.89148170383952</c:v>
                </c:pt>
                <c:pt idx="17">
                  <c:v>0</c:v>
                </c:pt>
                <c:pt idx="18">
                  <c:v>0</c:v>
                </c:pt>
                <c:pt idx="19">
                  <c:v>3.2405492482825999</c:v>
                </c:pt>
                <c:pt idx="20">
                  <c:v>3.3492775274679554</c:v>
                </c:pt>
                <c:pt idx="21">
                  <c:v>3.4881274962474587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2.4449811120879446</c:v>
                </c:pt>
                <c:pt idx="26">
                  <c:v>1.2442771208018428</c:v>
                </c:pt>
                <c:pt idx="27">
                  <c:v>3.8371463439090601</c:v>
                </c:pt>
                <c:pt idx="28">
                  <c:v>1.6354837468149122</c:v>
                </c:pt>
                <c:pt idx="29">
                  <c:v>0</c:v>
                </c:pt>
                <c:pt idx="30">
                  <c:v>0</c:v>
                </c:pt>
                <c:pt idx="31">
                  <c:v>2.8041394323353503</c:v>
                </c:pt>
                <c:pt idx="32">
                  <c:v>1.7037211599270199</c:v>
                </c:pt>
                <c:pt idx="33">
                  <c:v>3.4801507252732806</c:v>
                </c:pt>
                <c:pt idx="34">
                  <c:v>0</c:v>
                </c:pt>
                <c:pt idx="35">
                  <c:v>0</c:v>
                </c:pt>
                <c:pt idx="36">
                  <c:v>3.2860071220794747</c:v>
                </c:pt>
                <c:pt idx="37">
                  <c:v>3.6135247028536526</c:v>
                </c:pt>
                <c:pt idx="38">
                  <c:v>3.7352794480604565</c:v>
                </c:pt>
                <c:pt idx="39">
                  <c:v>3.7693034601890818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3.9643539292921934</c:v>
                </c:pt>
                <c:pt idx="44">
                  <c:v>0</c:v>
                </c:pt>
                <c:pt idx="45">
                  <c:v>3.3647385550553985</c:v>
                </c:pt>
                <c:pt idx="46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051-194B-B538-246EBBF197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8345072"/>
        <c:axId val="1393464832"/>
      </c:scatterChart>
      <c:valAx>
        <c:axId val="32834507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DfSO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3464832"/>
        <c:crosses val="autoZero"/>
        <c:crossBetween val="midCat"/>
      </c:valAx>
      <c:valAx>
        <c:axId val="13934648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IFNL2</a:t>
                </a:r>
                <a:r>
                  <a:rPr lang="en-GB" baseline="0"/>
                  <a:t> log10+1</a:t>
                </a:r>
                <a:endParaRPr lang="en-GB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834507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WHO 1-2</c:v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xVal>
            <c:numRef>
              <c:f>'[Corrected DSS data OJ IFNL.xlsx]Scatter plot DfSO WHO IFNL2'!$C$8:$C$145</c:f>
              <c:numCache>
                <c:formatCode>General</c:formatCode>
                <c:ptCount val="138"/>
                <c:pt idx="0">
                  <c:v>2</c:v>
                </c:pt>
                <c:pt idx="1">
                  <c:v>0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5</c:v>
                </c:pt>
                <c:pt idx="6">
                  <c:v>7</c:v>
                </c:pt>
                <c:pt idx="7">
                  <c:v>6</c:v>
                </c:pt>
                <c:pt idx="8">
                  <c:v>5</c:v>
                </c:pt>
                <c:pt idx="9">
                  <c:v>6</c:v>
                </c:pt>
                <c:pt idx="10">
                  <c:v>8</c:v>
                </c:pt>
                <c:pt idx="11">
                  <c:v>10</c:v>
                </c:pt>
                <c:pt idx="12">
                  <c:v>10</c:v>
                </c:pt>
                <c:pt idx="13">
                  <c:v>8</c:v>
                </c:pt>
                <c:pt idx="14">
                  <c:v>11</c:v>
                </c:pt>
                <c:pt idx="15">
                  <c:v>10</c:v>
                </c:pt>
                <c:pt idx="16">
                  <c:v>10</c:v>
                </c:pt>
                <c:pt idx="17">
                  <c:v>11</c:v>
                </c:pt>
                <c:pt idx="18">
                  <c:v>12</c:v>
                </c:pt>
                <c:pt idx="19">
                  <c:v>12</c:v>
                </c:pt>
                <c:pt idx="20">
                  <c:v>13</c:v>
                </c:pt>
                <c:pt idx="21">
                  <c:v>14</c:v>
                </c:pt>
                <c:pt idx="22">
                  <c:v>14</c:v>
                </c:pt>
                <c:pt idx="23">
                  <c:v>13</c:v>
                </c:pt>
                <c:pt idx="24">
                  <c:v>14</c:v>
                </c:pt>
                <c:pt idx="25">
                  <c:v>16</c:v>
                </c:pt>
                <c:pt idx="26">
                  <c:v>20</c:v>
                </c:pt>
                <c:pt idx="27">
                  <c:v>20</c:v>
                </c:pt>
                <c:pt idx="28">
                  <c:v>15</c:v>
                </c:pt>
                <c:pt idx="29">
                  <c:v>16</c:v>
                </c:pt>
                <c:pt idx="30">
                  <c:v>16</c:v>
                </c:pt>
                <c:pt idx="31">
                  <c:v>16</c:v>
                </c:pt>
                <c:pt idx="32">
                  <c:v>16</c:v>
                </c:pt>
                <c:pt idx="33">
                  <c:v>19</c:v>
                </c:pt>
                <c:pt idx="34">
                  <c:v>19</c:v>
                </c:pt>
                <c:pt idx="35">
                  <c:v>19</c:v>
                </c:pt>
                <c:pt idx="36">
                  <c:v>20</c:v>
                </c:pt>
                <c:pt idx="37">
                  <c:v>20</c:v>
                </c:pt>
                <c:pt idx="38">
                  <c:v>21</c:v>
                </c:pt>
                <c:pt idx="39">
                  <c:v>22</c:v>
                </c:pt>
                <c:pt idx="40">
                  <c:v>23</c:v>
                </c:pt>
                <c:pt idx="41">
                  <c:v>24</c:v>
                </c:pt>
                <c:pt idx="42">
                  <c:v>24</c:v>
                </c:pt>
                <c:pt idx="43">
                  <c:v>25</c:v>
                </c:pt>
                <c:pt idx="44">
                  <c:v>27</c:v>
                </c:pt>
                <c:pt idx="45">
                  <c:v>27</c:v>
                </c:pt>
                <c:pt idx="46">
                  <c:v>28</c:v>
                </c:pt>
                <c:pt idx="47">
                  <c:v>29</c:v>
                </c:pt>
                <c:pt idx="48">
                  <c:v>29</c:v>
                </c:pt>
                <c:pt idx="49">
                  <c:v>30</c:v>
                </c:pt>
                <c:pt idx="50">
                  <c:v>19</c:v>
                </c:pt>
                <c:pt idx="51">
                  <c:v>22</c:v>
                </c:pt>
                <c:pt idx="52">
                  <c:v>30</c:v>
                </c:pt>
                <c:pt idx="53">
                  <c:v>33</c:v>
                </c:pt>
                <c:pt idx="54">
                  <c:v>37</c:v>
                </c:pt>
                <c:pt idx="55">
                  <c:v>40</c:v>
                </c:pt>
                <c:pt idx="56">
                  <c:v>40</c:v>
                </c:pt>
                <c:pt idx="57">
                  <c:v>41</c:v>
                </c:pt>
                <c:pt idx="58">
                  <c:v>45</c:v>
                </c:pt>
                <c:pt idx="59">
                  <c:v>47</c:v>
                </c:pt>
                <c:pt idx="60">
                  <c:v>54</c:v>
                </c:pt>
                <c:pt idx="61">
                  <c:v>56</c:v>
                </c:pt>
                <c:pt idx="62">
                  <c:v>57</c:v>
                </c:pt>
                <c:pt idx="63">
                  <c:v>60</c:v>
                </c:pt>
                <c:pt idx="64">
                  <c:v>60</c:v>
                </c:pt>
                <c:pt idx="65">
                  <c:v>31</c:v>
                </c:pt>
                <c:pt idx="66">
                  <c:v>34</c:v>
                </c:pt>
                <c:pt idx="67">
                  <c:v>34</c:v>
                </c:pt>
                <c:pt idx="68">
                  <c:v>35</c:v>
                </c:pt>
                <c:pt idx="69">
                  <c:v>36</c:v>
                </c:pt>
                <c:pt idx="70">
                  <c:v>36</c:v>
                </c:pt>
                <c:pt idx="71">
                  <c:v>36</c:v>
                </c:pt>
                <c:pt idx="72">
                  <c:v>39</c:v>
                </c:pt>
                <c:pt idx="73">
                  <c:v>40</c:v>
                </c:pt>
                <c:pt idx="74">
                  <c:v>40</c:v>
                </c:pt>
                <c:pt idx="75">
                  <c:v>41</c:v>
                </c:pt>
                <c:pt idx="76">
                  <c:v>42</c:v>
                </c:pt>
                <c:pt idx="77">
                  <c:v>42</c:v>
                </c:pt>
                <c:pt idx="78">
                  <c:v>43</c:v>
                </c:pt>
                <c:pt idx="79">
                  <c:v>43</c:v>
                </c:pt>
                <c:pt idx="80">
                  <c:v>48</c:v>
                </c:pt>
                <c:pt idx="81">
                  <c:v>48</c:v>
                </c:pt>
                <c:pt idx="82">
                  <c:v>49</c:v>
                </c:pt>
                <c:pt idx="83">
                  <c:v>50</c:v>
                </c:pt>
                <c:pt idx="84">
                  <c:v>52</c:v>
                </c:pt>
                <c:pt idx="85">
                  <c:v>53</c:v>
                </c:pt>
                <c:pt idx="86">
                  <c:v>53</c:v>
                </c:pt>
                <c:pt idx="87">
                  <c:v>53</c:v>
                </c:pt>
                <c:pt idx="88">
                  <c:v>53</c:v>
                </c:pt>
                <c:pt idx="89">
                  <c:v>55</c:v>
                </c:pt>
                <c:pt idx="90">
                  <c:v>56</c:v>
                </c:pt>
                <c:pt idx="91">
                  <c:v>57</c:v>
                </c:pt>
                <c:pt idx="92">
                  <c:v>58</c:v>
                </c:pt>
                <c:pt idx="93">
                  <c:v>59</c:v>
                </c:pt>
                <c:pt idx="94">
                  <c:v>36</c:v>
                </c:pt>
                <c:pt idx="95">
                  <c:v>52</c:v>
                </c:pt>
                <c:pt idx="96">
                  <c:v>59</c:v>
                </c:pt>
                <c:pt idx="97">
                  <c:v>63</c:v>
                </c:pt>
                <c:pt idx="98">
                  <c:v>68</c:v>
                </c:pt>
                <c:pt idx="99">
                  <c:v>70</c:v>
                </c:pt>
                <c:pt idx="100">
                  <c:v>71</c:v>
                </c:pt>
                <c:pt idx="101">
                  <c:v>85</c:v>
                </c:pt>
                <c:pt idx="102">
                  <c:v>101</c:v>
                </c:pt>
                <c:pt idx="103">
                  <c:v>108</c:v>
                </c:pt>
                <c:pt idx="104">
                  <c:v>114</c:v>
                </c:pt>
                <c:pt idx="105">
                  <c:v>140</c:v>
                </c:pt>
                <c:pt idx="106">
                  <c:v>255</c:v>
                </c:pt>
                <c:pt idx="107">
                  <c:v>61</c:v>
                </c:pt>
                <c:pt idx="108">
                  <c:v>61</c:v>
                </c:pt>
                <c:pt idx="109">
                  <c:v>61</c:v>
                </c:pt>
                <c:pt idx="110">
                  <c:v>62</c:v>
                </c:pt>
                <c:pt idx="111">
                  <c:v>62</c:v>
                </c:pt>
                <c:pt idx="112">
                  <c:v>63</c:v>
                </c:pt>
                <c:pt idx="113">
                  <c:v>65</c:v>
                </c:pt>
                <c:pt idx="114">
                  <c:v>66</c:v>
                </c:pt>
                <c:pt idx="115">
                  <c:v>66</c:v>
                </c:pt>
                <c:pt idx="116">
                  <c:v>68</c:v>
                </c:pt>
                <c:pt idx="117">
                  <c:v>69</c:v>
                </c:pt>
                <c:pt idx="118">
                  <c:v>71</c:v>
                </c:pt>
                <c:pt idx="119">
                  <c:v>71</c:v>
                </c:pt>
                <c:pt idx="120">
                  <c:v>76</c:v>
                </c:pt>
                <c:pt idx="121">
                  <c:v>78</c:v>
                </c:pt>
                <c:pt idx="122">
                  <c:v>79</c:v>
                </c:pt>
                <c:pt idx="123">
                  <c:v>88</c:v>
                </c:pt>
                <c:pt idx="124">
                  <c:v>92</c:v>
                </c:pt>
                <c:pt idx="125">
                  <c:v>95</c:v>
                </c:pt>
                <c:pt idx="126">
                  <c:v>100</c:v>
                </c:pt>
                <c:pt idx="127">
                  <c:v>105</c:v>
                </c:pt>
                <c:pt idx="128">
                  <c:v>110</c:v>
                </c:pt>
                <c:pt idx="129">
                  <c:v>110</c:v>
                </c:pt>
                <c:pt idx="130">
                  <c:v>61</c:v>
                </c:pt>
                <c:pt idx="131">
                  <c:v>104</c:v>
                </c:pt>
                <c:pt idx="132">
                  <c:v>110</c:v>
                </c:pt>
                <c:pt idx="133">
                  <c:v>123</c:v>
                </c:pt>
                <c:pt idx="134">
                  <c:v>124</c:v>
                </c:pt>
                <c:pt idx="135">
                  <c:v>95</c:v>
                </c:pt>
                <c:pt idx="136">
                  <c:v>135</c:v>
                </c:pt>
                <c:pt idx="137">
                  <c:v>185</c:v>
                </c:pt>
              </c:numCache>
            </c:numRef>
          </c:xVal>
          <c:yVal>
            <c:numRef>
              <c:f>'[Corrected DSS data OJ IFNL.xlsx]Scatter plot DfSO WHO IFNL2'!$D$8:$D$145</c:f>
              <c:numCache>
                <c:formatCode>General</c:formatCode>
                <c:ptCount val="138"/>
                <c:pt idx="0">
                  <c:v>1.36679638328673</c:v>
                </c:pt>
                <c:pt idx="1">
                  <c:v>2.2884728005997825</c:v>
                </c:pt>
                <c:pt idx="2">
                  <c:v>3.020775488193558</c:v>
                </c:pt>
                <c:pt idx="3">
                  <c:v>2.9613736275948011</c:v>
                </c:pt>
                <c:pt idx="4">
                  <c:v>2.7965049515532963</c:v>
                </c:pt>
                <c:pt idx="5">
                  <c:v>3.1280760126687155</c:v>
                </c:pt>
                <c:pt idx="6">
                  <c:v>2.8794399659952172</c:v>
                </c:pt>
                <c:pt idx="7">
                  <c:v>3.5169318088680126</c:v>
                </c:pt>
                <c:pt idx="8">
                  <c:v>2.8069935136821074</c:v>
                </c:pt>
                <c:pt idx="9">
                  <c:v>3.249198357391113</c:v>
                </c:pt>
                <c:pt idx="10">
                  <c:v>2.9088065994056742</c:v>
                </c:pt>
                <c:pt idx="11">
                  <c:v>2.7272158209084925</c:v>
                </c:pt>
                <c:pt idx="12">
                  <c:v>1.5956064348656029</c:v>
                </c:pt>
                <c:pt idx="13">
                  <c:v>3.8771985152717896</c:v>
                </c:pt>
                <c:pt idx="14">
                  <c:v>0.93323412871480804</c:v>
                </c:pt>
                <c:pt idx="15">
                  <c:v>3.5379449592914867</c:v>
                </c:pt>
                <c:pt idx="16">
                  <c:v>2.3694014136966244</c:v>
                </c:pt>
                <c:pt idx="17">
                  <c:v>3.2683439139510648</c:v>
                </c:pt>
                <c:pt idx="18">
                  <c:v>1.3664229572259727</c:v>
                </c:pt>
                <c:pt idx="19">
                  <c:v>0</c:v>
                </c:pt>
                <c:pt idx="20">
                  <c:v>2.1737688231366499</c:v>
                </c:pt>
                <c:pt idx="21">
                  <c:v>3.2559957267224018</c:v>
                </c:pt>
                <c:pt idx="22">
                  <c:v>1.2615007731982801</c:v>
                </c:pt>
                <c:pt idx="23">
                  <c:v>3.430075055551939</c:v>
                </c:pt>
                <c:pt idx="24">
                  <c:v>3.4860051863622421</c:v>
                </c:pt>
                <c:pt idx="25">
                  <c:v>2.6425634371043878</c:v>
                </c:pt>
                <c:pt idx="26">
                  <c:v>3.4171394097273255</c:v>
                </c:pt>
                <c:pt idx="27">
                  <c:v>0</c:v>
                </c:pt>
                <c:pt idx="28">
                  <c:v>0.79211140908716837</c:v>
                </c:pt>
                <c:pt idx="29">
                  <c:v>2.7693773260761385</c:v>
                </c:pt>
                <c:pt idx="30">
                  <c:v>1.5403294747908738</c:v>
                </c:pt>
                <c:pt idx="31">
                  <c:v>3.5830853663476878</c:v>
                </c:pt>
                <c:pt idx="32">
                  <c:v>2.2273724422896364</c:v>
                </c:pt>
                <c:pt idx="33">
                  <c:v>3.6725596277632757</c:v>
                </c:pt>
                <c:pt idx="34">
                  <c:v>3.2960066693136723</c:v>
                </c:pt>
                <c:pt idx="35">
                  <c:v>0</c:v>
                </c:pt>
                <c:pt idx="36">
                  <c:v>4.0577041315340301</c:v>
                </c:pt>
                <c:pt idx="37">
                  <c:v>0</c:v>
                </c:pt>
                <c:pt idx="38">
                  <c:v>3.2557547866430441</c:v>
                </c:pt>
                <c:pt idx="39">
                  <c:v>3.9576551669434914</c:v>
                </c:pt>
                <c:pt idx="40">
                  <c:v>3.5742628297070267</c:v>
                </c:pt>
                <c:pt idx="41">
                  <c:v>0</c:v>
                </c:pt>
                <c:pt idx="42">
                  <c:v>3.7983052820219765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3.3242824552976926</c:v>
                </c:pt>
                <c:pt idx="47">
                  <c:v>1.9607085516885565</c:v>
                </c:pt>
                <c:pt idx="48">
                  <c:v>2.6353832040474985</c:v>
                </c:pt>
                <c:pt idx="49">
                  <c:v>3.8580557180503643</c:v>
                </c:pt>
                <c:pt idx="50">
                  <c:v>1.7139103541289553</c:v>
                </c:pt>
                <c:pt idx="51">
                  <c:v>0</c:v>
                </c:pt>
                <c:pt idx="52">
                  <c:v>2.2595938788859486</c:v>
                </c:pt>
                <c:pt idx="53">
                  <c:v>1.7245216271185626</c:v>
                </c:pt>
                <c:pt idx="54">
                  <c:v>0</c:v>
                </c:pt>
                <c:pt idx="55">
                  <c:v>2.1031192535457137</c:v>
                </c:pt>
                <c:pt idx="56">
                  <c:v>3.1821292140529982</c:v>
                </c:pt>
                <c:pt idx="57">
                  <c:v>2.6171052305023781</c:v>
                </c:pt>
                <c:pt idx="58">
                  <c:v>2.3651134316275773</c:v>
                </c:pt>
                <c:pt idx="59">
                  <c:v>3.2245330626060857</c:v>
                </c:pt>
                <c:pt idx="60">
                  <c:v>3.8107028609471167</c:v>
                </c:pt>
                <c:pt idx="61">
                  <c:v>3.3756636139608855</c:v>
                </c:pt>
                <c:pt idx="62">
                  <c:v>1.2607866686549762</c:v>
                </c:pt>
                <c:pt idx="63">
                  <c:v>1.8036619232362243</c:v>
                </c:pt>
                <c:pt idx="64">
                  <c:v>3.1829849670035819</c:v>
                </c:pt>
                <c:pt idx="65">
                  <c:v>0</c:v>
                </c:pt>
                <c:pt idx="66">
                  <c:v>1.6668922110665363</c:v>
                </c:pt>
                <c:pt idx="67">
                  <c:v>0</c:v>
                </c:pt>
                <c:pt idx="68">
                  <c:v>3.2229764498933915</c:v>
                </c:pt>
                <c:pt idx="69">
                  <c:v>2.6329631681672612</c:v>
                </c:pt>
                <c:pt idx="70">
                  <c:v>3.7939998009844706</c:v>
                </c:pt>
                <c:pt idx="71">
                  <c:v>3.1136091510730277</c:v>
                </c:pt>
                <c:pt idx="72">
                  <c:v>3.8211203237768236</c:v>
                </c:pt>
                <c:pt idx="73">
                  <c:v>1.8845121591903939</c:v>
                </c:pt>
                <c:pt idx="74">
                  <c:v>3.5851221863068155</c:v>
                </c:pt>
                <c:pt idx="75">
                  <c:v>2.469674772551798</c:v>
                </c:pt>
                <c:pt idx="76">
                  <c:v>0.75358305889290655</c:v>
                </c:pt>
                <c:pt idx="77">
                  <c:v>0</c:v>
                </c:pt>
                <c:pt idx="78">
                  <c:v>3.7206553565517244</c:v>
                </c:pt>
                <c:pt idx="79">
                  <c:v>3.0762762554042178</c:v>
                </c:pt>
                <c:pt idx="80">
                  <c:v>2.4878451201114355</c:v>
                </c:pt>
                <c:pt idx="81">
                  <c:v>3.7627535649333739</c:v>
                </c:pt>
                <c:pt idx="82">
                  <c:v>3.7301360039966776</c:v>
                </c:pt>
                <c:pt idx="83">
                  <c:v>0</c:v>
                </c:pt>
                <c:pt idx="84">
                  <c:v>0</c:v>
                </c:pt>
                <c:pt idx="85">
                  <c:v>3.2405492482825999</c:v>
                </c:pt>
                <c:pt idx="86">
                  <c:v>0</c:v>
                </c:pt>
                <c:pt idx="87">
                  <c:v>0</c:v>
                </c:pt>
                <c:pt idx="88">
                  <c:v>1.9702073588068547</c:v>
                </c:pt>
                <c:pt idx="89">
                  <c:v>8.5825533520743083E-2</c:v>
                </c:pt>
                <c:pt idx="90">
                  <c:v>3.4906606533561368</c:v>
                </c:pt>
                <c:pt idx="91">
                  <c:v>1.9518230353159121</c:v>
                </c:pt>
                <c:pt idx="92">
                  <c:v>3.1357685145678222</c:v>
                </c:pt>
                <c:pt idx="93">
                  <c:v>3.5150786750759226</c:v>
                </c:pt>
                <c:pt idx="94">
                  <c:v>3.0542299098633974</c:v>
                </c:pt>
                <c:pt idx="95">
                  <c:v>0</c:v>
                </c:pt>
                <c:pt idx="96">
                  <c:v>2.3816564825857869</c:v>
                </c:pt>
                <c:pt idx="97">
                  <c:v>2.860397905127313</c:v>
                </c:pt>
                <c:pt idx="98">
                  <c:v>3.4566696294237578</c:v>
                </c:pt>
                <c:pt idx="99">
                  <c:v>2.7744439689249649</c:v>
                </c:pt>
                <c:pt idx="100">
                  <c:v>3.441538038702161</c:v>
                </c:pt>
                <c:pt idx="101">
                  <c:v>0</c:v>
                </c:pt>
                <c:pt idx="102">
                  <c:v>1.9910044403307552</c:v>
                </c:pt>
                <c:pt idx="103">
                  <c:v>0</c:v>
                </c:pt>
                <c:pt idx="104">
                  <c:v>2.111262513659065</c:v>
                </c:pt>
                <c:pt idx="105">
                  <c:v>0</c:v>
                </c:pt>
                <c:pt idx="106">
                  <c:v>3.3016809492935764</c:v>
                </c:pt>
                <c:pt idx="107">
                  <c:v>3.185542154854375</c:v>
                </c:pt>
                <c:pt idx="108">
                  <c:v>2.8846821042060249</c:v>
                </c:pt>
                <c:pt idx="109">
                  <c:v>3.6229389692114902</c:v>
                </c:pt>
                <c:pt idx="110">
                  <c:v>3.683407299132095</c:v>
                </c:pt>
                <c:pt idx="111">
                  <c:v>3.7231271587956916</c:v>
                </c:pt>
                <c:pt idx="112">
                  <c:v>3.5215303412787109</c:v>
                </c:pt>
                <c:pt idx="113">
                  <c:v>2.4245549766067134</c:v>
                </c:pt>
                <c:pt idx="114">
                  <c:v>2.2304489213782741</c:v>
                </c:pt>
                <c:pt idx="115">
                  <c:v>3.5476516583599693</c:v>
                </c:pt>
                <c:pt idx="116">
                  <c:v>2.2309595557485689</c:v>
                </c:pt>
                <c:pt idx="117">
                  <c:v>0</c:v>
                </c:pt>
                <c:pt idx="118">
                  <c:v>3.4271614029259654</c:v>
                </c:pt>
                <c:pt idx="119">
                  <c:v>3.6757783416740852</c:v>
                </c:pt>
                <c:pt idx="120">
                  <c:v>3.0979510709941498</c:v>
                </c:pt>
                <c:pt idx="121">
                  <c:v>0</c:v>
                </c:pt>
                <c:pt idx="122">
                  <c:v>3.8356905714924254</c:v>
                </c:pt>
                <c:pt idx="123">
                  <c:v>0</c:v>
                </c:pt>
                <c:pt idx="124">
                  <c:v>1.7115541682501696</c:v>
                </c:pt>
                <c:pt idx="125">
                  <c:v>3.5293019977879805</c:v>
                </c:pt>
                <c:pt idx="126">
                  <c:v>2.6850247851057141</c:v>
                </c:pt>
                <c:pt idx="127">
                  <c:v>3.9427519204298136</c:v>
                </c:pt>
                <c:pt idx="128">
                  <c:v>3.0644579892269186</c:v>
                </c:pt>
                <c:pt idx="129">
                  <c:v>3.7959494989028033</c:v>
                </c:pt>
                <c:pt idx="130">
                  <c:v>1.7282725978950171</c:v>
                </c:pt>
                <c:pt idx="131">
                  <c:v>2.6173149332982937</c:v>
                </c:pt>
                <c:pt idx="132">
                  <c:v>2.8570911546735136</c:v>
                </c:pt>
                <c:pt idx="133">
                  <c:v>3.2973227142053028</c:v>
                </c:pt>
                <c:pt idx="134">
                  <c:v>3.6605809124272994</c:v>
                </c:pt>
                <c:pt idx="135">
                  <c:v>0</c:v>
                </c:pt>
                <c:pt idx="136">
                  <c:v>2.896415976473123</c:v>
                </c:pt>
                <c:pt idx="137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744-5F4C-B172-A7E5FBA363AD}"/>
            </c:ext>
          </c:extLst>
        </c:ser>
        <c:ser>
          <c:idx val="1"/>
          <c:order val="1"/>
          <c:tx>
            <c:v>WHO 3-4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5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xVal>
            <c:numRef>
              <c:f>'[Corrected DSS data OJ IFNL.xlsx]Scatter plot DfSO WHO IFNL2'!$E$8:$E$106</c:f>
              <c:numCache>
                <c:formatCode>General</c:formatCode>
                <c:ptCount val="99"/>
                <c:pt idx="0">
                  <c:v>3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6</c:v>
                </c:pt>
                <c:pt idx="5">
                  <c:v>1</c:v>
                </c:pt>
                <c:pt idx="6">
                  <c:v>2</c:v>
                </c:pt>
                <c:pt idx="7">
                  <c:v>2</c:v>
                </c:pt>
                <c:pt idx="8">
                  <c:v>3</c:v>
                </c:pt>
                <c:pt idx="9">
                  <c:v>3</c:v>
                </c:pt>
                <c:pt idx="10">
                  <c:v>4</c:v>
                </c:pt>
                <c:pt idx="11">
                  <c:v>4</c:v>
                </c:pt>
                <c:pt idx="12">
                  <c:v>7</c:v>
                </c:pt>
                <c:pt idx="13">
                  <c:v>6</c:v>
                </c:pt>
                <c:pt idx="14">
                  <c:v>6</c:v>
                </c:pt>
                <c:pt idx="15">
                  <c:v>10</c:v>
                </c:pt>
                <c:pt idx="16">
                  <c:v>10</c:v>
                </c:pt>
                <c:pt idx="17">
                  <c:v>12</c:v>
                </c:pt>
                <c:pt idx="18">
                  <c:v>10</c:v>
                </c:pt>
                <c:pt idx="19">
                  <c:v>12</c:v>
                </c:pt>
                <c:pt idx="20">
                  <c:v>12</c:v>
                </c:pt>
                <c:pt idx="21">
                  <c:v>8</c:v>
                </c:pt>
                <c:pt idx="22">
                  <c:v>9</c:v>
                </c:pt>
                <c:pt idx="23">
                  <c:v>10</c:v>
                </c:pt>
                <c:pt idx="24">
                  <c:v>10</c:v>
                </c:pt>
                <c:pt idx="25">
                  <c:v>10</c:v>
                </c:pt>
                <c:pt idx="26">
                  <c:v>12</c:v>
                </c:pt>
                <c:pt idx="27">
                  <c:v>12</c:v>
                </c:pt>
                <c:pt idx="28">
                  <c:v>13</c:v>
                </c:pt>
                <c:pt idx="29">
                  <c:v>10</c:v>
                </c:pt>
                <c:pt idx="30">
                  <c:v>13</c:v>
                </c:pt>
                <c:pt idx="31">
                  <c:v>13</c:v>
                </c:pt>
                <c:pt idx="32">
                  <c:v>17</c:v>
                </c:pt>
                <c:pt idx="33">
                  <c:v>15</c:v>
                </c:pt>
                <c:pt idx="34">
                  <c:v>19</c:v>
                </c:pt>
                <c:pt idx="35">
                  <c:v>16</c:v>
                </c:pt>
                <c:pt idx="36">
                  <c:v>15</c:v>
                </c:pt>
                <c:pt idx="37">
                  <c:v>18</c:v>
                </c:pt>
                <c:pt idx="38">
                  <c:v>21</c:v>
                </c:pt>
                <c:pt idx="39">
                  <c:v>24</c:v>
                </c:pt>
                <c:pt idx="40">
                  <c:v>28</c:v>
                </c:pt>
                <c:pt idx="41">
                  <c:v>25</c:v>
                </c:pt>
                <c:pt idx="42">
                  <c:v>28</c:v>
                </c:pt>
                <c:pt idx="43">
                  <c:v>33</c:v>
                </c:pt>
                <c:pt idx="44">
                  <c:v>36</c:v>
                </c:pt>
                <c:pt idx="45">
                  <c:v>39</c:v>
                </c:pt>
                <c:pt idx="46">
                  <c:v>41</c:v>
                </c:pt>
                <c:pt idx="47">
                  <c:v>49</c:v>
                </c:pt>
                <c:pt idx="48">
                  <c:v>55</c:v>
                </c:pt>
                <c:pt idx="49">
                  <c:v>57</c:v>
                </c:pt>
                <c:pt idx="50">
                  <c:v>39</c:v>
                </c:pt>
                <c:pt idx="51">
                  <c:v>40</c:v>
                </c:pt>
                <c:pt idx="52">
                  <c:v>50</c:v>
                </c:pt>
                <c:pt idx="53">
                  <c:v>54</c:v>
                </c:pt>
                <c:pt idx="54">
                  <c:v>31</c:v>
                </c:pt>
                <c:pt idx="55">
                  <c:v>58</c:v>
                </c:pt>
                <c:pt idx="56">
                  <c:v>103</c:v>
                </c:pt>
                <c:pt idx="57">
                  <c:v>112</c:v>
                </c:pt>
                <c:pt idx="58">
                  <c:v>114</c:v>
                </c:pt>
                <c:pt idx="59">
                  <c:v>114</c:v>
                </c:pt>
                <c:pt idx="60">
                  <c:v>121</c:v>
                </c:pt>
                <c:pt idx="61">
                  <c:v>109</c:v>
                </c:pt>
                <c:pt idx="62">
                  <c:v>123</c:v>
                </c:pt>
                <c:pt idx="63">
                  <c:v>123</c:v>
                </c:pt>
                <c:pt idx="64">
                  <c:v>123</c:v>
                </c:pt>
                <c:pt idx="65">
                  <c:v>123</c:v>
                </c:pt>
                <c:pt idx="66">
                  <c:v>115</c:v>
                </c:pt>
                <c:pt idx="67">
                  <c:v>127</c:v>
                </c:pt>
                <c:pt idx="68">
                  <c:v>128</c:v>
                </c:pt>
                <c:pt idx="69">
                  <c:v>128</c:v>
                </c:pt>
                <c:pt idx="70">
                  <c:v>132</c:v>
                </c:pt>
                <c:pt idx="71">
                  <c:v>118</c:v>
                </c:pt>
                <c:pt idx="72">
                  <c:v>145</c:v>
                </c:pt>
                <c:pt idx="73">
                  <c:v>150</c:v>
                </c:pt>
                <c:pt idx="74">
                  <c:v>155</c:v>
                </c:pt>
                <c:pt idx="75">
                  <c:v>194</c:v>
                </c:pt>
                <c:pt idx="76">
                  <c:v>236</c:v>
                </c:pt>
                <c:pt idx="77">
                  <c:v>69</c:v>
                </c:pt>
                <c:pt idx="78">
                  <c:v>69</c:v>
                </c:pt>
                <c:pt idx="79">
                  <c:v>85</c:v>
                </c:pt>
                <c:pt idx="80">
                  <c:v>87</c:v>
                </c:pt>
                <c:pt idx="81">
                  <c:v>89</c:v>
                </c:pt>
                <c:pt idx="82">
                  <c:v>94</c:v>
                </c:pt>
                <c:pt idx="83">
                  <c:v>94</c:v>
                </c:pt>
                <c:pt idx="84">
                  <c:v>96</c:v>
                </c:pt>
                <c:pt idx="85">
                  <c:v>107</c:v>
                </c:pt>
                <c:pt idx="86">
                  <c:v>107</c:v>
                </c:pt>
                <c:pt idx="87">
                  <c:v>108</c:v>
                </c:pt>
                <c:pt idx="88">
                  <c:v>108</c:v>
                </c:pt>
                <c:pt idx="89">
                  <c:v>113</c:v>
                </c:pt>
                <c:pt idx="90">
                  <c:v>117</c:v>
                </c:pt>
                <c:pt idx="91">
                  <c:v>115</c:v>
                </c:pt>
                <c:pt idx="92">
                  <c:v>117</c:v>
                </c:pt>
                <c:pt idx="93">
                  <c:v>119</c:v>
                </c:pt>
                <c:pt idx="94">
                  <c:v>126</c:v>
                </c:pt>
                <c:pt idx="95">
                  <c:v>174</c:v>
                </c:pt>
                <c:pt idx="96">
                  <c:v>205</c:v>
                </c:pt>
                <c:pt idx="97">
                  <c:v>129</c:v>
                </c:pt>
                <c:pt idx="98">
                  <c:v>237</c:v>
                </c:pt>
              </c:numCache>
            </c:numRef>
          </c:xVal>
          <c:yVal>
            <c:numRef>
              <c:f>'[Corrected DSS data OJ IFNL.xlsx]Scatter plot DfSO WHO IFNL2'!$G$8:$G$106</c:f>
              <c:numCache>
                <c:formatCode>General</c:formatCode>
                <c:ptCount val="99"/>
                <c:pt idx="0">
                  <c:v>0</c:v>
                </c:pt>
                <c:pt idx="1">
                  <c:v>2.926136571067449</c:v>
                </c:pt>
                <c:pt idx="2">
                  <c:v>2.7168377232995247</c:v>
                </c:pt>
                <c:pt idx="3">
                  <c:v>0</c:v>
                </c:pt>
                <c:pt idx="4">
                  <c:v>0</c:v>
                </c:pt>
                <c:pt idx="5">
                  <c:v>1.6968803716827623</c:v>
                </c:pt>
                <c:pt idx="6">
                  <c:v>2.7044079273868409</c:v>
                </c:pt>
                <c:pt idx="7">
                  <c:v>0</c:v>
                </c:pt>
                <c:pt idx="8">
                  <c:v>0</c:v>
                </c:pt>
                <c:pt idx="9">
                  <c:v>2.5991185650553628</c:v>
                </c:pt>
                <c:pt idx="10">
                  <c:v>0</c:v>
                </c:pt>
                <c:pt idx="11">
                  <c:v>3.3418300569205104</c:v>
                </c:pt>
                <c:pt idx="12">
                  <c:v>2.9960298284110767</c:v>
                </c:pt>
                <c:pt idx="13">
                  <c:v>3.3228392726863212</c:v>
                </c:pt>
                <c:pt idx="14">
                  <c:v>1.3836358683618797</c:v>
                </c:pt>
                <c:pt idx="15">
                  <c:v>1.7935110057928578</c:v>
                </c:pt>
                <c:pt idx="16">
                  <c:v>3.9046614579155245</c:v>
                </c:pt>
                <c:pt idx="17">
                  <c:v>1.7042363373087877</c:v>
                </c:pt>
                <c:pt idx="18">
                  <c:v>0</c:v>
                </c:pt>
                <c:pt idx="19">
                  <c:v>2.1408221801093106</c:v>
                </c:pt>
                <c:pt idx="20">
                  <c:v>3.2068258760318495</c:v>
                </c:pt>
                <c:pt idx="21">
                  <c:v>0</c:v>
                </c:pt>
                <c:pt idx="22">
                  <c:v>2.5078558716958308</c:v>
                </c:pt>
                <c:pt idx="23">
                  <c:v>0</c:v>
                </c:pt>
                <c:pt idx="24">
                  <c:v>3.284881714655453</c:v>
                </c:pt>
                <c:pt idx="25">
                  <c:v>0</c:v>
                </c:pt>
                <c:pt idx="26">
                  <c:v>2.5361795321372251</c:v>
                </c:pt>
                <c:pt idx="27">
                  <c:v>2.2697463731307672</c:v>
                </c:pt>
                <c:pt idx="28">
                  <c:v>0</c:v>
                </c:pt>
                <c:pt idx="29">
                  <c:v>3.7722483399718536</c:v>
                </c:pt>
                <c:pt idx="30">
                  <c:v>1.735519058815171</c:v>
                </c:pt>
                <c:pt idx="31">
                  <c:v>2.6343764940883676</c:v>
                </c:pt>
                <c:pt idx="32">
                  <c:v>3.0711452904510828</c:v>
                </c:pt>
                <c:pt idx="33">
                  <c:v>2.295127085252191</c:v>
                </c:pt>
                <c:pt idx="34">
                  <c:v>2.6091673743020198</c:v>
                </c:pt>
                <c:pt idx="35">
                  <c:v>2.3036279763838898</c:v>
                </c:pt>
                <c:pt idx="36">
                  <c:v>0</c:v>
                </c:pt>
                <c:pt idx="37">
                  <c:v>2.6231458746379395</c:v>
                </c:pt>
                <c:pt idx="38">
                  <c:v>2.5158738437116792</c:v>
                </c:pt>
                <c:pt idx="39">
                  <c:v>0</c:v>
                </c:pt>
                <c:pt idx="40">
                  <c:v>2.852601969338235</c:v>
                </c:pt>
                <c:pt idx="41">
                  <c:v>2.7268901407418218</c:v>
                </c:pt>
                <c:pt idx="42">
                  <c:v>1.6184664921990803</c:v>
                </c:pt>
                <c:pt idx="43">
                  <c:v>2.8294967497201826</c:v>
                </c:pt>
                <c:pt idx="44">
                  <c:v>1.5819496583733179</c:v>
                </c:pt>
                <c:pt idx="45">
                  <c:v>2.9023836844324715</c:v>
                </c:pt>
                <c:pt idx="46">
                  <c:v>2.0561422620590522</c:v>
                </c:pt>
                <c:pt idx="47">
                  <c:v>1.2803506930460056</c:v>
                </c:pt>
                <c:pt idx="48">
                  <c:v>3.802705327074352</c:v>
                </c:pt>
                <c:pt idx="49">
                  <c:v>2.8768526476013436</c:v>
                </c:pt>
                <c:pt idx="50">
                  <c:v>2.1869563354654122</c:v>
                </c:pt>
                <c:pt idx="51">
                  <c:v>1.2723058444020865</c:v>
                </c:pt>
                <c:pt idx="52">
                  <c:v>0</c:v>
                </c:pt>
                <c:pt idx="53">
                  <c:v>2.8014037100173552</c:v>
                </c:pt>
                <c:pt idx="54">
                  <c:v>3.7305400364771191</c:v>
                </c:pt>
                <c:pt idx="55">
                  <c:v>3.3896975482063856</c:v>
                </c:pt>
                <c:pt idx="56">
                  <c:v>3.2435341018320618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3.9252605095194353</c:v>
                </c:pt>
                <c:pt idx="61">
                  <c:v>1.9223620967847901</c:v>
                </c:pt>
                <c:pt idx="62">
                  <c:v>2.3261309567107946</c:v>
                </c:pt>
                <c:pt idx="63">
                  <c:v>0</c:v>
                </c:pt>
                <c:pt idx="64">
                  <c:v>2.1568519010700111</c:v>
                </c:pt>
                <c:pt idx="65">
                  <c:v>0</c:v>
                </c:pt>
                <c:pt idx="66">
                  <c:v>0</c:v>
                </c:pt>
                <c:pt idx="67">
                  <c:v>3.7712934426290596</c:v>
                </c:pt>
                <c:pt idx="68">
                  <c:v>3.9593276459721709</c:v>
                </c:pt>
                <c:pt idx="69">
                  <c:v>2.4101020766428607</c:v>
                </c:pt>
                <c:pt idx="70">
                  <c:v>0</c:v>
                </c:pt>
                <c:pt idx="71">
                  <c:v>0</c:v>
                </c:pt>
                <c:pt idx="72">
                  <c:v>3.8167714123333463</c:v>
                </c:pt>
                <c:pt idx="73">
                  <c:v>3.0549958615291417</c:v>
                </c:pt>
                <c:pt idx="74">
                  <c:v>2.8208579894397001</c:v>
                </c:pt>
                <c:pt idx="75">
                  <c:v>3.5395778833453089</c:v>
                </c:pt>
                <c:pt idx="76">
                  <c:v>3.0674428427763805</c:v>
                </c:pt>
                <c:pt idx="77">
                  <c:v>0</c:v>
                </c:pt>
                <c:pt idx="78">
                  <c:v>2.5160062303860475</c:v>
                </c:pt>
                <c:pt idx="79">
                  <c:v>1.1684974835230326</c:v>
                </c:pt>
                <c:pt idx="80">
                  <c:v>1.9365640051352659</c:v>
                </c:pt>
                <c:pt idx="81">
                  <c:v>2.1939589780191868</c:v>
                </c:pt>
                <c:pt idx="82">
                  <c:v>3.3096301674258988</c:v>
                </c:pt>
                <c:pt idx="83">
                  <c:v>3.7511250715355837</c:v>
                </c:pt>
                <c:pt idx="84">
                  <c:v>2.0216027160282422</c:v>
                </c:pt>
                <c:pt idx="85">
                  <c:v>2.9024924211586036</c:v>
                </c:pt>
                <c:pt idx="86">
                  <c:v>0</c:v>
                </c:pt>
                <c:pt idx="87">
                  <c:v>1.9971678714458339</c:v>
                </c:pt>
                <c:pt idx="88">
                  <c:v>2.8162412999917832</c:v>
                </c:pt>
                <c:pt idx="89">
                  <c:v>2.1238516409670858</c:v>
                </c:pt>
                <c:pt idx="90">
                  <c:v>1.7964355588101746</c:v>
                </c:pt>
                <c:pt idx="91">
                  <c:v>0</c:v>
                </c:pt>
                <c:pt idx="92">
                  <c:v>1.2390490931401914</c:v>
                </c:pt>
                <c:pt idx="93">
                  <c:v>3.1176026916900841</c:v>
                </c:pt>
                <c:pt idx="94">
                  <c:v>0</c:v>
                </c:pt>
                <c:pt idx="95">
                  <c:v>2.5515719736742537</c:v>
                </c:pt>
                <c:pt idx="96">
                  <c:v>4.0618669721385627</c:v>
                </c:pt>
                <c:pt idx="97">
                  <c:v>0</c:v>
                </c:pt>
                <c:pt idx="98">
                  <c:v>3.63477945814595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744-5F4C-B172-A7E5FBA363AD}"/>
            </c:ext>
          </c:extLst>
        </c:ser>
        <c:ser>
          <c:idx val="2"/>
          <c:order val="2"/>
          <c:tx>
            <c:v>WHO 5-8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75000"/>
                </a:schemeClr>
              </a:solidFill>
              <a:ln w="9525">
                <a:solidFill>
                  <a:schemeClr val="dk1">
                    <a:tint val="75000"/>
                  </a:schemeClr>
                </a:solidFill>
              </a:ln>
              <a:effectLst/>
            </c:spPr>
          </c:marker>
          <c:xVal>
            <c:numRef>
              <c:f>'[Corrected DSS data OJ IFNL.xlsx]Scatter plot DfSO WHO IFNL2'!$H$8:$H$54</c:f>
              <c:numCache>
                <c:formatCode>General</c:formatCode>
                <c:ptCount val="47"/>
                <c:pt idx="0">
                  <c:v>0</c:v>
                </c:pt>
                <c:pt idx="1">
                  <c:v>3</c:v>
                </c:pt>
                <c:pt idx="2">
                  <c:v>4</c:v>
                </c:pt>
                <c:pt idx="3">
                  <c:v>1</c:v>
                </c:pt>
                <c:pt idx="4">
                  <c:v>2</c:v>
                </c:pt>
                <c:pt idx="5">
                  <c:v>4</c:v>
                </c:pt>
                <c:pt idx="6">
                  <c:v>7</c:v>
                </c:pt>
                <c:pt idx="7">
                  <c:v>3</c:v>
                </c:pt>
                <c:pt idx="8">
                  <c:v>6</c:v>
                </c:pt>
                <c:pt idx="9">
                  <c:v>2</c:v>
                </c:pt>
                <c:pt idx="10">
                  <c:v>3</c:v>
                </c:pt>
                <c:pt idx="11">
                  <c:v>5</c:v>
                </c:pt>
                <c:pt idx="12">
                  <c:v>5</c:v>
                </c:pt>
                <c:pt idx="13">
                  <c:v>6</c:v>
                </c:pt>
                <c:pt idx="14">
                  <c:v>5</c:v>
                </c:pt>
                <c:pt idx="15">
                  <c:v>8</c:v>
                </c:pt>
                <c:pt idx="16">
                  <c:v>8</c:v>
                </c:pt>
                <c:pt idx="17">
                  <c:v>8</c:v>
                </c:pt>
                <c:pt idx="18">
                  <c:v>13</c:v>
                </c:pt>
                <c:pt idx="19">
                  <c:v>9</c:v>
                </c:pt>
                <c:pt idx="20">
                  <c:v>13</c:v>
                </c:pt>
                <c:pt idx="21">
                  <c:v>8</c:v>
                </c:pt>
                <c:pt idx="22">
                  <c:v>8</c:v>
                </c:pt>
                <c:pt idx="23">
                  <c:v>12</c:v>
                </c:pt>
                <c:pt idx="24">
                  <c:v>17</c:v>
                </c:pt>
                <c:pt idx="25">
                  <c:v>17</c:v>
                </c:pt>
                <c:pt idx="26">
                  <c:v>20</c:v>
                </c:pt>
                <c:pt idx="27">
                  <c:v>24</c:v>
                </c:pt>
                <c:pt idx="28">
                  <c:v>26</c:v>
                </c:pt>
                <c:pt idx="29">
                  <c:v>16</c:v>
                </c:pt>
                <c:pt idx="30">
                  <c:v>37</c:v>
                </c:pt>
                <c:pt idx="31">
                  <c:v>41</c:v>
                </c:pt>
                <c:pt idx="32">
                  <c:v>31</c:v>
                </c:pt>
                <c:pt idx="33">
                  <c:v>114</c:v>
                </c:pt>
                <c:pt idx="34">
                  <c:v>120</c:v>
                </c:pt>
                <c:pt idx="35">
                  <c:v>123</c:v>
                </c:pt>
                <c:pt idx="36">
                  <c:v>124</c:v>
                </c:pt>
                <c:pt idx="37">
                  <c:v>128</c:v>
                </c:pt>
                <c:pt idx="38">
                  <c:v>131</c:v>
                </c:pt>
                <c:pt idx="39">
                  <c:v>162</c:v>
                </c:pt>
                <c:pt idx="40">
                  <c:v>216</c:v>
                </c:pt>
                <c:pt idx="41">
                  <c:v>116</c:v>
                </c:pt>
                <c:pt idx="42">
                  <c:v>117</c:v>
                </c:pt>
                <c:pt idx="43">
                  <c:v>137</c:v>
                </c:pt>
                <c:pt idx="44">
                  <c:v>192</c:v>
                </c:pt>
                <c:pt idx="45">
                  <c:v>114</c:v>
                </c:pt>
                <c:pt idx="46">
                  <c:v>216</c:v>
                </c:pt>
              </c:numCache>
            </c:numRef>
          </c:xVal>
          <c:yVal>
            <c:numRef>
              <c:f>'[Corrected DSS data OJ IFNL.xlsx]Scatter plot DfSO WHO IFNL2'!$J$8:$J$54</c:f>
              <c:numCache>
                <c:formatCode>General</c:formatCode>
                <c:ptCount val="47"/>
                <c:pt idx="0">
                  <c:v>0</c:v>
                </c:pt>
                <c:pt idx="1">
                  <c:v>2.697578033651113</c:v>
                </c:pt>
                <c:pt idx="2">
                  <c:v>3.4601458174917501</c:v>
                </c:pt>
                <c:pt idx="3">
                  <c:v>0</c:v>
                </c:pt>
                <c:pt idx="4">
                  <c:v>0</c:v>
                </c:pt>
                <c:pt idx="5">
                  <c:v>2.4679039465228003</c:v>
                </c:pt>
                <c:pt idx="6">
                  <c:v>2.500373714353374</c:v>
                </c:pt>
                <c:pt idx="7">
                  <c:v>1.2743887955503788</c:v>
                </c:pt>
                <c:pt idx="8">
                  <c:v>0</c:v>
                </c:pt>
                <c:pt idx="9">
                  <c:v>0</c:v>
                </c:pt>
                <c:pt idx="10">
                  <c:v>3.318272080211627</c:v>
                </c:pt>
                <c:pt idx="11">
                  <c:v>1.9641181431514849</c:v>
                </c:pt>
                <c:pt idx="12">
                  <c:v>0.96146855535078635</c:v>
                </c:pt>
                <c:pt idx="13">
                  <c:v>2.7502769151539925</c:v>
                </c:pt>
                <c:pt idx="14">
                  <c:v>0</c:v>
                </c:pt>
                <c:pt idx="15">
                  <c:v>0</c:v>
                </c:pt>
                <c:pt idx="16">
                  <c:v>1.89148170383952</c:v>
                </c:pt>
                <c:pt idx="17">
                  <c:v>0</c:v>
                </c:pt>
                <c:pt idx="18">
                  <c:v>0</c:v>
                </c:pt>
                <c:pt idx="19">
                  <c:v>3.2405492482825999</c:v>
                </c:pt>
                <c:pt idx="20">
                  <c:v>3.3492775274679554</c:v>
                </c:pt>
                <c:pt idx="21">
                  <c:v>3.4881274962474587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2.4449811120879446</c:v>
                </c:pt>
                <c:pt idx="26">
                  <c:v>1.2442771208018428</c:v>
                </c:pt>
                <c:pt idx="27">
                  <c:v>3.8371463439090601</c:v>
                </c:pt>
                <c:pt idx="28">
                  <c:v>1.6354837468149122</c:v>
                </c:pt>
                <c:pt idx="29">
                  <c:v>0</c:v>
                </c:pt>
                <c:pt idx="30">
                  <c:v>0</c:v>
                </c:pt>
                <c:pt idx="31">
                  <c:v>2.8041394323353503</c:v>
                </c:pt>
                <c:pt idx="32">
                  <c:v>1.7037211599270199</c:v>
                </c:pt>
                <c:pt idx="33">
                  <c:v>3.4801507252732806</c:v>
                </c:pt>
                <c:pt idx="34">
                  <c:v>0</c:v>
                </c:pt>
                <c:pt idx="35">
                  <c:v>0</c:v>
                </c:pt>
                <c:pt idx="36">
                  <c:v>3.2860071220794747</c:v>
                </c:pt>
                <c:pt idx="37">
                  <c:v>3.6135247028536526</c:v>
                </c:pt>
                <c:pt idx="38">
                  <c:v>3.7352794480604565</c:v>
                </c:pt>
                <c:pt idx="39">
                  <c:v>3.7693034601890818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3.9643539292921934</c:v>
                </c:pt>
                <c:pt idx="44">
                  <c:v>0</c:v>
                </c:pt>
                <c:pt idx="45">
                  <c:v>3.3647385550553985</c:v>
                </c:pt>
                <c:pt idx="46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744-5F4C-B172-A7E5FBA363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8345072"/>
        <c:axId val="1393464832"/>
      </c:scatterChart>
      <c:valAx>
        <c:axId val="32834507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DfSO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3464832"/>
        <c:crosses val="autoZero"/>
        <c:crossBetween val="midCat"/>
      </c:valAx>
      <c:valAx>
        <c:axId val="13934648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IFNL2</a:t>
                </a:r>
                <a:r>
                  <a:rPr lang="en-GB" baseline="0"/>
                  <a:t> log10+1</a:t>
                </a:r>
                <a:endParaRPr lang="en-GB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834507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all_IFN_levels!$B$2:$B$838</cx:f>
        <cx:lvl ptCount="837" formatCode="0.00">
          <cx:pt idx="0">1.9000939015433984</cx:pt>
          <cx:pt idx="1">2.1085650237328344</cx:pt>
          <cx:pt idx="2">1.9481683617271317</cx:pt>
          <cx:pt idx="3">3.4073909044707316</cx:pt>
          <cx:pt idx="4">2.6929350025311378</cx:pt>
          <cx:pt idx="5">1.7926717891415673</cx:pt>
          <cx:pt idx="6">2.7446058754142388</cx:pt>
          <cx:pt idx="7">1.7111320723068417</cx:pt>
          <cx:pt idx="8">2.1122697684172707</cx:pt>
          <cx:pt idx="9">1.8018837071252396</cx:pt>
          <cx:pt idx="10">1.8773137433122384</cx:pt>
          <cx:pt idx="11">1.8801273222166248</cx:pt>
          <cx:pt idx="12">1.7761925147470721</cx:pt>
          <cx:pt idx="13">1.8187535904977168</cx:pt>
          <cx:pt idx="14">1.6964437631389993</cx:pt>
          <cx:pt idx="15">2.5970366649776535</cx:pt>
          <cx:pt idx="16">2.0989896394011773</cx:pt>
          <cx:pt idx="17">1.7623784293119642</cx:pt>
          <cx:pt idx="18">4.4050217561930847</cx:pt>
          <cx:pt idx="19">2.150756439860309</cx:pt>
          <cx:pt idx="20">1.736953953783146</cx:pt>
          <cx:pt idx="21">1.7281101841003406</cx:pt>
          <cx:pt idx="22">2.1034616220947049</cx:pt>
          <cx:pt idx="23">1.7053504628857119</cx:pt>
          <cx:pt idx="24">1.8425468364950151</cx:pt>
          <cx:pt idx="25">2.2487087356009177</cx:pt>
          <cx:pt idx="26">1.6956567599361902</cx:pt>
          <cx:pt idx="27">1.8203328448994098</cx:pt>
          <cx:pt idx="28">1.7696726640554925</cx:pt>
          <cx:pt idx="29">1.716504163773217</cx:pt>
          <cx:pt idx="30">2.1917303933628562</cx:pt>
          <cx:pt idx="31">1.7405205860536648</cx:pt>
          <cx:pt idx="32">1.884342147647059</cx:pt>
          <cx:pt idx="33">1.7994783988379808</cx:pt>
          <cx:pt idx="34">1.7795964912578246</cx:pt>
          <cx:pt idx="35">1.8500332576897689</cx:pt>
          <cx:pt idx="36">1.7911290007272862</cx:pt>
          <cx:pt idx="37">1.9204364065507586</cx:pt>
          <cx:pt idx="38">2.0614524790871931</cx:pt>
          <cx:pt idx="39">1.8588979572320035</cx:pt>
          <cx:pt idx="40">0.89008552671632524</cx:pt>
          <cx:pt idx="41">1.6647359685187051</cx:pt>
          <cx:pt idx="42">1.6086329894900369</cx:pt>
          <cx:pt idx="43">1.9895388033205024</cx:pt>
          <cx:pt idx="44">0.80441205913771385</cx:pt>
          <cx:pt idx="45">0</cx:pt>
          <cx:pt idx="46">1.6698745024898025</cx:pt>
          <cx:pt idx="47">0</cx:pt>
          <cx:pt idx="48">1.8868853589860086</cx:pt>
          <cx:pt idx="49">1.8314218170650221</cx:pt>
          <cx:pt idx="50">1.2174839442139063</cx:pt>
          <cx:pt idx="51">2.4954055631461931</cx:pt>
          <cx:pt idx="52">3.0610753236297916</cx:pt>
          <cx:pt idx="53">1.8989992708897891</cx:pt>
          <cx:pt idx="54">0</cx:pt>
          <cx:pt idx="55">3.9383195433421556</cx:pt>
          <cx:pt idx="56">1.8920389203412915</cx:pt>
          <cx:pt idx="57">0</cx:pt>
          <cx:pt idx="58">3.6384892569546374</cx:pt>
          <cx:pt idx="59">2.2203696324513946</cx:pt>
          <cx:pt idx="60">2.7936507177071728</cx:pt>
          <cx:pt idx="61">1.7377490738915571</cx:pt>
          <cx:pt idx="62">1.454387467146955</cx:pt>
          <cx:pt idx="63">1.4858633295973347</cx:pt>
          <cx:pt idx="64">1.7222224639697303</cx:pt>
          <cx:pt idx="65">1.5141491344754374</cx:pt>
          <cx:pt idx="66">1.1003705451175629</cx:pt>
          <cx:pt idx="67">1.9237619608287002</cx:pt>
          <cx:pt idx="68">1.6875289612146342</cx:pt>
          <cx:pt idx="69">1.0788191830988487</cx:pt>
          <cx:pt idx="70">2.5843312243675309</cx:pt>
          <cx:pt idx="71">2.2782962080912741</cx:pt>
          <cx:pt idx="72">2.344588742578714</cx:pt>
          <cx:pt idx="73">0.68993010401821808</cx:pt>
          <cx:pt idx="74">2.1010593549081156</cx:pt>
          <cx:pt idx="75">2.6401831919213401</cx:pt>
          <cx:pt idx="76">1.4307198878632823</cx:pt>
          <cx:pt idx="77">1.7737864449811935</cx:pt>
          <cx:pt idx="78">1.697490887171057</cx:pt>
          <cx:pt idx="79">1.3769417571467586</cx:pt>
          <cx:pt idx="80">2.1992064791616577</cx:pt>
          <cx:pt idx="81">2.4693801358499252</cx:pt>
          <cx:pt idx="82">0</cx:pt>
          <cx:pt idx="83">0</cx:pt>
          <cx:pt idx="84">2.9989129043587859</cx:pt>
          <cx:pt idx="85">2.1489109931093564</cx:pt>
          <cx:pt idx="86">0</cx:pt>
          <cx:pt idx="87">0</cx:pt>
          <cx:pt idx="88">1.7633531087482155</cx:pt>
          <cx:pt idx="89">0</cx:pt>
          <cx:pt idx="90">0</cx:pt>
          <cx:pt idx="91">0</cx:pt>
          <cx:pt idx="92">1.3248994970523134</cx:pt>
          <cx:pt idx="93">0</cx:pt>
          <cx:pt idx="94">0</cx:pt>
          <cx:pt idx="95">1.9567925203704948</cx:pt>
          <cx:pt idx="96">0</cx:pt>
          <cx:pt idx="97">0</cx:pt>
          <cx:pt idx="98">2.3791241460703918</cx:pt>
          <cx:pt idx="99">0</cx:pt>
          <cx:pt idx="100">1.5958267770732231</cx:pt>
          <cx:pt idx="101">0</cx:pt>
          <cx:pt idx="102">3.249198357391113</cx:pt>
          <cx:pt idx="103">0</cx:pt>
          <cx:pt idx="104">0</cx:pt>
          <cx:pt idx="105">0</cx:pt>
          <cx:pt idx="106">0</cx:pt>
          <cx:pt idx="107">1.6774244377012475</cx:pt>
          <cx:pt idx="108">3.4463818122224419</cx:pt>
          <cx:pt idx="109">2.4857214264815801</cx:pt>
          <cx:pt idx="110">2.5543680009900878</cx:pt>
          <cx:pt idx="111">2.1228709228644354</cx:pt>
          <cx:pt idx="112">3.1445742076096161</cx:pt>
          <cx:pt idx="113">0</cx:pt>
          <cx:pt idx="114">2.9296232515152405</cx:pt>
          <cx:pt idx="115">3.445136968713304</cx:pt>
          <cx:pt idx="116">0</cx:pt>
          <cx:pt idx="117">0</cx:pt>
          <cx:pt idx="118">0</cx:pt>
          <cx:pt idx="119">0</cx:pt>
          <cx:pt idx="120">1.2648178230095364</cx:pt>
          <cx:pt idx="121">1.3338501451025451</cx:pt>
          <cx:pt idx="122">1.8155113373627643</cx:pt>
          <cx:pt idx="123">1.4141373621844766</cx:pt>
          <cx:pt idx="124">2.2855573090077739</cx:pt>
          <cx:pt idx="125">2.4999618655961902</cx:pt>
          <cx:pt idx="126">1.2276296495710086</cx:pt>
          <cx:pt idx="127">2.6201360549737576</cx:pt>
          <cx:pt idx="128">1.3675422735205767</cx:pt>
          <cx:pt idx="129">1.2681097298084782</cx:pt>
          <cx:pt idx="130">2.1325798476597368</cx:pt>
          <cx:pt idx="131">1.1392492175716069</cx:pt>
          <cx:pt idx="132">1.4468477101558088</cx:pt>
          <cx:pt idx="133">1.3602146132953523</cx:pt>
          <cx:pt idx="134">1.2319790268315043</cx:pt>
          <cx:pt idx="135">3.0149403497929366</cx:pt>
          <cx:pt idx="136">1.4687902620996109</cx:pt>
          <cx:pt idx="137">2.4616485680634552</cx:pt>
          <cx:pt idx="138">1.7003575278226599</cx:pt>
          <cx:pt idx="139">3.0842186867392387</cx:pt>
          <cx:pt idx="140">1.4712917110589385</cx:pt>
          <cx:pt idx="141">2.0102999566398121</cx:pt>
          <cx:pt idx="142">2.3123889493705918</cx:pt>
          <cx:pt idx="143">1.7545012293869171</cx:pt>
          <cx:pt idx="144">2.5474054596674898</cx:pt>
          <cx:pt idx="145">2.669967369908504</cx:pt>
          <cx:pt idx="146">3.6298171960185157</cx:pt>
          <cx:pt idx="147">2.0195316845312554</cx:pt>
          <cx:pt idx="148">1.2992893340876799</cx:pt>
          <cx:pt idx="149">1.2586372827240764</cx:pt>
          <cx:pt idx="150">2.6080979463252798</cx:pt>
          <cx:pt idx="151">1.7571681922142726</cx:pt>
          <cx:pt idx="152">2.060320028688285</cx:pt>
          <cx:pt idx="153">2.0622058088197126</cx:pt>
          <cx:pt idx="154">2.5518158223510157</cx:pt>
          <cx:pt idx="155">1.6534054906645013</cx:pt>
          <cx:pt idx="156">1.4888326343824005</cx:pt>
          <cx:pt idx="157">1.9837615602861649</cx:pt>
          <cx:pt idx="158">1.5395778833453091</cx:pt>
          <cx:pt idx="159">1.5630061870617937</cx:pt>
          <cx:pt idx="160">2.8568496787251725</cx:pt>
          <cx:pt idx="161">0</cx:pt>
          <cx:pt idx="162">3.2024883170600935</cx:pt>
          <cx:pt idx="163">1.3081373786380386</cx:pt>
          <cx:pt idx="164">0</cx:pt>
          <cx:pt idx="165">2.0923696996291206</cx:pt>
          <cx:pt idx="166">0</cx:pt>
          <cx:pt idx="167">3.5481436374348454</cx:pt>
          <cx:pt idx="168">0</cx:pt>
          <cx:pt idx="169">0</cx:pt>
          <cx:pt idx="170">0</cx:pt>
          <cx:pt idx="171">0</cx:pt>
          <cx:pt idx="172">0</cx:pt>
          <cx:pt idx="173">0</cx:pt>
          <cx:pt idx="174">0</cx:pt>
          <cx:pt idx="175">0</cx:pt>
          <cx:pt idx="176">0</cx:pt>
          <cx:pt idx="177">0</cx:pt>
          <cx:pt idx="178">0</cx:pt>
          <cx:pt idx="179">0</cx:pt>
          <cx:pt idx="180">0</cx:pt>
          <cx:pt idx="181">0</cx:pt>
          <cx:pt idx="182">0</cx:pt>
          <cx:pt idx="183">0</cx:pt>
          <cx:pt idx="184">0</cx:pt>
          <cx:pt idx="185">0</cx:pt>
          <cx:pt idx="186">0</cx:pt>
          <cx:pt idx="187">0</cx:pt>
          <cx:pt idx="188">0</cx:pt>
          <cx:pt idx="189">0</cx:pt>
          <cx:pt idx="190">0</cx:pt>
          <cx:pt idx="191">0</cx:pt>
          <cx:pt idx="192">2.1078880251827985</cx:pt>
          <cx:pt idx="193">0</cx:pt>
          <cx:pt idx="194">0</cx:pt>
          <cx:pt idx="195">2.3958503760187813</cx:pt>
          <cx:pt idx="196">1.6185710281201298</cx:pt>
          <cx:pt idx="197">1.9059576990924272</cx:pt>
          <cx:pt idx="198">0</cx:pt>
          <cx:pt idx="199">1.8212514315459412</cx:pt>
          <cx:pt idx="200">1.6178387477170033</cx:pt>
          <cx:pt idx="201">1.8606374167737547</cx:pt>
          <cx:pt idx="202">2.012837224705172</cx:pt>
          <cx:pt idx="203">0</cx:pt>
          <cx:pt idx="204">0</cx:pt>
          <cx:pt idx="205">0</cx:pt>
          <cx:pt idx="206">1.9769915453061506</cx:pt>
          <cx:pt idx="207">1.3782161497498779</cx:pt>
          <cx:pt idx="208">2.5027001753105629</cx:pt>
          <cx:pt idx="209">2.7859701251320095</cx:pt>
          <cx:pt idx="210">1.4785664955938433</cx:pt>
          <cx:pt idx="211">0</cx:pt>
          <cx:pt idx="213">1.4516329474569909</cx:pt>
          <cx:pt idx="214">1.9785000693114592</cx:pt>
          <cx:pt idx="215">0</cx:pt>
          <cx:pt idx="216">1.6785183790401139</cx:pt>
          <cx:pt idx="217">1.8804133998779167</cx:pt>
          <cx:pt idx="218">0</cx:pt>
          <cx:pt idx="219">1.9978667262391447</cx:pt>
          <cx:pt idx="220">2.04883008652835</cx:pt>
          <cx:pt idx="221">1.7508939203821254</cx:pt>
          <cx:pt idx="222">1.3562171342197351</cx:pt>
          <cx:pt idx="223">2.3780343224573315</cx:pt>
          <cx:pt idx="224">2.0338256939533101</cx:pt>
          <cx:pt idx="225">2.6863681034730362</cx:pt>
          <cx:pt idx="226">2.2464985807958011</cx:pt>
          <cx:pt idx="227">1.9406160823374077</cx:pt>
          <cx:pt idx="228">1.8323172699222616</cx:pt>
          <cx:pt idx="231">2.6627578316815739</cx:pt>
          <cx:pt idx="232">1.02840856511547</cx:pt>
          <cx:pt idx="233">1.1000257301078626</cx:pt>
          <cx:pt idx="235">0.73351825143448757</cx:pt>
          <cx:pt idx="236">1.7823292689968369</cx:pt>
          <cx:pt idx="237">1.6458151182966418</cx:pt>
          <cx:pt idx="239">1.6297153326471323</cx:pt>
          <cx:pt idx="240">2.2511513431753545</cx:pt>
          <cx:pt idx="241">1.7606486195813562</cx:pt>
          <cx:pt idx="242">1.2076343673889616</cx:pt>
          <cx:pt idx="243">2.0542299098633974</cx:pt>
          <cx:pt idx="244">2.5358002908248976</cx:pt>
          <cx:pt idx="245">1.0425755124401905</cx:pt>
          <cx:pt idx="246">1.8634418286137087</cx:pt>
          <cx:pt idx="247">2.4452927694259716</cx:pt>
          <cx:pt idx="248">1.1132746924643504</cx:pt>
          <cx:pt idx="249">2.8244512700366129</cx:pt>
          <cx:pt idx="250">2.1055101847699738</cx:pt>
          <cx:pt idx="251">0.85454893581295077</cx:pt>
          <cx:pt idx="252">1.2019430634016501</cx:pt>
          <cx:pt idx="253">1.9853366417356129</cx:pt>
          <cx:pt idx="254">0</cx:pt>
          <cx:pt idx="255">1.3298045221640695</cx:pt>
          <cx:pt idx="256">1.2255677134394711</cx:pt>
          <cx:pt idx="257">2.6907275438703668</cx:pt>
          <cx:pt idx="258">1.3269499941659988</cx:pt>
          <cx:pt idx="259">3.1408221801093106</cx:pt>
          <cx:pt idx="260">1.0112320103193659</cx:pt>
          <cx:pt idx="261">1.5524248457040855</cx:pt>
          <cx:pt idx="262">2.6853834098014873</cx:pt>
          <cx:pt idx="263">0</cx:pt>
          <cx:pt idx="264">1.3669829759778509</cx:pt>
          <cx:pt idx="265">2.0817072700973491</cx:pt>
          <cx:pt idx="266">1.0468851908377101</cx:pt>
          <cx:pt idx="267">1.4462264017781632</cx:pt>
          <cx:pt idx="268">1.8825814535544512</cx:pt>
          <cx:pt idx="269">1.1682027468426308</cx:pt>
          <cx:pt idx="270">3.3877456596088638</cx:pt>
          <cx:pt idx="271">1.8759867714284879</cx:pt>
          <cx:pt idx="272">1.9614685553507865</cx:pt>
          <cx:pt idx="273">1.7699678013294424</cx:pt>
          <cx:pt idx="274">0</cx:pt>
          <cx:pt idx="275">1.2690457096576229</cx:pt>
          <cx:pt idx="276">1.7949757440511316</cx:pt>
          <cx:pt idx="277">2.4379090355394983</cx:pt>
          <cx:pt idx="278">2.1889284837608534</cx:pt>
          <cx:pt idx="279">2.4644895474339714</cx:pt>
          <cx:pt idx="280">2.5071809772602407</cx:pt>
          <cx:pt idx="281">0</cx:pt>
          <cx:pt idx="282">0</cx:pt>
          <cx:pt idx="283">0</cx:pt>
          <cx:pt idx="284">1.8502785525180372</cx:pt>
          <cx:pt idx="285">3.3055663135153042</cx:pt>
          <cx:pt idx="286">0</cx:pt>
          <cx:pt idx="287">0</cx:pt>
          <cx:pt idx="288">0</cx:pt>
          <cx:pt idx="289">0</cx:pt>
          <cx:pt idx="290">0</cx:pt>
          <cx:pt idx="291">0</cx:pt>
          <cx:pt idx="292">0</cx:pt>
          <cx:pt idx="293">0</cx:pt>
          <cx:pt idx="294">0</cx:pt>
          <cx:pt idx="295">0</cx:pt>
          <cx:pt idx="296">0</cx:pt>
          <cx:pt idx="297">0</cx:pt>
          <cx:pt idx="298">0</cx:pt>
          <cx:pt idx="299">2.2889196056617265</cx:pt>
          <cx:pt idx="300">0</cx:pt>
          <cx:pt idx="301">3.7488854400095168</cx:pt>
          <cx:pt idx="302">0</cx:pt>
          <cx:pt idx="303">0</cx:pt>
          <cx:pt idx="304">0</cx:pt>
          <cx:pt idx="305">0</cx:pt>
          <cx:pt idx="306">0</cx:pt>
          <cx:pt idx="307">0</cx:pt>
          <cx:pt idx="308">0</cx:pt>
          <cx:pt idx="309">0</cx:pt>
          <cx:pt idx="310">2.2853322276438846</cx:pt>
          <cx:pt idx="311">2.9356583861006342</cx:pt>
          <cx:pt idx="312">0</cx:pt>
          <cx:pt idx="313">0</cx:pt>
          <cx:pt idx="314">0</cx:pt>
          <cx:pt idx="315">0</cx:pt>
          <cx:pt idx="316">0</cx:pt>
          <cx:pt idx="317">0</cx:pt>
          <cx:pt idx="318">0</cx:pt>
          <cx:pt idx="319">0</cx:pt>
          <cx:pt idx="320">0</cx:pt>
          <cx:pt idx="321">0</cx:pt>
          <cx:pt idx="322">0</cx:pt>
          <cx:pt idx="323">0.58240429801902815</cx:pt>
          <cx:pt idx="325">0.97451169273732841</cx:pt>
          <cx:pt idx="326">0</cx:pt>
          <cx:pt idx="327">3.5700757053216043</cx:pt>
          <cx:pt idx="328">0.028697293660688322</cx:pt>
          <cx:pt idx="329">1.8016780590358932</cx:pt>
          <cx:pt idx="330">2.1652443261253107</cx:pt>
          <cx:pt idx="331">2.0913151596972228</cx:pt>
          <cx:pt idx="332">2.2846562827885157</cx:pt>
          <cx:pt idx="333">1.8555191556678001</cx:pt>
          <cx:pt idx="334">2.8676442339030985</cx:pt>
          <cx:pt idx="335">0</cx:pt>
          <cx:pt idx="336">0.81150797994532664</cx:pt>
          <cx:pt idx="337">2.4643404846276673</cx:pt>
          <cx:pt idx="338">0</cx:pt>
          <cx:pt idx="339">1.5376931943673908</cx:pt>
          <cx:pt idx="340">1.04883008652835</cx:pt>
          <cx:pt idx="341">0</cx:pt>
          <cx:pt idx="342">1.2113875529368587</cx:pt>
          <cx:pt idx="343">1.5137501500818236</cx:pt>
          <cx:pt idx="344">1.5994463757252757</cx:pt>
          <cx:pt idx="345">2.1179338350396413</cx:pt>
          <cx:pt idx="346">1.2087100199064011</cx:pt>
          <cx:pt idx="347">0</cx:pt>
          <cx:pt idx="348">0</cx:pt>
          <cx:pt idx="349">1.4875625602563782</cx:pt>
          <cx:pt idx="350">0.99943504987632981</cx:pt>
          <cx:pt idx="351">0</cx:pt>
          <cx:pt idx="352">1.085290578230065</cx:pt>
          <cx:pt idx="353">0</cx:pt>
          <cx:pt idx="354">0</cx:pt>
          <cx:pt idx="355">1.2755416884013095</cx:pt>
          <cx:pt idx="356">0</cx:pt>
          <cx:pt idx="357">0</cx:pt>
          <cx:pt idx="358">0</cx:pt>
          <cx:pt idx="359">2.0515383905153275</cx:pt>
          <cx:pt idx="360">3.0425755124401905</cx:pt>
          <cx:pt idx="361">0</cx:pt>
          <cx:pt idx="362">1.5125509929042107</cx:pt>
          <cx:pt idx="364">1.3005954838899636</cx:pt>
          <cx:pt idx="365">0</cx:pt>
          <cx:pt idx="366">1.0208996728625364</cx:pt>
          <cx:pt idx="367">0</cx:pt>
          <cx:pt idx="368">2.0622058088197126</cx:pt>
          <cx:pt idx="369">1.2676409823459156</cx:pt>
          <cx:pt idx="370">0.76514679010802533</cx:pt>
          <cx:pt idx="371">0</cx:pt>
          <cx:pt idx="372">1.4962375451667353</cx:pt>
          <cx:pt idx="373">2.0530784434834195</cx:pt>
          <cx:pt idx="374">1.5954962218255742</cx:pt>
          <cx:pt idx="375">0</cx:pt>
          <cx:pt idx="376">1.7237018939912678</cx:pt>
          <cx:pt idx="377">0</cx:pt>
          <cx:pt idx="378">2.7149162479935849</cx:pt>
          <cx:pt idx="379">3.0576661039098294</cx:pt>
          <cx:pt idx="380">0</cx:pt>
          <cx:pt idx="381">0</cx:pt>
          <cx:pt idx="382">0</cx:pt>
          <cx:pt idx="383">1.7172543127625497</cx:pt>
          <cx:pt idx="384">0</cx:pt>
          <cx:pt idx="385">0</cx:pt>
          <cx:pt idx="386">1.6623800200162475</cx:pt>
          <cx:pt idx="387">0</cx:pt>
          <cx:pt idx="388">0</cx:pt>
          <cx:pt idx="389">1.6594407818703176</cx:pt>
          <cx:pt idx="390">0</cx:pt>
          <cx:pt idx="391">1.8380931384455983</cx:pt>
          <cx:pt idx="392">1.6760531246518715</cx:pt>
          <cx:pt idx="393">0</cx:pt>
          <cx:pt idx="394">0</cx:pt>
          <cx:pt idx="395">2.2789821168654432</cx:pt>
          <cx:pt idx="396">0</cx:pt>
          <cx:pt idx="397">0</cx:pt>
        </cx:lvl>
      </cx:numDim>
    </cx:data>
    <cx:data id="1">
      <cx:numDim type="val">
        <cx:f>all_IFN_levels!$C$2:$C$838</cx:f>
        <cx:lvl ptCount="837" formatCode="0.00">
          <cx:pt idx="0">1.7037211599270199</cx:pt>
          <cx:pt idx="1">2.9088065994056742</cx:pt>
          <cx:pt idx="2">1.3836358683618797</cx:pt>
          <cx:pt idx="3">1.2271150825891251</cx:pt>
          <cx:pt idx="4">3.3228392726863212</cx:pt>
          <cx:pt idx="5">2.3036279763838898</cx:pt>
          <cx:pt idx="6">3.4171394097273255</cx:pt>
          <cx:pt idx="7">1.36679638328673</cx:pt>
          <cx:pt idx="8">1.7042363373087877</cx:pt>
          <cx:pt idx="9">1.2442771208018428</cx:pt>
          <cx:pt idx="10">1.6184664921990803</cx:pt>
          <cx:pt idx="11">2.9613736275948011</cx:pt>
          <cx:pt idx="12">1.2743887955503788</cx:pt>
          <cx:pt idx="13">3.6725596277632757</cx:pt>
          <cx:pt idx="14">2.1737688231366499</cx:pt>
          <cx:pt idx="15">2.7268901407418218</cx:pt>
          <cx:pt idx="16">1.7935110057928578</cx:pt>
          <cx:pt idx="17">2.9960298284110767</cx:pt>
          <cx:pt idx="18">3.9046614579155245</cx:pt>
          <cx:pt idx="19">2.7693773260761385</cx:pt>
          <cx:pt idx="20">2.469674772551798</cx:pt>
          <cx:pt idx="21">4.0577041315340301</cx:pt>
          <cx:pt idx="22">1.2803506930460056</cx:pt>
          <cx:pt idx="23">2.8041394323353503</cx:pt>
          <cx:pt idx="24">2.1408221801093106</cx:pt>
          <cx:pt idx="25">3.2559957267224018</cx:pt>
          <cx:pt idx="26">1.7139103541289553</cx:pt>
          <cx:pt idx="27">2.295127085252191</cx:pt>
          <cx:pt idx="28">2.1869563354654122</cx:pt>
          <cx:pt idx="29">2.6171052305023781</cx:pt>
          <cx:pt idx="30">3.7305400364771191</cx:pt>
          <cx:pt idx="31">1.735519058815171</cx:pt>
          <cx:pt idx="32">2.6425634371043878</cx:pt>
          <cx:pt idx="33">1.3664229572259727</cx:pt>
          <cx:pt idx="34">2.5158738437116792</cx:pt>
          <cx:pt idx="35">1.5819496583733179</cx:pt>
          <cx:pt idx="36">1.2615007731982801</cx:pt>
          <cx:pt idx="37">3.7301360039966776</cx:pt>
          <cx:pt idx="38">2.852601969338235</cx:pt>
          <cx:pt idx="39">1.2723058444020865</cx:pt>
          <cx:pt idx="40">1.9518230353159121</cx:pt>
          <cx:pt idx="41">1.9641181431514849</cx:pt>
          <cx:pt idx="42">1.8845121591903939</cx:pt>
          <cx:pt idx="43">2.7965049515532963</cx:pt>
          <cx:pt idx="44">3.2960066693136723</cx:pt>
          <cx:pt idx="45">1.6354837468149122</cx:pt>
          <cx:pt idx="46">3.5742628297070267</cx:pt>
          <cx:pt idx="47">0.75358305889290655</cx:pt>
          <cx:pt idx="48">0.79211140908716837</cx:pt>
          <cx:pt idx="49">3.2683439139510648</cx:pt>
          <cx:pt idx="50">2.4878451201114355</cx:pt>
          <cx:pt idx="51">3.2229764498933915</cx:pt>
          <cx:pt idx="52">3.4860051863622421</cx:pt>
          <cx:pt idx="53">2.0561422620590522</cx:pt>
          <cx:pt idx="54">2.6329631681672612</cx:pt>
          <cx:pt idx="55">3.8107028609471167</cx:pt>
          <cx:pt idx="56">2.3651134316275773</cx:pt>
          <cx:pt idx="57">1.6668922110665363</cx:pt>
          <cx:pt idx="58">3.3756636139608855</cx:pt>
          <cx:pt idx="59">2.1031192535457137</cx:pt>
          <cx:pt idx="60">1.2607866686549762</cx:pt>
          <cx:pt idx="61">0.085825533520743083</cx:pt>
          <cx:pt idx="62">1.5403294747908738</cx:pt>
          <cx:pt idx="63">3.2405492482825999</cx:pt>
          <cx:pt idx="64">3.2557547866430441</cx:pt>
          <cx:pt idx="65">3.7206553565517244</cx:pt>
          <cx:pt idx="66">1.7245216271185626</cx:pt>
          <cx:pt idx="67">0</cx:pt>
          <cx:pt idx="68">0</cx:pt>
          <cx:pt idx="69">0</cx:pt>
          <cx:pt idx="70">2.8768526476013436</cx:pt>
          <cx:pt idx="71">3.7939998009844706</cx:pt>
          <cx:pt idx="72">3.185542154854375</cx:pt>
          <cx:pt idx="73">1.8036619232362243</cx:pt>
          <cx:pt idx="74">3.5169318088680126</cx:pt>
          <cx:pt idx="75">3.8771985152717896</cx:pt>
          <cx:pt idx="76">2.2304489213782741</cx:pt>
          <cx:pt idx="77">3.5215303412787109</cx:pt>
          <cx:pt idx="78">1.9607085516885565</cx:pt>
          <cx:pt idx="79">3.0762762554042178</cx:pt>
          <cx:pt idx="80">3.4271614029259654</cx:pt>
          <cx:pt idx="81">0</cx:pt>
          <cx:pt idx="82">3.5830853663476878</cx:pt>
          <cx:pt idx="83">2.4245549766067134</cx:pt>
          <cx:pt idx="84">3.9576551669434914</cx:pt>
          <cx:pt idx="85">3.4906606533561368</cx:pt>
          <cx:pt idx="86">3.7627535649333739</cx:pt>
          <cx:pt idx="87">3.5851221863068155</cx:pt>
          <cx:pt idx="88">2.6353832040474985</cx:pt>
          <cx:pt idx="89">0</cx:pt>
          <cx:pt idx="90">0</cx:pt>
          <cx:pt idx="91">0</cx:pt>
          <cx:pt idx="92">2.8846821042060249</cx:pt>
          <cx:pt idx="93">0</cx:pt>
          <cx:pt idx="94">3.6229389692114902</cx:pt>
          <cx:pt idx="95">3.3242824552976926</cx:pt>
          <cx:pt idx="96">0</cx:pt>
          <cx:pt idx="97">0</cx:pt>
          <cx:pt idx="98">3.8211203237768236</cx:pt>
          <cx:pt idx="99">0</cx:pt>
          <cx:pt idx="100">3.3896975482063856</cx:pt>
          <cx:pt idx="101">0</cx:pt>
          <cx:pt idx="102">3.8580557180503643</cx:pt>
          <cx:pt idx="103">2.8294967497201826</cx:pt>
          <cx:pt idx="104">0</cx:pt>
          <cx:pt idx="105">0</cx:pt>
          <cx:pt idx="106">0</cx:pt>
          <cx:pt idx="107">2.2273724422896364</cx:pt>
          <cx:pt idx="108">3.7983052820219765</cx:pt>
          <cx:pt idx="109">3.5150786750759226</cx:pt>
          <cx:pt idx="110">3.1280760126687155</cx:pt>
          <cx:pt idx="111">3.5476516583599693</cx:pt>
          <cx:pt idx="112">3.683407299132095</cx:pt>
          <cx:pt idx="113">0</cx:pt>
          <cx:pt idx="114">3.441538038702161</cx:pt>
          <cx:pt idx="115">3.802705327074352</cx:pt>
          <cx:pt idx="116">0</cx:pt>
          <cx:pt idx="117">0</cx:pt>
          <cx:pt idx="118">2.7744439689249649</cx:pt>
          <cx:pt idx="119">3.1821292140529982</cx:pt>
          <cx:pt idx="120">0</cx:pt>
          <cx:pt idx="121">3.2245330626060857</cx:pt>
          <cx:pt idx="122">2.860397905127313</cx:pt>
          <cx:pt idx="123">0</cx:pt>
          <cx:pt idx="124">3.1829849670035819</cx:pt>
          <cx:pt idx="125">3.4566696294237578</cx:pt>
          <cx:pt idx="126">2.2595938788859486</cx:pt>
          <cx:pt idx="127">0</cx:pt>
          <cx:pt idx="128">0</cx:pt>
          <cx:pt idx="129">0</cx:pt>
          <cx:pt idx="130">3.7231271587956916</cx:pt>
          <cx:pt idx="131">0</cx:pt>
          <cx:pt idx="132">3.5116160205691376</cx:pt>
          <cx:pt idx="133">0</cx:pt>
          <cx:pt idx="134">0</cx:pt>
          <cx:pt idx="135">3.471144965160633</cx:pt>
          <cx:pt idx="136">0</cx:pt>
          <cx:pt idx="137">3.5853479110945909</cx:pt>
          <cx:pt idx="138">0</cx:pt>
          <cx:pt idx="139">3.5645477117559481</cx:pt>
          <cx:pt idx="140">0</cx:pt>
          <cx:pt idx="141">0</cx:pt>
          <cx:pt idx="142">2.8745977687031998</cx:pt>
          <cx:pt idx="143">0</cx:pt>
          <cx:pt idx="144">3.1136091510730277</cx:pt>
          <cx:pt idx="145">3.1357685145678222</cx:pt>
          <cx:pt idx="146">3.8356905714924254</cx:pt>
          <cx:pt idx="147">3.6757783416740852</cx:pt>
          <cx:pt idx="149">1.9702073588068547</cx:pt>
          <cx:pt idx="150">3.0979510709941498</cx:pt>
          <cx:pt idx="152">2.6850247851057141</cx:pt>
          <cx:pt idx="153">2.3816564825857869</cx:pt>
          <cx:pt idx="154">3.0644579892269186</cx:pt>
          <cx:pt idx="155">2.2309595557485689</cx:pt>
          <cx:pt idx="156">0</cx:pt>
          <cx:pt idx="157">1.4614985267830187</cx:pt>
          <cx:pt idx="158">0</cx:pt>
          <cx:pt idx="159">0</cx:pt>
          <cx:pt idx="160">3.2054750367408911</cx:pt>
          <cx:pt idx="161">2.6987962517904314</cx:pt>
          <cx:pt idx="162">3.8373990243420226</cx:pt>
          <cx:pt idx="163">2.020775488193558</cx:pt>
          <cx:pt idx="164">1.7115541682501696</cx:pt>
          <cx:pt idx="165">3.5293019977879805</cx:pt>
          <cx:pt idx="166">2.0526939419249679</cx:pt>
          <cx:pt idx="167">3.4161410311683289</cx:pt>
          <cx:pt idx="168">1.858115932190066</cx:pt>
          <cx:pt idx="169">1.7282725978950171</cx:pt>
          <cx:pt idx="170">3.3096301674258988</cx:pt>
          <cx:pt idx="171">2.9023836844324715</cx:pt>
          <cx:pt idx="172">3.9427519204298136</cx:pt>
          <cx:pt idx="173">1.9365640051352659</cx:pt>
          <cx:pt idx="174">3.7511250715355837</cx:pt>
          <cx:pt idx="175">2.1939589780191868</cx:pt>
          <cx:pt idx="176">1.9466487339066763</cx:pt>
          <cx:pt idx="177">1.8597985474805656</cx:pt>
          <cx:pt idx="178">1.7957410208692439</cx:pt>
          <cx:pt idx="179">1.8355637516690968</cx:pt>
          <cx:pt idx="180">1.9709973655724853</cx:pt>
          <cx:pt idx="181">3.2973227142053028</cx:pt>
          <cx:pt idx="182">1.9773577295453013</cx:pt>
          <cx:pt idx="183">1.787814567063023</cx:pt>
          <cx:pt idx="184">1.7985815947285477</cx:pt>
          <cx:pt idx="185">1.9910044403307552</cx:pt>
          <cx:pt idx="186">2.0951693514317551</cx:pt>
          <cx:pt idx="187">3.0845762779343309</cx:pt>
          <cx:pt idx="188">1.7407573233077707</cx:pt>
          <cx:pt idx="189">2.3040594662175993</cx:pt>
          <cx:pt idx="190">1.8570911546735138</cx:pt>
          <cx:pt idx="191">2.035829825252828</cx:pt>
          <cx:pt idx="192">3.2736955879300922</cx:pt>
          <cx:pt idx="193">2.0216027160282422</cx:pt>
          <cx:pt idx="194">2.2846562827885157</cx:pt>
          <cx:pt idx="195">2.9024924211586036</cx:pt>
          <cx:pt idx="196">1.7527396939353281</cx:pt>
          <cx:pt idx="197">2.8490506905695123</cx:pt>
          <cx:pt idx="198">1.7532765701844184</cx:pt>
          <cx:pt idx="199">1.7821858664920163</cx:pt>
          <cx:pt idx="200">3.8344207036815328</cx:pt>
          <cx:pt idx="201">1.6781540380104374</cx:pt>
          <cx:pt idx="202">3.2574385668598138</cx:pt>
          <cx:pt idx="203">2.3902283624691298</cx:pt>
          <cx:pt idx="204">3.6843066460716316</cx:pt>
          <cx:pt idx="205">1.7180862947830917</cx:pt>
          <cx:pt idx="206">3.0211892990699383</cx:pt>
          <cx:pt idx="207">0</cx:pt>
          <cx:pt idx="208">3.3925210899319325</cx:pt>
          <cx:pt idx="209">2.9764875373051898</cx:pt>
          <cx:pt idx="210">2.6173149332982937</cx:pt>
          <cx:pt idx="211">0.68957521575993819</cx:pt>
          <cx:pt idx="212">1.9223620967847901</cx:pt>
          <cx:pt idx="213">1.2309595557485691</cx:pt>
          <cx:pt idx="214">0.93084719168249697</cx:pt>
          <cx:pt idx="215">2.3242824552976926</cx:pt>
          <cx:pt idx="216">1.2633993313340022</cx:pt>
          <cx:pt idx="217">0</cx:pt>
          <cx:pt idx="218">0</cx:pt>
          <cx:pt idx="219">1.7964355588101746</cx:pt>
          <cx:pt idx="220">3.2435341018320618</cx:pt>
          <cx:pt idx="221">3.5727554651542195</cx:pt>
          <cx:pt idx="222">0</cx:pt>
          <cx:pt idx="223">2.8302678009336417</cx:pt>
          <cx:pt idx="224">3.2410481506716442</cx:pt>
          <cx:pt idx="225">3.1852587652965849</cx:pt>
          <cx:pt idx="226">0</cx:pt>
          <cx:pt idx="227">2.3261309567107946</cx:pt>
          <cx:pt idx="228">2.2619761913978125</cx:pt>
          <cx:pt idx="229">2.2769211320657741</cx:pt>
          <cx:pt idx="231">3.1176026916900841</cx:pt>
          <cx:pt idx="232">2.8570911546735136</cx:pt>
          <cx:pt idx="233">1.2390490931401914</cx:pt>
          <cx:pt idx="234">2.111262513659065</cx:pt>
          <cx:pt idx="235">2.8014037100173552</cx:pt>
          <cx:pt idx="236">3.7959494989028033</cx:pt>
          <cx:pt idx="237">1.9971678714458339</cx:pt>
          <cx:pt idx="238">1.1684974835230326</cx:pt>
          <cx:pt idx="239">3.3647385550553985</cx:pt>
          <cx:pt idx="240">3.7712934426290596</cx:pt>
          <cx:pt idx="241">0</cx:pt>
          <cx:pt idx="242">2.8162412999917832</cx:pt>
          <cx:pt idx="243">0</cx:pt>
          <cx:pt idx="244">2.896415976473123</cx:pt>
          <cx:pt idx="245">0</cx:pt>
          <cx:pt idx="246">0</cx:pt>
          <cx:pt idx="247">3.4801507252732806</cx:pt>
          <cx:pt idx="248">0</cx:pt>
          <cx:pt idx="249">3.7352794480604565</cx:pt>
          <cx:pt idx="250">3.2860071220794747</cx:pt>
          <cx:pt idx="251">0</cx:pt>
          <cx:pt idx="252">0</cx:pt>
          <cx:pt idx="253">2.1238516409670858</cx:pt>
          <cx:pt idx="254">0</cx:pt>
          <cx:pt idx="255">2.1568519010700111</cx:pt>
          <cx:pt idx="256">3.8167714123333463</cx:pt>
          <cx:pt idx="257">3.8211858826088454</cx:pt>
          <cx:pt idx="258">2.8368302864888788</cx:pt>
          <cx:pt idx="259">3.6452257115354163</cx:pt>
          <cx:pt idx="260">0</cx:pt>
          <cx:pt idx="261">0</cx:pt>
          <cx:pt idx="262">3.372175286115064</cx:pt>
          <cx:pt idx="263">0</cx:pt>
          <cx:pt idx="264">0</cx:pt>
          <cx:pt idx="265">0</cx:pt>
          <cx:pt idx="266">3.1209028176145273</cx:pt>
          <cx:pt idx="267">0</cx:pt>
          <cx:pt idx="268">2.8208579894397001</cx:pt>
          <cx:pt idx="269">0</cx:pt>
          <cx:pt idx="270">3.6605809124272994</cx:pt>
          <cx:pt idx="271">0</cx:pt>
          <cx:pt idx="272">0</cx:pt>
          <cx:pt idx="273">3.9643539292921934</cx:pt>
          <cx:pt idx="274">3.0549958615291417</cx:pt>
          <cx:pt idx="275">0</cx:pt>
          <cx:pt idx="276">3.9593276459721709</cx:pt>
          <cx:pt idx="277">3.9252605095194353</cx:pt>
          <cx:pt idx="278">0</cx:pt>
          <cx:pt idx="279">3.6135247028536526</cx:pt>
          <cx:pt idx="280">3.7693034601890818</cx:pt>
          <cx:pt idx="281">3.3492775274679554</cx:pt>
          <cx:pt idx="282">0</cx:pt>
          <cx:pt idx="283">0.96146855535078635</cx:pt>
          <cx:pt idx="284">3.4881274962474587</cx:pt>
          <cx:pt idx="285">3.8371463439090601</cx:pt>
          <cx:pt idx="286">2.4101020766428607</cx:pt>
          <cx:pt idx="287">2.5515719736742537</cx:pt>
          <cx:pt idx="288">2.7044079273868409</cx:pt>
          <cx:pt idx="289">3.2405492482825999</cx:pt>
          <cx:pt idx="290">0</cx:pt>
          <cx:pt idx="291">2.3366598234544202</cx:pt>
          <cx:pt idx="292">2.0472748673841794</cx:pt>
          <cx:pt idx="293">0</cx:pt>
          <cx:pt idx="294">0</cx:pt>
          <cx:pt idx="295">2.6091673743020198</cx:pt>
          <cx:pt idx="296">2.9309999419561521</cx:pt>
          <cx:pt idx="297">0</cx:pt>
          <cx:pt idx="298">0</cx:pt>
          <cx:pt idx="299">0</cx:pt>
          <cx:pt idx="300">0</cx:pt>
          <cx:pt idx="301">3.8570911546735136</cx:pt>
          <cx:pt idx="302">0</cx:pt>
          <cx:pt idx="303">0</cx:pt>
          <cx:pt idx="304">0.93323412871480804</cx:pt>
          <cx:pt idx="305">2.5160062303860475</cx:pt>
          <cx:pt idx="306">3.2902572693945182</cx:pt>
          <cx:pt idx="307">1.7211508437496841</cx:pt>
          <cx:pt idx="308">0</cx:pt>
          <cx:pt idx="309">0</cx:pt>
          <cx:pt idx="310">3.2068258760318495</cx:pt>
          <cx:pt idx="311">2.6717280882395582</cx:pt>
          <cx:pt idx="312">2.0253058652647704</cx:pt>
          <cx:pt idx="313">2.9970367108825267</cx:pt>
          <cx:pt idx="315">2.4449811120879446</cx:pt>
          <cx:pt idx="316">3.5395778833453089</cx:pt>
          <cx:pt idx="317">1.8230827965328038</cx:pt>
          <cx:pt idx="318">1.5956064348656029</cx:pt>
          <cx:pt idx="319">3.284881714655453</cx:pt>
          <cx:pt idx="320">2.5078558716958308</cx:pt>
          <cx:pt idx="321">0</cx:pt>
          <cx:pt idx="322">0</cx:pt>
          <cx:pt idx="323">2.9467469350335849</cx:pt>
          <cx:pt idx="324">2.4407517004791854</cx:pt>
          <cx:pt idx="325">2.9638822289287772</cx:pt>
          <cx:pt idx="326">0</cx:pt>
          <cx:pt idx="327">3.7722483399718536</cx:pt>
          <cx:pt idx="328">0</cx:pt>
          <cx:pt idx="329">0</cx:pt>
          <cx:pt idx="330">2.7168377232995247</cx:pt>
          <cx:pt idx="331">2.6231458746379395</cx:pt>
          <cx:pt idx="332">2.5361795321372251</cx:pt>
          <cx:pt idx="333">2.7272158209084925</cx:pt>
          <cx:pt idx="334">3.5379449592914867</cx:pt>
          <cx:pt idx="335">0</cx:pt>
          <cx:pt idx="336">2.4679039465228003</cx:pt>
          <cx:pt idx="337">2.5206145218782359</cx:pt>
          <cx:pt idx="338">2.7502769151539925</cx:pt>
          <cx:pt idx="339">3.1212314551496214</cx:pt>
          <cx:pt idx="340">0</cx:pt>
          <cx:pt idx="341">0</cx:pt>
          <cx:pt idx="342">2.500373714353374</cx:pt>
          <cx:pt idx="343">2.9360107957152097</cx:pt>
          <cx:pt idx="344">0</cx:pt>
          <cx:pt idx="345">3.356790460351716</cx:pt>
          <cx:pt idx="346">0</cx:pt>
          <cx:pt idx="347">3.318272080211627</cx:pt>
          <cx:pt idx="348">2.5267268673146357</cx:pt>
          <cx:pt idx="349">0</cx:pt>
          <cx:pt idx="350">0</cx:pt>
          <cx:pt idx="351">1.89148170383952</cx:pt>
          <cx:pt idx="352">0</cx:pt>
          <cx:pt idx="353">3.020775488193558</cx:pt>
          <cx:pt idx="354">0</cx:pt>
          <cx:pt idx="355">0</cx:pt>
          <cx:pt idx="356">0</cx:pt>
          <cx:pt idx="357">0</cx:pt>
          <cx:pt idx="358">0</cx:pt>
          <cx:pt idx="359">3.0542299098633974</cx:pt>
          <cx:pt idx="360">3.5354207180561734</cx:pt>
          <cx:pt idx="361">0</cx:pt>
          <cx:pt idx="362">2.2884728005997825</cx:pt>
          <cx:pt idx="363">2.8794399659952172</cx:pt>
          <cx:pt idx="364">3.4601458174917501</cx:pt>
          <cx:pt idx="365">0</cx:pt>
          <cx:pt idx="366">3.249198357391113</cx:pt>
          <cx:pt idx="367">2.926136571067449</cx:pt>
          <cx:pt idx="368">1.6968803716827623</cx:pt>
          <cx:pt idx="369">0</cx:pt>
          <cx:pt idx="370">2.5991185650553628</cx:pt>
          <cx:pt idx="371">0</cx:pt>
          <cx:pt idx="372">2.697578033651113</cx:pt>
          <cx:pt idx="373">0</cx:pt>
          <cx:pt idx="374">2.2697463731307672</cx:pt>
          <cx:pt idx="375">0</cx:pt>
          <cx:pt idx="376">0</cx:pt>
          <cx:pt idx="377">0</cx:pt>
          <cx:pt idx="378">4.0618669721385627</cx:pt>
          <cx:pt idx="379">3.6347794581459518</cx:pt>
          <cx:pt idx="380">3.3016809492935764</cx:pt>
          <cx:pt idx="381">3.430075055551939</cx:pt>
          <cx:pt idx="382">0</cx:pt>
          <cx:pt idx="383">2.3694014136966244</cx:pt>
          <cx:pt idx="384">0</cx:pt>
          <cx:pt idx="385">3.0711452904510828</cx:pt>
          <cx:pt idx="386">3.0674428427763805</cx:pt>
          <cx:pt idx="387">0</cx:pt>
          <cx:pt idx="388">0</cx:pt>
          <cx:pt idx="389">2.6343764940883676</cx:pt>
          <cx:pt idx="390">2.7213983755215052</cx:pt>
          <cx:pt idx="391">1.5931752634781027</cx:pt>
          <cx:pt idx="392">3.3418300569205104</cx:pt>
          <cx:pt idx="393">0</cx:pt>
          <cx:pt idx="394">0</cx:pt>
          <cx:pt idx="395">0</cx:pt>
          <cx:pt idx="396">2.8069935136821074</cx:pt>
          <cx:pt idx="397">2.2360331471176358</cx:pt>
        </cx:lvl>
      </cx:numDim>
    </cx:data>
    <cx:data id="2">
      <cx:numDim type="val">
        <cx:f>all_IFN_levels!$D$2:$D$838</cx:f>
        <cx:lvl ptCount="837" formatCode="0.00">
          <cx:pt idx="0">0</cx:pt>
          <cx:pt idx="1">2.6835873175727669</cx:pt>
          <cx:pt idx="2">0</cx:pt>
          <cx:pt idx="3">4.0314488618593831</cx:pt>
          <cx:pt idx="4">3.6515687388657918</cx:pt>
          <cx:pt idx="5">0</cx:pt>
          <cx:pt idx="6">3.0606978403536118</cx:pt>
          <cx:pt idx="7">3.7375901662857216</cx:pt>
          <cx:pt idx="8">0</cx:pt>
          <cx:pt idx="9">0</cx:pt>
          <cx:pt idx="10">0</cx:pt>
          <cx:pt idx="11">3.7797407511767407</cx:pt>
          <cx:pt idx="12">4.0678516605123525</cx:pt>
          <cx:pt idx="13">0</cx:pt>
          <cx:pt idx="14">2.469822015978163</cx:pt>
          <cx:pt idx="15">0</cx:pt>
          <cx:pt idx="16">0</cx:pt>
          <cx:pt idx="17">0</cx:pt>
          <cx:pt idx="18">4.3550873800749041</cx:pt>
          <cx:pt idx="19">4.6344873464819329</cx:pt>
          <cx:pt idx="20">0</cx:pt>
          <cx:pt idx="21">0</cx:pt>
          <cx:pt idx="22">3.8100307864058394</cx:pt>
          <cx:pt idx="23">4.1258389639950046</cx:pt>
          <cx:pt idx="24">3.9564565834098997</cx:pt>
          <cx:pt idx="25">0</cx:pt>
          <cx:pt idx="26">0</cx:pt>
          <cx:pt idx="27">3.6939906104607769</cx:pt>
          <cx:pt idx="28">3.4039779636693548</cx:pt>
          <cx:pt idx="29">3.6784273224338673</cx:pt>
          <cx:pt idx="30">0</cx:pt>
          <cx:pt idx="31">3.8812705039293576</cx:pt>
          <cx:pt idx="32">3.5504729571065634</cx:pt>
          <cx:pt idx="33">3.4353665066126613</cx:pt>
          <cx:pt idx="34">3.9905164440282292</cx:pt>
          <cx:pt idx="35">3.6127838567197355</cx:pt>
          <cx:pt idx="36">3.330819466495837</cx:pt>
          <cx:pt idx="37">3.5626496722119168</cx:pt>
          <cx:pt idx="38">3.9529860651970554</cx:pt>
          <cx:pt idx="39">3.4079005401426352</cx:pt>
          <cx:pt idx="40">2.9027641439240859</cx:pt>
          <cx:pt idx="41">2.4442009888641594</cx:pt>
          <cx:pt idx="42">2.7974060496763822</cx:pt>
          <cx:pt idx="43">2.6573427368146261</cx:pt>
          <cx:pt idx="44">2.7335182514344876</cx:pt>
          <cx:pt idx="45">2.5850092799024611</cx:pt>
          <cx:pt idx="46">2.7512020945883533</cx:pt>
          <cx:pt idx="47">2.3533390953113047</cx:pt>
          <cx:pt idx="48">2.875697761980208</cx:pt>
          <cx:pt idx="49">2.4530123911214554</cx:pt>
          <cx:pt idx="50">2.2221960463017201</cx:pt>
          <cx:pt idx="51">2.1565491513317814</cx:pt>
          <cx:pt idx="52">2.9194964878630616</cx:pt>
          <cx:pt idx="53">2.5964871337365443</cx:pt>
          <cx:pt idx="54">2.9346499229007108</cx:pt>
          <cx:pt idx="55">2.4136349971985558</cx:pt>
          <cx:pt idx="56">2.5770319856260313</cx:pt>
          <cx:pt idx="57">2.4121244061733171</cx:pt>
          <cx:pt idx="58">2.764325605625984</cx:pt>
          <cx:pt idx="59">2.5014700721004122</cx:pt>
          <cx:pt idx="60">2.3634239329171765</cx:pt>
          <cx:pt idx="61">2.8857003801283301</cx:pt>
          <cx:pt idx="62">2.1126050015345745</cx:pt>
          <cx:pt idx="63">2.5471591213274176</cx:pt>
          <cx:pt idx="64">2.265996370495079</cx:pt>
          <cx:pt idx="65">2.5016069224188295</cx:pt>
          <cx:pt idx="66">2.2332500095411003</cx:pt>
          <cx:pt idx="67">2.4747988188006311</cx:pt>
          <cx:pt idx="68">1.8555191556678001</cx:pt>
          <cx:pt idx="69">2.0606978403536118</cx:pt>
          <cx:pt idx="70">3.1829849670035819</cx:pt>
          <cx:pt idx="71">2.7377490738915573</cx:pt>
          <cx:pt idx="72">2.5254335534288201</cx:pt>
          <cx:pt idx="73">2.375297738217339</cx:pt>
          <cx:pt idx="74">2.7849737099544005</cx:pt>
          <cx:pt idx="75">2.7816835845073506</cx:pt>
          <cx:pt idx="76">2.2417954312951989</cx:pt>
          <cx:pt idx="77">2.6854730197227594</cx:pt>
          <cx:pt idx="78">2.6058435390580894</cx:pt>
          <cx:pt idx="79">2.4670158184384356</cx:pt>
          <cx:pt idx="80">2.4282968139828798</cx:pt>
          <cx:pt idx="81">2.8868853589860088</cx:pt>
          <cx:pt idx="82">2.7628285531890904</cx:pt>
          <cx:pt idx="83">2.5588285248170117</cx:pt>
          <cx:pt idx="84">3.1684974835230326</cx:pt>
          <cx:pt idx="85">2.3163897510731952</cx:pt>
          <cx:pt idx="86">2.5972562829251418</cx:pt>
          <cx:pt idx="87">2.5796692935547205</cx:pt>
          <cx:pt idx="88">2.5477747053878224</cx:pt>
          <cx:pt idx="89">2.3025473724874854</cx:pt>
          <cx:pt idx="90">2.3712526291249394</cx:pt>
          <cx:pt idx="91">2.5847833789965078</cx:pt>
          <cx:pt idx="92">2.3893433112520781</cx:pt>
          <cx:pt idx="93">2.3443922736851106</cx:pt>
          <cx:pt idx="94">2.6351820486562678</cx:pt>
          <cx:pt idx="95">2.6480671294489344</cx:pt>
          <cx:pt idx="96">2.4237372499823291</cx:pt>
          <cx:pt idx="97">2.388988785124714</cx:pt>
          <cx:pt idx="98">2.5579881482249132</cx:pt>
          <cx:pt idx="99">2.2367890994092927</cx:pt>
          <cx:pt idx="100">2.9125939977521056</cx:pt>
          <cx:pt idx="101">2.5412046906832586</cx:pt>
          <cx:pt idx="102">2.9210098014970343</cx:pt>
          <cx:pt idx="103">2.6274682724597098</cx:pt>
          <cx:pt idx="104">2.2387985627139169</cx:pt>
          <cx:pt idx="105">2.3134453704264142</cx:pt>
          <cx:pt idx="106">2.1122697684172707</cx:pt>
          <cx:pt idx="107">2.3115419584011949</cx:pt>
          <cx:pt idx="108">2.667452952889954</cx:pt>
          <cx:pt idx="109">2.5464192668351915</cx:pt>
          <cx:pt idx="110">2.5747255835940734</cx:pt>
          <cx:pt idx="111">2.6594407818703178</cx:pt>
          <cx:pt idx="112">2.7264826967848297</cx:pt>
          <cx:pt idx="113">2.6403820447095683</cx:pt>
          <cx:pt idx="114">2.3727279408855955</cx:pt>
          <cx:pt idx="115">2.9854264740830017</cx:pt>
          <cx:pt idx="116">2.2513948500401044</cx:pt>
          <cx:pt idx="117">2.3424226808222062</cx:pt>
          <cx:pt idx="118">2.6030360562505215</cx:pt>
          <cx:pt idx="119">2.8474492624991727</cx:pt>
          <cx:pt idx="120">2.5689054149828787</cx:pt>
          <cx:pt idx="121">2.5169318088680126</cx:pt>
          <cx:pt idx="122">2.6516656039229356</cx:pt>
          <cx:pt idx="123">2.6604860157849677</cx:pt>
          <cx:pt idx="124">2.5626496722119168</cx:pt>
          <cx:pt idx="125">2.6770591773921613</cx:pt>
          <cx:pt idx="126">2.4379090355394983</cx:pt>
          <cx:pt idx="127">2.7307822756663893</cx:pt>
          <cx:pt idx="128">2.6380897219845059</cx:pt>
          <cx:pt idx="129">2.4788549675286631</cx:pt>
          <cx:pt idx="130">2.5699588180965942</cx:pt>
          <cx:pt idx="131">2.5301996982030821</cx:pt>
          <cx:pt idx="132">2.5246557123577773</cx:pt>
          <cx:pt idx="133">2.4643404846276673</cx:pt>
          <cx:pt idx="134">2.6074550232146687</cx:pt>
          <cx:pt idx="135">2.757471947765668</cx:pt>
          <cx:pt idx="136">2.5179872030250783</cx:pt>
          <cx:pt idx="137">2.801197834459149</cx:pt>
          <cx:pt idx="138">2.6390878710837375</cx:pt>
          <cx:pt idx="139">2.9096095104901689</cx:pt>
          <cx:pt idx="140">2.4823017672234426</cx:pt>
          <cx:pt idx="141">2.6352826379982122</cx:pt>
          <cx:pt idx="142">2.6600112212893308</cx:pt>
          <cx:pt idx="143">2.6518592692469491</cx:pt>
          <cx:pt idx="144">2.9939209588012869</cx:pt>
          <cx:pt idx="145">2.7900035203904894</cx:pt>
          <cx:pt idx="146">3.1589652603834102</cx:pt>
          <cx:pt idx="147">2.8151791301394185</cx:pt>
          <cx:pt idx="148">2.4184670209466006</cx:pt>
          <cx:pt idx="149">2.4292676664331685</cx:pt>
          <cx:pt idx="150">2.5710096723093048</cx:pt>
          <cx:pt idx="151">2.781755374652469</cx:pt>
          <cx:pt idx="152">2.4197905861063629</cx:pt>
          <cx:pt idx="153">2.2975416678181597</cx:pt>
          <cx:pt idx="154">2.6706168864003255</cx:pt>
          <cx:pt idx="155">2.2638726768652235</cx:pt>
          <cx:pt idx="156">2.472171146692363</cx:pt>
          <cx:pt idx="157">2.4842998393467859</cx:pt>
          <cx:pt idx="158">2.4580331924965062</cx:pt>
          <cx:pt idx="159">2.5597869682005565</cx:pt>
          <cx:pt idx="160">2.4844422076424069</cx:pt>
          <cx:pt idx="161">2.3712526291249394</cx:pt>
          <cx:pt idx="162">2.9067120569429639</cx:pt>
          <cx:pt idx="163">2.4692327425066121</cx:pt>
          <cx:pt idx="164">2.3070679506612985</cx:pt>
          <cx:pt idx="165">2.7191654940892134</cx:pt>
          <cx:pt idx="166">2.6409780573583319</cx:pt>
          <cx:pt idx="167">2.6295115342004531</cx:pt>
          <cx:pt idx="168">2.4692327425066121</cx:pt>
          <cx:pt idx="169">2.6938148538894167</cx:pt>
          <cx:pt idx="170">2.7294887691795613</cx:pt>
          <cx:pt idx="171">2.5706596700215343</cx:pt>
          <cx:pt idx="172">2.2990712600274095</cx:pt>
          <cx:pt idx="173">2.5225746326911769</cx:pt>
          <cx:pt idx="174">2.5449357658815024</cx:pt>
          <cx:pt idx="175">2.6662370958958044</cx:pt>
          <cx:pt idx="176">2.448087666692341</cx:pt>
          <cx:pt idx="177">2.532627001228891</cx:pt>
          <cx:pt idx="178">2.4867137759824853</cx:pt>
          <cx:pt idx="179">2.4089180208467798</cx:pt>
          <cx:pt idx="180">2.5435714239623652</cx:pt>
          <cx:pt idx="181">2.4935974490005268</cx:pt>
          <cx:pt idx="182">2.5113485154902131</cx:pt>
          <cx:pt idx="183">2.3981136917305026</cx:pt>
          <cx:pt idx="184">2.4119562379304016</cx:pt>
          <cx:pt idx="185">2.5323721335678773</cx:pt>
          <cx:pt idx="186">2.4646385590950328</cx:pt>
          <cx:pt idx="187">2.4695274791870139</cx:pt>
          <cx:pt idx="188">2.4032921451582543</cx:pt>
          <cx:pt idx="189">2.5676144427308447</cx:pt>
          <cx:pt idx="190">2.7554174628109362</cx:pt>
          <cx:pt idx="191">2.802020751771976</cx:pt>
          <cx:pt idx="192">2.5054213275832811</cx:pt>
          <cx:pt idx="193">2.6524397475894204</cx:pt>
          <cx:pt idx="194">2.5094713521025485</cx:pt>
          <cx:pt idx="195">2.7291647896927702</cx:pt>
          <cx:pt idx="196">2.45117215751254</cx:pt>
          <cx:pt idx="197">2.4771212547196626</cx:pt>
          <cx:pt idx="198">2.436162647040756</cx:pt>
          <cx:pt idx="199">2.7098633174403992</cx:pt>
          <cx:pt idx="200">2.5414544287475889</cx:pt>
          <cx:pt idx="201">2.5492485568540557</cx:pt>
          <cx:pt idx="202">2.5436956323092446</cx:pt>
          <cx:pt idx="203">2.5170638734826545</cx:pt>
          <cx:pt idx="204">2.5041989185394451</cx:pt>
          <cx:pt idx="205">2.6711728427150834</cx:pt>
          <cx:pt idx="206">2.5940609012704181</cx:pt>
          <cx:pt idx="207">2.5122840632818537</cx:pt>
          <cx:pt idx="208">2.7960189693471493</cx:pt>
          <cx:pt idx="209">2.4893959217271293</cx:pt>
          <cx:pt idx="210">2.4222614508136027</cx:pt>
          <cx:pt idx="211">2.518382315545344</cx:pt>
          <cx:pt idx="212">2.6518592692469491</cx:pt>
          <cx:pt idx="213">2.4739246934161572</cx:pt>
          <cx:pt idx="214">2.4689378056654614</cx:pt>
          <cx:pt idx="215">2.454387467146955</cx:pt>
          <cx:pt idx="216">2.5967070296814461</cx:pt>
          <cx:pt idx="217">2.7632033003707717</cx:pt>
          <cx:pt idx="218">2.5625307688622612</cx:pt>
          <cx:pt idx="219">2.426673888021373</cx:pt>
          <cx:pt idx="220">2.4983105537896004</cx:pt>
          <cx:pt idx="221">2.4470028984661623</cx:pt>
          <cx:pt idx="222">2.4565178578052627</cx:pt>
          <cx:pt idx="223">2.5413295776666938</cx:pt>
          <cx:pt idx="224">2.5048784594102158</cx:pt>
          <cx:pt idx="225">2.8442907432543429</cx:pt>
          <cx:pt idx="226">2.6826864782497681</cx:pt>
          <cx:pt idx="227">2.600428325732131</cx:pt>
          <cx:pt idx="228">2.5126843962171637</cx:pt>
          <cx:pt idx="229">2.518382315545344</cx:pt>
          <cx:pt idx="230">2.5368108659915416</cx:pt>
          <cx:pt idx="231">2.8278859827898559</cx:pt>
          <cx:pt idx="232">2.5440680443502757</cx:pt>
          <cx:pt idx="233">2.5693739096150461</cx:pt>
          <cx:pt idx="234">2.8060442357480881</cx:pt>
          <cx:pt idx="235">2.6319508262592168</cx:pt>
          <cx:pt idx="236">2.7660408603813891</cx:pt>
          <cx:pt idx="237">2.6183619311098782</cx:pt>
          <cx:pt idx="238">2.9009130677376689</cx:pt>
          <cx:pt idx="239">2.6521496054016529</cx:pt>
          <cx:pt idx="240">2.4056877866727775</cx:pt>
          <cx:pt idx="241">2.472171146692363</cx:pt>
          <cx:pt idx="242">2.6100210246641451</cx:pt>
          <cx:pt idx="243">2.5970366649776535</cx:pt>
          <cx:pt idx="244">2.6404814369704219</cx:pt>
          <cx:pt idx="245">2.3979400086720375</cx:pt>
          <cx:pt idx="246">2.4885507165004443</cx:pt>
          <cx:pt idx="247">2.8880671134074367</cx:pt>
          <cx:pt idx="248">2.840983837320378</cx:pt>
          <cx:pt idx="249">2.6015167836500104</cx:pt>
          <cx:pt idx="250">2.5058280338548364</cx:pt>
          <cx:pt idx="251">2.6222140229662951</cx:pt>
          <cx:pt idx="252">2.3496659840966299</cx:pt>
          <cx:pt idx="253">2.7901443650429005</cx:pt>
          <cx:pt idx="254">2.5335178620169674</cx:pt>
          <cx:pt idx="255">2.5041989185394451</cx:pt>
          <cx:pt idx="256">2.1357685145678222</cx:pt>
          <cx:pt idx="257">2.7629784908677428</cx:pt>
          <cx:pt idx="258">2.4479328655921804</cx:pt>
          <cx:pt idx="259">2.7729081949712717</cx:pt>
          <cx:pt idx="260">2.5254335534288201</cx:pt>
          <cx:pt idx="261">2.6018427897820979</cx:pt>
          <cx:pt idx="262">2.4646385590950328</cx:pt>
          <cx:pt idx="263">2.6885977750811696</cx:pt>
          <cx:pt idx="264">2.518382315545344</cx:pt>
          <cx:pt idx="265">0</cx:pt>
          <cx:pt idx="266">2.7043221408222355</cx:pt>
          <cx:pt idx="267">2.6145808669974859</cx:pt>
          <cx:pt idx="268">2.5873741720730656</cx:pt>
          <cx:pt idx="269">2.7169210731667612</cx:pt>
          <cx:pt idx="270">2.8300751664297503</cx:pt>
          <cx:pt idx="271">2.6901074394563307</cx:pt>
          <cx:pt idx="272">2.6269559514354475</cx:pt>
          <cx:pt idx="273">2.5703093854358796</cx:pt>
          <cx:pt idx="274">2.550105999347593</cx:pt>
          <cx:pt idx="275">2.5360531551592049</cx:pt>
          <cx:pt idx="276">2.6056282220076188</cx:pt>
          <cx:pt idx="277">2.7223047868743278</cx:pt>
          <cx:pt idx="278">2.531223374533027</cx:pt>
          <cx:pt idx="279">2.598571663482141</cx:pt>
          <cx:pt idx="280">2.7838321433844411</cx:pt>
          <cx:pt idx="281">3.1020905255118367</cx:pt>
          <cx:pt idx="282">2.635785235533652</cx:pt>
          <cx:pt idx="283">2.9020028913507296</cx:pt>
          <cx:pt idx="284">2.8858698609039064</cx:pt>
          <cx:pt idx="285">3.1156105116742996</cx:pt>
          <cx:pt idx="286">2.9610887197678961</cx:pt>
          <cx:pt idx="287">2.9610887197678961</cx:pt>
          <cx:pt idx="288">3.1829849670035819</cx:pt>
          <cx:pt idx="289">2.7680458141024169</cx:pt>
          <cx:pt idx="290">2.8150461760646306</cx:pt>
          <cx:pt idx="291">2.9582771255476974</cx:pt>
          <cx:pt idx="292">2.7813963051967905</cx:pt>
          <cx:pt idx="293">2.8565476448567479</cx:pt>
          <cx:pt idx="294">2.7831171374904673</cx:pt>
          <cx:pt idx="295">2.8553374044695405</cx:pt>
          <cx:pt idx="296">3.2076343673889616</cx:pt>
          <cx:pt idx="297">2.9776778876739938</cx:pt>
          <cx:pt idx="298">3.0744507189545911</cx:pt>
          <cx:pt idx="299">2.913760886412323</cx:pt>
          <cx:pt idx="300">2.9544354863284825</cx:pt>
          <cx:pt idx="301">3.463743721247059</cx:pt>
          <cx:pt idx="302">3.0472748673841794</cx:pt>
          <cx:pt idx="303">3.1109262422664203</cx:pt>
          <cx:pt idx="304">2.9650605206111984</cx:pt>
          <cx:pt idx="305">3.0546130545568877</cx:pt>
          <cx:pt idx="306">3.3857849588433355</cx:pt>
          <cx:pt idx="307">3.370698092575577</cx:pt>
          <cx:pt idx="308">3.2543063323312857</cx:pt>
          <cx:pt idx="309">2.9565525919173989</cx:pt>
          <cx:pt idx="310">3.1335389083702174</cx:pt>
          <cx:pt idx="311">3.1274287778515988</cx:pt>
          <cx:pt idx="312">3.0216027160282422</cx:pt>
          <cx:pt idx="313">3.082066934285113</cx:pt>
          <cx:pt idx="314">3.4143046881283317</cx:pt>
          <cx:pt idx="315">3.5017437296279943</cx:pt>
          <cx:pt idx="316">3.1495270137543478</cx:pt>
          <cx:pt idx="317">3.3328422669943514</cx:pt>
          <cx:pt idx="318">3.13640344813399</cx:pt>
          <cx:pt idx="319">3.0831441431430524</cx:pt>
          <cx:pt idx="320">2.8942052591420837</cx:pt>
          <cx:pt idx="321">2.6180480967120925</cx:pt>
          <cx:pt idx="322">2.5897262562542371</cx:pt>
          <cx:pt idx="323">2.4504030861553665</cx:pt>
          <cx:pt idx="324">2.3712526291249394</cx:pt>
          <cx:pt idx="325">2.4423229557455746</cx:pt>
          <cx:pt idx="326">2.4371160930480786</cx:pt>
          <cx:pt idx="327">2.8156441491319653</cx:pt>
          <cx:pt idx="328">2.1920095926536702</cx:pt>
          <cx:pt idx="329">2.4817291969600159</cx:pt>
          <cx:pt idx="330">2.4456042032735974</cx:pt>
          <cx:pt idx="331">2.6348801407665263</cx:pt>
          <cx:pt idx="332">2.6909045540549665</cx:pt>
          <cx:pt idx="333">2.3604040547299387</cx:pt>
          <cx:pt idx="334">2.6737579365495767</cx:pt>
          <cx:pt idx="335">2.2474822606770544</cx:pt>
          <cx:pt idx="336">2.4661258704181992</cx:pt>
          <cx:pt idx="337">2.6143698395482886</cx:pt>
          <cx:pt idx="338">2.6574383227029625</cx:pt>
          <cx:pt idx="339">2.5612206789339438</cx:pt>
          <cx:pt idx="340">2.603793704136963</cx:pt>
          <cx:pt idx="341">2.4000196350651586</cx:pt>
          <cx:pt idx="342">2.5286596452349901</cx:pt>
          <cx:pt idx="343">2.6602012013806817</cx:pt>
          <cx:pt idx="344">2.4299136977637548</cx:pt>
          <cx:pt idx="345">2.9002032130168933</cx:pt>
          <cx:pt idx="346">2.476976465759527</cx:pt>
          <cx:pt idx="347">2.5728716022004803</cx:pt>
          <cx:pt idx="348">2.7044079273868409</cx:pt>
          <cx:pt idx="349">2.7129021250472225</cx:pt>
          <cx:pt idx="350">2.3168087520530221</cx:pt>
          <cx:pt idx="351">2.4114513421379375</cx:pt>
          <cx:pt idx="352">1.9576551669434912</cx:pt>
          <cx:pt idx="353">2.5121505369220305</cx:pt>
          <cx:pt idx="354">2.5984622004741507</cx:pt>
          <cx:pt idx="355">2.6377898293622293</cx:pt>
          <cx:pt idx="356">2.3845326154942486</cx:pt>
          <cx:pt idx="357">2.4670158184384356</cx:pt>
          <cx:pt idx="358">2.5125509929042109</cx:pt>
          <cx:pt idx="359">2.4874212113594742</cx:pt>
          <cx:pt idx="360">2.7778616241762419</cx:pt>
          <cx:pt idx="361">2.4007106367732312</cx:pt>
          <cx:pt idx="362">2.3760291817281805</cx:pt>
          <cx:pt idx="363">2.3541084391474008</cx:pt>
          <cx:pt idx="364">2.4745076391169758</cx:pt>
          <cx:pt idx="365">2.1027766148834415</cx:pt>
          <cx:pt idx="366">2.3352572564345317</cx:pt>
          <cx:pt idx="367">2.6153186566114788</cx:pt>
          <cx:pt idx="368">2.0565237240791006</cx:pt>
          <cx:pt idx="369">2.3477202170340381</cx:pt>
          <cx:pt idx="370">2.5324995860946626</cx:pt>
          <cx:pt idx="371">2.3432115901797474</cx:pt>
          <cx:pt idx="372">2.4899584794248346</cx:pt>
          <cx:pt idx="373">2.2447717614952949</cx:pt>
          <cx:pt idx="374">2.6176292977578419</cx:pt>
          <cx:pt idx="375">2.398981066658131</cx:pt>
          <cx:pt idx="376">2.3590762260592628</cx:pt>
          <cx:pt idx="377">0</cx:pt>
          <cx:pt idx="378">2.7781512503836434</cx:pt>
          <cx:pt idx="379">2.9515803449033919</cx:pt>
          <cx:pt idx="380">2.5097400155703822</cx:pt>
          <cx:pt idx="381">2.60788374435699</cx:pt>
          <cx:pt idx="382">2.0809870469108871</cx:pt>
          <cx:pt idx="383">2.2988530764097068</cx:pt>
          <cx:pt idx="384">2.0595634179012676</cx:pt>
          <cx:pt idx="385">2.1580607939366052</cx:pt>
          <cx:pt idx="386">2.5796692935547205</cx:pt>
          <cx:pt idx="387">2.495821753385906</cx:pt>
          <cx:pt idx="388">2.401572845676446</cx:pt>
          <cx:pt idx="389">2.3410386316775229</cx:pt>
          <cx:pt idx="390">2.4891143693789193</cx:pt>
          <cx:pt idx="391">2.3825573219087857</cx:pt>
          <cx:pt idx="392">2.3001605369513523</cx:pt>
          <cx:pt idx="393">2.2986347831244354</cx:pt>
          <cx:pt idx="394">2.3666097103924297</cx:pt>
          <cx:pt idx="395">2.3718064585074159</cx:pt>
          <cx:pt idx="396">2.6243852414202653</cx:pt>
          <cx:pt idx="397">1.9700677965491371</cx:pt>
        </cx:lvl>
      </cx:numDim>
    </cx:data>
  </cx:chartData>
  <cx:chart>
    <cx:plotArea>
      <cx:plotAreaRegion>
        <cx:plotSurface>
          <cx:spPr>
            <a:ln>
              <a:solidFill>
                <a:sysClr val="windowText" lastClr="000000"/>
              </a:solidFill>
            </a:ln>
          </cx:spPr>
        </cx:plotSurface>
        <cx:series layoutId="boxWhisker" uniqueId="{11F36BF7-9309-4A6D-A02E-6539902EC789}">
          <cx:tx>
            <cx:txData>
              <cx:f>all_IFN_levels!$B$1</cx:f>
              <cx:v>IFNL1 CV-19 </cx:v>
            </cx:txData>
          </cx:tx>
          <cx:spPr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</cx:spPr>
          <cx:dataId val="0"/>
          <cx:layoutPr>
            <cx:visibility meanLine="1" meanMarker="0" nonoutliers="1" outliers="1"/>
            <cx:statistics quartileMethod="inclusive"/>
          </cx:layoutPr>
        </cx:series>
        <cx:series layoutId="boxWhisker" uniqueId="{ECF9643B-B4DA-4759-B63C-9F033533FFB6}">
          <cx:tx>
            <cx:txData>
              <cx:f>all_IFN_levels!$C$1</cx:f>
              <cx:v>IFNL2 CV-19</cx:v>
            </cx:txData>
          </cx:tx>
          <cx:spPr>
            <a:solidFill>
              <a:schemeClr val="bg2">
                <a:lumMod val="50000"/>
              </a:schemeClr>
            </a:solidFill>
            <a:ln>
              <a:solidFill>
                <a:sysClr val="windowText" lastClr="000000"/>
              </a:solidFill>
            </a:ln>
          </cx:spPr>
          <cx:dataId val="1"/>
          <cx:layoutPr>
            <cx:visibility meanLine="1" meanMarker="0" nonoutliers="1" outliers="1"/>
            <cx:statistics quartileMethod="inclusive"/>
          </cx:layoutPr>
        </cx:series>
        <cx:series layoutId="boxWhisker" uniqueId="{5A6FDCF1-A527-47A9-ACC4-4D10773B9E15}">
          <cx:tx>
            <cx:txData>
              <cx:f>all_IFN_levels!$D$1</cx:f>
              <cx:v>IFNL3 CV-19 </cx:v>
            </cx:txData>
          </cx:tx>
          <cx:spPr>
            <a:solidFill>
              <a:schemeClr val="bg2">
                <a:lumMod val="75000"/>
              </a:schemeClr>
            </a:solidFill>
            <a:ln>
              <a:solidFill>
                <a:sysClr val="windowText" lastClr="000000"/>
              </a:solidFill>
            </a:ln>
          </cx:spPr>
          <cx:dataId val="2"/>
          <cx:layoutPr>
            <cx:visibility meanLine="1" meanMarker="0" nonoutliers="1" outliers="1"/>
            <cx:statistics quartileMethod="inclusive"/>
          </cx:layoutPr>
        </cx:series>
      </cx:plotAreaRegion>
      <cx:axis id="0" hidden="1">
        <cx:catScaling gapWidth="0.330000013"/>
        <cx:tickLabels/>
      </cx:axis>
      <cx:axis id="1">
        <cx:valScaling max="6" min="-0.5"/>
        <cx:title>
          <cx:tx>
            <cx:rich>
              <a:bodyPr spcFirstLastPara="1" vertOverflow="ellipsis" horzOverflow="overflow" wrap="square" lIns="0" tIns="0" rIns="0" bIns="0" anchor="ctr" anchorCtr="1"/>
              <a:lstStyle/>
              <a:p>
                <a:pPr rtl="0" eaLnBrk="1" fontAlgn="auto" latinLnBrk="0" hangingPunct="1"/>
                <a:r>
                  <a:rPr lang="es-ES" sz="1200" b="1" i="0" baseline="0" dirty="0">
                    <a:effectLst/>
                    <a:latin typeface="+mn-lt"/>
                  </a:rPr>
                  <a:t>IFNL </a:t>
                </a:r>
                <a:r>
                  <a:rPr lang="es-ES" sz="1200" b="1" i="0" baseline="0" dirty="0" err="1">
                    <a:effectLst/>
                    <a:latin typeface="+mn-lt"/>
                  </a:rPr>
                  <a:t>pg</a:t>
                </a:r>
                <a:r>
                  <a:rPr lang="es-ES" sz="1200" b="1" i="0" baseline="0" dirty="0">
                    <a:effectLst/>
                    <a:latin typeface="+mn-lt"/>
                  </a:rPr>
                  <a:t>/ml Log10 (x+1)</a:t>
                </a:r>
                <a:endParaRPr lang="en-US" sz="1200" dirty="0">
                  <a:effectLst/>
                  <a:latin typeface="+mn-lt"/>
                </a:endParaRPr>
              </a:p>
            </cx:rich>
          </cx:tx>
        </cx:title>
        <cx:tickLabels/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200" b="1">
                <a:solidFill>
                  <a:sysClr val="windowText" lastClr="000000"/>
                </a:solidFill>
              </a:defRPr>
            </a:pPr>
            <a:endParaRPr lang="es-ES" sz="1200" b="1" i="0" u="none" strike="noStrike" baseline="0">
              <a:solidFill>
                <a:sysClr val="windowText" lastClr="000000"/>
              </a:solidFill>
              <a:latin typeface="Calibri" panose="020F0502020204030204"/>
            </a:endParaRPr>
          </a:p>
        </cx:txPr>
      </cx:axis>
    </cx:plotArea>
  </cx:chart>
  <cx:spPr>
    <a:ln>
      <a:solidFill>
        <a:sysClr val="windowText" lastClr="000000"/>
      </a:solidFill>
    </a:ln>
  </cx:spPr>
</cx:chartSpace>
</file>

<file path=ppt/charts/chartEx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Relevant IFNL Data ONLY'!$V$5:$V$60</cx:f>
        <cx:lvl ptCount="56" formatCode="0.00">
          <cx:pt idx="0">1.6634819693292902</cx:pt>
          <cx:pt idx="1">1.8193581618665939</cx:pt>
          <cx:pt idx="2">1.5631858345725056</cx:pt>
          <cx:pt idx="3">1.5350866914206234</cx:pt>
          <cx:pt idx="4">2.4188000421773794</cx:pt>
          <cx:pt idx="5">1.7425021203552122</cx:pt>
          <cx:pt idx="6">2.2036100990355507</cx:pt>
          <cx:pt idx="7">1</cx:pt>
          <cx:pt idx="8">1.4801014056469941</cx:pt>
          <cx:pt idx="9">1.9476334405074114</cx:pt>
          <cx:pt idx="10">1.7492563143766207</cx:pt>
          <cx:pt idx="11">1</cx:pt>
          <cx:pt idx="12">1.9827629324555829</cx:pt>
          <cx:pt idx="13">1.7761267858889382</cx:pt>
          <cx:pt idx="14">1.8427719597330874</cx:pt>
          <cx:pt idx="15">1.5854696134657991</cx:pt>
          <cx:pt idx="16">1.5726467477274206</cx:pt>
          <cx:pt idx="17">-0.12018995601037108</cx:pt>
          <cx:pt idx="18">2.0701312823720808</cx:pt>
          <cx:pt idx="19">1.8712389593928929</cx:pt>
          <cx:pt idx="20">2.0975713966454457</cx:pt>
          <cx:pt idx="21">1.8627634931017305</cx:pt>
          <cx:pt idx="22">2.841068298512206</cx:pt>
          <cx:pt idx="23">0.55710147057239434</cx:pt>
          <cx:pt idx="24">3.4424365902691809</cx:pt>
          <cx:pt idx="25">0.99544198949789453</cx:pt>
          <cx:pt idx="26">1.6323963500774363</cx:pt>
          <cx:pt idx="27">1.5292846246435834</cx:pt>
          <cx:pt idx="28">1.4782448785388413</cx:pt>
          <cx:pt idx="29">1.7753287621324307</cx:pt>
          <cx:pt idx="30">1.6112319906005763</cx:pt>
          <cx:pt idx="31">2.0367313777895633</cx:pt>
          <cx:pt idx="32">1.8656363990382931</cx:pt>
          <cx:pt idx="33">1.9237681439470993</cx:pt>
          <cx:pt idx="34">1.7372750950614813</cx:pt>
          <cx:pt idx="35">1.3333741310390137</cx:pt>
          <cx:pt idx="36">1.3655132559008527</cx:pt>
          <cx:pt idx="37">1.7875035698705901</cx:pt>
          <cx:pt idx="38">1.8939624010096088</cx:pt>
          <cx:pt idx="39">1.6753007098699868</cx:pt>
          <cx:pt idx="40">1</cx:pt>
          <cx:pt idx="41">1.8565015581253048</cx:pt>
          <cx:pt idx="42">2.1522824063731747</cx:pt>
          <cx:pt idx="43">1.3575407222207603</cx:pt>
          <cx:pt idx="44">1.4305341189222596</cx:pt>
          <cx:pt idx="45">1.2852797694254225</cx:pt>
          <cx:pt idx="46">1.7988946406951487</cx:pt>
          <cx:pt idx="47">1.1655775100701813</cx:pt>
          <cx:pt idx="48">1</cx:pt>
          <cx:pt idx="49">1</cx:pt>
          <cx:pt idx="50">2.3348995431465593</cx:pt>
          <cx:pt idx="51">2.0388413884099159</cx:pt>
          <cx:pt idx="52">1</cx:pt>
          <cx:pt idx="53">0.071242358649223264</cx:pt>
          <cx:pt idx="54">1.1089087433649931</cx:pt>
          <cx:pt idx="55">1</cx:pt>
        </cx:lvl>
      </cx:numDim>
    </cx:data>
    <cx:data id="1">
      <cx:numDim type="val">
        <cx:f>'Relevant IFNL Data ONLY'!$W$5:$W$60</cx:f>
        <cx:lvl ptCount="56" formatCode="0.00">
          <cx:pt idx="0">1.8250572744380427</cx:pt>
          <cx:pt idx="1">1.7298617705360608</cx:pt>
          <cx:pt idx="2">1</cx:pt>
          <cx:pt idx="3">1</cx:pt>
          <cx:pt idx="4">1</cx:pt>
          <cx:pt idx="5">2.4644891218605505</cx:pt>
          <cx:pt idx="6">2.5153791701925909</cx:pt>
          <cx:pt idx="7">1</cx:pt>
          <cx:pt idx="8">1</cx:pt>
          <cx:pt idx="9">1</cx:pt>
          <cx:pt idx="10">2.4320144590955048</cx:pt>
          <cx:pt idx="11">1</cx:pt>
          <cx:pt idx="12">1.5867841871195858</cx:pt>
          <cx:pt idx="13">1.7431225354443463</cx:pt>
          <cx:pt idx="14">1</cx:pt>
          <cx:pt idx="15">1.3097961689340427</cx:pt>
          <cx:pt idx="16">1.591007059108452</cx:pt>
          <cx:pt idx="17">-0.17908246762865115</cx:pt>
          <cx:pt idx="18">2.4359786690144181</cx:pt>
          <cx:pt idx="19">2.5424254298945681</cx:pt>
          <cx:pt idx="20">2.527858692667778</cx:pt>
          <cx:pt idx="21">1</cx:pt>
          <cx:pt idx="22">2.6397351968813743</cx:pt>
          <cx:pt idx="23">2.2266426576527767</cx:pt>
          <cx:pt idx="24">2.4201426573779874</cx:pt>
          <cx:pt idx="25">1</cx:pt>
          <cx:pt idx="26">1</cx:pt>
          <cx:pt idx="27">1</cx:pt>
          <cx:pt idx="28">1</cx:pt>
          <cx:pt idx="29">1</cx:pt>
          <cx:pt idx="30">1</cx:pt>
          <cx:pt idx="31">1</cx:pt>
          <cx:pt idx="32">1</cx:pt>
          <cx:pt idx="33">1</cx:pt>
          <cx:pt idx="34">2.0099263013524666</cx:pt>
          <cx:pt idx="35">1</cx:pt>
          <cx:pt idx="36">2.1705650268637555</cx:pt>
          <cx:pt idx="37">2.1901560819936137</cx:pt>
          <cx:pt idx="38">1</cx:pt>
          <cx:pt idx="39">1</cx:pt>
          <cx:pt idx="40">1.8985075049951794</cx:pt>
          <cx:pt idx="41">1</cx:pt>
          <cx:pt idx="42">2.2244816561348721</cx:pt>
          <cx:pt idx="43">1</cx:pt>
          <cx:pt idx="44">1</cx:pt>
          <cx:pt idx="45">2.3776080329271942</cx:pt>
          <cx:pt idx="46">2.4786141593371793</cx:pt>
          <cx:pt idx="47">2.0506179530226412</cx:pt>
          <cx:pt idx="48">1</cx:pt>
          <cx:pt idx="49">1</cx:pt>
          <cx:pt idx="50">2.4271507193531163</cx:pt>
          <cx:pt idx="51">1</cx:pt>
          <cx:pt idx="52">1</cx:pt>
          <cx:pt idx="53">2.1804676268197145</cx:pt>
          <cx:pt idx="54">1</cx:pt>
          <cx:pt idx="55">1</cx:pt>
        </cx:lvl>
      </cx:numDim>
    </cx:data>
    <cx:data id="2">
      <cx:numDim type="val">
        <cx:f>'Relevant IFNL Data ONLY'!$X$5:$X$60</cx:f>
        <cx:lvl ptCount="56" formatCode="0.00">
          <cx:pt idx="0">2.1926438234048322</cx:pt>
          <cx:pt idx="1">2.0587293669142164</cx:pt>
          <cx:pt idx="2">2.5885459889967568</cx:pt>
          <cx:pt idx="3">2.2306881787236885</cx:pt>
          <cx:pt idx="4">1.8352309478072517</cx:pt>
          <cx:pt idx="5">1.797263753627713</cx:pt>
          <cx:pt idx="6">2.0060503241655265</cx:pt>
          <cx:pt idx="7">1.873124897695299</cx:pt>
          <cx:pt idx="8">2.212891407397116</cx:pt>
          <cx:pt idx="9">2.0035792106102615</cx:pt>
          <cx:pt idx="10">1.6460436701491674</cx:pt>
          <cx:pt idx="11">1.5196684144479287</cx:pt>
          <cx:pt idx="12">2.28785992011675</cx:pt>
          <cx:pt idx="13">2.0566491234449682</cx:pt>
          <cx:pt idx="14">2.0396084502021679</cx:pt>
          <cx:pt idx="15">2.6777637155150469</cx:pt>
          <cx:pt idx="16">1.9923554837723851</cx:pt>
          <cx:pt idx="17">2.3671083008817586</cx:pt>
          <cx:pt idx="18">2.1264708358379112</cx:pt>
          <cx:pt idx="19">2.439019423683229</cx:pt>
          <cx:pt idx="20">2.113417717249134</cx:pt>
          <cx:pt idx="21">1.9269319504137157</cx:pt>
          <cx:pt idx="22">2.4272200377871331</cx:pt>
          <cx:pt idx="23">2.0134150618713158</cx:pt>
          <cx:pt idx="24">2.7752043083332385</cx:pt>
          <cx:pt idx="25">2.0559941556720553</cx:pt>
          <cx:pt idx="26">2.4953394409445391</cx:pt>
          <cx:pt idx="27">2.3656868197996754</cx:pt>
          <cx:pt idx="28">2.365923899180788</cx:pt>
          <cx:pt idx="29">2.0994100100830275</cx:pt>
          <cx:pt idx="30">1.6786350331336666</cx:pt>
          <cx:pt idx="31">2.1377878993354074</cx:pt>
          <cx:pt idx="32">2.169307685844128</cx:pt>
          <cx:pt idx="33">2.0104530137868104</cx:pt>
          <cx:pt idx="34">2.0682223140832265</cx:pt>
          <cx:pt idx="35">2.2079180530189237</cx:pt>
          <cx:pt idx="36">1.943235973790042</cx:pt>
          <cx:pt idx="37">2.3266233161167622</cx:pt>
          <cx:pt idx="38">2.2214669197196684</cx:pt>
          <cx:pt idx="39">2.0722495621021859</cx:pt>
          <cx:pt idx="40">1</cx:pt>
          <cx:pt idx="41">2.4296936621471663</cx:pt>
          <cx:pt idx="42">1.8749362756337142</cx:pt>
          <cx:pt idx="43">2.043249837567247</cx:pt>
          <cx:pt idx="44">2.3789905185117886</cx:pt>
          <cx:pt idx="45">1.8193359918812166</cx:pt>
          <cx:pt idx="46">2.3658864257240064</cx:pt>
          <cx:pt idx="47">1.9040723152877643</cx:pt>
          <cx:pt idx="48">2.1604925171627989</cx:pt>
          <cx:pt idx="49">2.0904455770091155</cx:pt>
          <cx:pt idx="50">2.2714889714265891</cx:pt>
          <cx:pt idx="51">1.983520583457175</cx:pt>
          <cx:pt idx="52">2.6705370552824919</cx:pt>
          <cx:pt idx="53">2.3224097795491776</cx:pt>
          <cx:pt idx="54">2.2006755753186287</cx:pt>
          <cx:pt idx="55">1</cx:pt>
        </cx:lvl>
      </cx:numDim>
    </cx:data>
  </cx:chartData>
  <cx:chart>
    <cx:plotArea>
      <cx:plotAreaRegion>
        <cx:plotSurface>
          <cx:spPr>
            <a:ln>
              <a:solidFill>
                <a:schemeClr val="tx1"/>
              </a:solidFill>
            </a:ln>
          </cx:spPr>
        </cx:plotSurface>
        <cx:series layoutId="boxWhisker" uniqueId="{07A9BF9D-4D46-7A4F-B539-1B5D5BBF65CF}">
          <cx:tx>
            <cx:txData>
              <cx:f>'Relevant IFNL Data ONLY'!$V$4</cx:f>
              <cx:v>IFNL1</cx:v>
            </cx:txData>
          </cx:tx>
          <cx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cx:spPr>
          <cx:dataId val="0"/>
          <cx:layoutPr>
            <cx:visibility meanLine="1" meanMarker="0" nonoutliers="1" outliers="1"/>
            <cx:statistics quartileMethod="exclusive"/>
          </cx:layoutPr>
        </cx:series>
        <cx:series layoutId="boxWhisker" uniqueId="{46285EA9-3B19-9E4A-B2FB-40A0A6C1A0A3}">
          <cx:tx>
            <cx:txData>
              <cx:f>'Relevant IFNL Data ONLY'!$W$4</cx:f>
              <cx:v>IFNL2</cx:v>
            </cx:txData>
          </cx:tx>
          <cx:spPr>
            <a:solidFill>
              <a:schemeClr val="bg2">
                <a:lumMod val="50000"/>
              </a:schemeClr>
            </a:solidFill>
            <a:ln>
              <a:solidFill>
                <a:schemeClr val="tx1"/>
              </a:solidFill>
            </a:ln>
          </cx:spPr>
          <cx:dataId val="1"/>
          <cx:layoutPr>
            <cx:visibility meanLine="1" meanMarker="0" nonoutliers="1" outliers="1"/>
            <cx:statistics quartileMethod="exclusive"/>
          </cx:layoutPr>
        </cx:series>
        <cx:series layoutId="boxWhisker" uniqueId="{10D23C2E-2D56-CD4C-80AA-D83BAFB1CF5E}">
          <cx:tx>
            <cx:txData>
              <cx:f>'Relevant IFNL Data ONLY'!$X$4</cx:f>
              <cx:v>IFNL3</cx:v>
            </cx:txData>
          </cx:tx>
          <cx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cx:spPr>
          <cx:dataId val="2"/>
          <cx:layoutPr>
            <cx:visibility meanLine="1" meanMarker="0" nonoutliers="1" outliers="1"/>
            <cx:statistics quartileMethod="exclusive"/>
          </cx:layoutPr>
        </cx:series>
      </cx:plotAreaRegion>
      <cx:axis id="0" hidden="1">
        <cx:catScaling gapWidth="0.5"/>
        <cx:tickLabels/>
      </cx:axis>
      <cx:axis id="1">
        <cx:valScaling max="6" min="0"/>
        <cx:title>
          <cx:tx>
            <cx:rich>
              <a:bodyPr spcFirstLastPara="1" vertOverflow="ellipsis" horzOverflow="overflow" wrap="square" lIns="0" tIns="0" rIns="0" bIns="0" anchor="ctr" anchorCtr="1"/>
              <a:lstStyle/>
              <a:p>
                <a:pPr algn="ctr" rtl="0">
                  <a:defRPr sz="1200" b="1" i="0">
                    <a:solidFill>
                      <a:schemeClr val="tx1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defRPr>
                </a:pPr>
                <a:r>
                  <a:rPr lang="en-GB" sz="1200" b="1" i="0" u="none" strike="noStrike" baseline="0" dirty="0">
                    <a:solidFill>
                      <a:schemeClr val="tx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IFNL </a:t>
                </a:r>
                <a:r>
                  <a:rPr lang="en-GB" sz="1200" b="1" i="0" u="none" strike="noStrike" baseline="0" dirty="0" err="1">
                    <a:solidFill>
                      <a:schemeClr val="tx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pg</a:t>
                </a:r>
                <a:r>
                  <a:rPr lang="en-GB" sz="1200" b="1" i="0" u="none" strike="noStrike" baseline="0" dirty="0">
                    <a:solidFill>
                      <a:schemeClr val="tx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/ml Log10(x+1)</a:t>
                </a:r>
              </a:p>
            </cx:rich>
          </cx:tx>
        </cx:title>
        <cx:majorGridlines>
          <cx:spPr>
            <a:ln>
              <a:solidFill>
                <a:schemeClr val="bg1"/>
              </a:solidFill>
            </a:ln>
          </cx:spPr>
        </cx:majorGridlines>
        <cx:tickLabels/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200" b="1">
                <a:solidFill>
                  <a:schemeClr val="tx1"/>
                </a:solidFill>
              </a:defRPr>
            </a:pPr>
            <a:endParaRPr lang="en-GB" sz="1200" b="1" i="0" u="none" strike="noStrike" baseline="0">
              <a:solidFill>
                <a:schemeClr val="tx1"/>
              </a:solidFill>
              <a:latin typeface="Calibri" panose="020F0502020204030204"/>
            </a:endParaRPr>
          </a:p>
        </cx:txPr>
      </cx:axis>
    </cx:plotArea>
  </cx:chart>
  <cx:spPr>
    <a:ln>
      <a:solidFill>
        <a:schemeClr val="tx1"/>
      </a:solidFill>
    </a:ln>
  </cx:spPr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F1F4A9-B568-6C4D-A806-90EBAD265398}" type="datetimeFigureOut">
              <a:rPr lang="en-US" smtClean="0"/>
              <a:t>5/22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78C9F8-A979-684D-807F-E9C89D5723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807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78C9F8-A979-684D-807F-E9C89D57237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53816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78C9F8-A979-684D-807F-E9C89D57237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73123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78C9F8-A979-684D-807F-E9C89D57237B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1915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CF0C9C-A0AC-FE17-C4C0-F5D5BB58FF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79D8F37-F59D-AA01-93C7-7C0504AE47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C0FDA1-FED6-3CE8-1CC6-F09E2CC0C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70B7-C912-4043-B55E-B42017C79FF2}" type="datetimeFigureOut">
              <a:rPr lang="en-US" smtClean="0"/>
              <a:t>5/2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333808-C2E0-F724-E983-7DD33ED8C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9F2FF8-2282-6DA3-C863-BB1ABF2813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B7692-7DE3-D446-BDFD-C8805855A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50518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F79AE1-A519-AFD7-CC76-A1F09FDC52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60A63E0-4862-88A2-E61A-DDB1D796CD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C949AE-90EB-DBCA-4888-871854C6EC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70B7-C912-4043-B55E-B42017C79FF2}" type="datetimeFigureOut">
              <a:rPr lang="en-US" smtClean="0"/>
              <a:t>5/2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AB9C65-1A2A-BA81-A4CD-D2BE58087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3E16EE-BC2F-A102-84EF-E447FE6CE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B7692-7DE3-D446-BDFD-C8805855A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56265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5188348-A24A-23F3-5609-205402F576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43B0AC-D7BA-B492-FDFB-0F0F2486A5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870BBF-BA79-140E-0546-4746E7F02B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70B7-C912-4043-B55E-B42017C79FF2}" type="datetimeFigureOut">
              <a:rPr lang="en-US" smtClean="0"/>
              <a:t>5/2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66550E-E392-37A1-DCA1-A0C1FFDF53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6F47F9-E0BD-7D6A-F3F7-29DA67F40A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B7692-7DE3-D446-BDFD-C8805855A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440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12B4CF-6ABE-7FF9-E837-2B8D292DBE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18F946-D00B-D161-DE39-4A9B0AAE0D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853B07-D1DA-EC08-2B4C-FC3CB8B98D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70B7-C912-4043-B55E-B42017C79FF2}" type="datetimeFigureOut">
              <a:rPr lang="en-US" smtClean="0"/>
              <a:t>5/2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C5B554-0FD6-0C03-F8E8-2C9D50BDCA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B0EFC2-ED66-0875-E960-E14498C5DE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B7692-7DE3-D446-BDFD-C8805855A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419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842DD5-4E78-1EB0-82E9-3F07231119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E8D591-A459-647F-53DD-D3D8C1A9B7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65B72F-5309-C3B9-6ED9-6115BAB681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70B7-C912-4043-B55E-B42017C79FF2}" type="datetimeFigureOut">
              <a:rPr lang="en-US" smtClean="0"/>
              <a:t>5/2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F7513F-1B03-01BA-442A-B88A183917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675E72-55C6-DF09-9CAB-007711270B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B7692-7DE3-D446-BDFD-C8805855A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085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9FC3E8-B0AF-5E35-D337-259001D317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C360C8-7792-7CE3-A3F6-810C46C753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03334E-BB89-F29A-F60C-18861463D0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A173940-96FC-6C42-09CB-629F8A561F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70B7-C912-4043-B55E-B42017C79FF2}" type="datetimeFigureOut">
              <a:rPr lang="en-US" smtClean="0"/>
              <a:t>5/2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4ABDD0-4300-DA2E-7CB3-2F3413FE4C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B00609-A4A2-5408-4ADD-30A19FE58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B7692-7DE3-D446-BDFD-C8805855A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825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C9B256-D66B-217D-4AD8-2B0185FDBB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C03A52-7534-9C27-887C-B8965F3830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913509-1E53-2BB9-A194-18C06B521F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5A7ACC-60A8-BE72-630D-C9DEA9D8BE7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FC05DCD-0B99-7401-49B7-9CA9B800CF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003E238-5F75-8377-7E34-7D95318978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70B7-C912-4043-B55E-B42017C79FF2}" type="datetimeFigureOut">
              <a:rPr lang="en-US" smtClean="0"/>
              <a:t>5/22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7594967-3F75-BB16-7005-38658840B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A1F78C8-B650-515E-E0EE-512BA11010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B7692-7DE3-D446-BDFD-C8805855A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789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782A1D-7B90-0FF6-4FCC-2C01B753D3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934431F-5329-2C62-6E35-1999991435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70B7-C912-4043-B55E-B42017C79FF2}" type="datetimeFigureOut">
              <a:rPr lang="en-US" smtClean="0"/>
              <a:t>5/22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49379E7-7FF5-8736-AA40-4E33C434B7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C577597-DB50-7330-F4D0-C5CE6C4F07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B7692-7DE3-D446-BDFD-C8805855A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09996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3D67E2D-DDFB-716D-0863-D0FDD94C25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70B7-C912-4043-B55E-B42017C79FF2}" type="datetimeFigureOut">
              <a:rPr lang="en-US" smtClean="0"/>
              <a:t>5/22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0404577-628D-E698-F767-6F4C4F2D29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B09236E-EAD0-7B65-D91C-7EDE0E9635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B7692-7DE3-D446-BDFD-C8805855A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150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A4C94D-8EE5-838E-BFB5-FF38109390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082840-A3CB-19D1-1293-2122AD9A7E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14A8A6-8BD4-8FC5-00B1-25AA5468E3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D726F9-7392-F2B9-0C7F-F699D693D0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70B7-C912-4043-B55E-B42017C79FF2}" type="datetimeFigureOut">
              <a:rPr lang="en-US" smtClean="0"/>
              <a:t>5/2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6BF63C-21D6-A544-78A7-257269FEAA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3986E6-E2A4-80CC-8E3A-4AFC604992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B7692-7DE3-D446-BDFD-C8805855A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049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07CEE2-3A23-A799-C459-0DC56EA85F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4C3FF6D-CC3D-4DD0-0354-E82539CB86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BB93B9-4C0C-10B6-67C9-BE8FF0B948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578B3F-4CE0-6A35-2E7E-8F48FCFCB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70B7-C912-4043-B55E-B42017C79FF2}" type="datetimeFigureOut">
              <a:rPr lang="en-US" smtClean="0"/>
              <a:t>5/2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B5AA83-ED22-81C5-50FC-E2A3BA46E1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17E137-7EF2-EA61-74F1-D43F6F2AE2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B7692-7DE3-D446-BDFD-C8805855A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5045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A94853C-273C-C187-801A-B34AF62BE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F7AAA9-8DD3-21DB-4A47-6D7A6391C5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628952-4B01-C607-A245-CD2F0DB43A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0A70B7-C912-4043-B55E-B42017C79FF2}" type="datetimeFigureOut">
              <a:rPr lang="en-US" smtClean="0"/>
              <a:t>5/2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ECC960-4627-96B7-DBF8-F9F0F1464F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F78579-AAA6-4A05-AC9D-81A1B5B6CD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FB7692-7DE3-D446-BDFD-C8805855A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03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14/relationships/chartEx" Target="../charts/chartEx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microsoft.com/office/2014/relationships/chartEx" Target="../charts/chartEx2.xml"/><Relationship Id="rId4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4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3F031C59-6DE3-B545-C637-2EEF14031287}"/>
              </a:ext>
            </a:extLst>
          </p:cNvPr>
          <p:cNvSpPr txBox="1"/>
          <p:nvPr/>
        </p:nvSpPr>
        <p:spPr>
          <a:xfrm>
            <a:off x="445845" y="284768"/>
            <a:ext cx="5566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:</a:t>
            </a:r>
            <a:r>
              <a:rPr lang="en-US" b="1" dirty="0"/>
              <a:t> </a:t>
            </a:r>
            <a:r>
              <a:rPr lang="en-US" dirty="0"/>
              <a:t>Overall IFNL </a:t>
            </a:r>
            <a:r>
              <a:rPr lang="en-US" sz="1800" dirty="0"/>
              <a:t>levels in the two Covid-19 cohorts </a:t>
            </a:r>
            <a:endParaRPr lang="en-US" dirty="0"/>
          </a:p>
        </p:txBody>
      </p:sp>
      <p:grpSp>
        <p:nvGrpSpPr>
          <p:cNvPr id="10" name="Grupo 34">
            <a:extLst>
              <a:ext uri="{FF2B5EF4-FFF2-40B4-BE49-F238E27FC236}">
                <a16:creationId xmlns:a16="http://schemas.microsoft.com/office/drawing/2014/main" id="{097C25A4-CA2C-460C-B7D5-451C8E69183B}"/>
              </a:ext>
            </a:extLst>
          </p:cNvPr>
          <p:cNvGrpSpPr/>
          <p:nvPr/>
        </p:nvGrpSpPr>
        <p:grpSpPr>
          <a:xfrm>
            <a:off x="1182820" y="1500604"/>
            <a:ext cx="4152973" cy="2916062"/>
            <a:chOff x="0" y="0"/>
            <a:chExt cx="7030640" cy="4020740"/>
          </a:xfrm>
        </p:grpSpPr>
        <mc:AlternateContent xmlns:mc="http://schemas.openxmlformats.org/markup-compatibility/2006" xmlns:cx1="http://schemas.microsoft.com/office/drawing/2015/9/8/chartex">
          <mc:Choice Requires="cx1">
            <p:graphicFrame>
              <p:nvGraphicFramePr>
                <p:cNvPr id="11" name="Gráfico 35">
                  <a:extLst>
                    <a:ext uri="{FF2B5EF4-FFF2-40B4-BE49-F238E27FC236}">
                      <a16:creationId xmlns:a16="http://schemas.microsoft.com/office/drawing/2014/main" id="{E3D186EE-4916-44D5-322D-C7ED67889FB0}"/>
                    </a:ext>
                  </a:extLst>
                </p:cNvPr>
                <p:cNvGraphicFramePr/>
                <p:nvPr>
                  <p:extLst>
                    <p:ext uri="{D42A27DB-BD31-4B8C-83A1-F6EECF244321}">
                      <p14:modId xmlns:p14="http://schemas.microsoft.com/office/powerpoint/2010/main" val="2001618156"/>
                    </p:ext>
                  </p:extLst>
                </p:nvPr>
              </p:nvGraphicFramePr>
              <p:xfrm>
                <a:off x="0" y="0"/>
                <a:ext cx="7030640" cy="4020740"/>
              </p:xfrm>
              <a:graphic>
                <a:graphicData uri="http://schemas.microsoft.com/office/drawing/2014/chartex">
                  <cx:chart xmlns:cx="http://schemas.microsoft.com/office/drawing/2014/chartex" xmlns:r="http://schemas.openxmlformats.org/officeDocument/2006/relationships" r:id="rId3"/>
                </a:graphicData>
              </a:graphic>
            </p:graphicFrame>
          </mc:Choice>
          <mc:Fallback xmlns="">
            <p:pic>
              <p:nvPicPr>
                <p:cNvPr id="11" name="Gráfico 35">
                  <a:extLst>
                    <a:ext uri="{FF2B5EF4-FFF2-40B4-BE49-F238E27FC236}">
                      <a16:creationId xmlns:a16="http://schemas.microsoft.com/office/drawing/2014/main" id="{E3D186EE-4916-44D5-322D-C7ED67889FB0}"/>
                    </a:ext>
                  </a:extLst>
                </p:cNvPr>
                <p:cNvPicPr>
                  <a:picLocks noGrp="1" noRot="1" noChangeAspect="1" noMove="1" noResize="1" noEditPoints="1" noAdjustHandles="1" noChangeArrowheads="1" noChangeShapeType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182820" y="1500604"/>
                  <a:ext cx="4152973" cy="2916062"/>
                </a:xfrm>
                <a:prstGeom prst="rect">
                  <a:avLst/>
                </a:prstGeom>
              </p:spPr>
            </p:pic>
          </mc:Fallback>
        </mc:AlternateContent>
        <p:grpSp>
          <p:nvGrpSpPr>
            <p:cNvPr id="12" name="Grupo 36">
              <a:extLst>
                <a:ext uri="{FF2B5EF4-FFF2-40B4-BE49-F238E27FC236}">
                  <a16:creationId xmlns:a16="http://schemas.microsoft.com/office/drawing/2014/main" id="{E4A403AA-09D9-B1EE-64CB-E9239E1B04F4}"/>
                </a:ext>
              </a:extLst>
            </p:cNvPr>
            <p:cNvGrpSpPr/>
            <p:nvPr/>
          </p:nvGrpSpPr>
          <p:grpSpPr>
            <a:xfrm>
              <a:off x="2523224" y="283871"/>
              <a:ext cx="2886565" cy="189165"/>
              <a:chOff x="2523224" y="284168"/>
              <a:chExt cx="2886565" cy="192949"/>
            </a:xfrm>
          </p:grpSpPr>
          <p:sp>
            <p:nvSpPr>
              <p:cNvPr id="19" name="CuadroTexto 43">
                <a:extLst>
                  <a:ext uri="{FF2B5EF4-FFF2-40B4-BE49-F238E27FC236}">
                    <a16:creationId xmlns:a16="http://schemas.microsoft.com/office/drawing/2014/main" id="{2CDFC541-67E5-24E5-29C0-BED538C95BDD}"/>
                  </a:ext>
                </a:extLst>
              </p:cNvPr>
              <p:cNvSpPr txBox="1"/>
              <p:nvPr/>
            </p:nvSpPr>
            <p:spPr>
              <a:xfrm>
                <a:off x="3802440" y="284168"/>
                <a:ext cx="988151" cy="64299"/>
              </a:xfrm>
              <a:prstGeom prst="rect">
                <a:avLst/>
              </a:prstGeom>
              <a:solidFill>
                <a:schemeClr val="lt1"/>
              </a:solidFill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b="1" dirty="0"/>
                  <a:t>****</a:t>
                </a:r>
              </a:p>
            </p:txBody>
          </p:sp>
          <p:cxnSp>
            <p:nvCxnSpPr>
              <p:cNvPr id="20" name="Conector recto 44">
                <a:extLst>
                  <a:ext uri="{FF2B5EF4-FFF2-40B4-BE49-F238E27FC236}">
                    <a16:creationId xmlns:a16="http://schemas.microsoft.com/office/drawing/2014/main" id="{CA98B5E3-3869-E9D1-4EB3-4C4A9C1597F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23224" y="471444"/>
                <a:ext cx="2886565" cy="5673"/>
              </a:xfrm>
              <a:prstGeom prst="line">
                <a:avLst/>
              </a:prstGeom>
              <a:ln w="9525">
                <a:solidFill>
                  <a:sysClr val="windowText" lastClr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" name="Grupo 37">
              <a:extLst>
                <a:ext uri="{FF2B5EF4-FFF2-40B4-BE49-F238E27FC236}">
                  <a16:creationId xmlns:a16="http://schemas.microsoft.com/office/drawing/2014/main" id="{32E02496-AFB1-862F-6FA0-C7015807A756}"/>
                </a:ext>
              </a:extLst>
            </p:cNvPr>
            <p:cNvGrpSpPr/>
            <p:nvPr/>
          </p:nvGrpSpPr>
          <p:grpSpPr>
            <a:xfrm>
              <a:off x="2523225" y="644556"/>
              <a:ext cx="3060450" cy="120674"/>
              <a:chOff x="2523225" y="647943"/>
              <a:chExt cx="3060450" cy="123058"/>
            </a:xfrm>
          </p:grpSpPr>
          <p:sp>
            <p:nvSpPr>
              <p:cNvPr id="17" name="CuadroTexto 41">
                <a:extLst>
                  <a:ext uri="{FF2B5EF4-FFF2-40B4-BE49-F238E27FC236}">
                    <a16:creationId xmlns:a16="http://schemas.microsoft.com/office/drawing/2014/main" id="{659E356C-F48C-299B-96A3-5F8C251E8A0B}"/>
                  </a:ext>
                </a:extLst>
              </p:cNvPr>
              <p:cNvSpPr txBox="1"/>
              <p:nvPr/>
            </p:nvSpPr>
            <p:spPr>
              <a:xfrm>
                <a:off x="4554937" y="653725"/>
                <a:ext cx="1028738" cy="117276"/>
              </a:xfrm>
              <a:prstGeom prst="rect">
                <a:avLst/>
              </a:prstGeom>
              <a:solidFill>
                <a:schemeClr val="lt1"/>
              </a:solidFill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b="1" dirty="0"/>
                  <a:t>****</a:t>
                </a:r>
              </a:p>
            </p:txBody>
          </p:sp>
          <p:cxnSp>
            <p:nvCxnSpPr>
              <p:cNvPr id="18" name="Conector recto 42">
                <a:extLst>
                  <a:ext uri="{FF2B5EF4-FFF2-40B4-BE49-F238E27FC236}">
                    <a16:creationId xmlns:a16="http://schemas.microsoft.com/office/drawing/2014/main" id="{D69579B1-AF37-EF8B-AFB7-78E77F50ADA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23225" y="647943"/>
                <a:ext cx="1324548" cy="0"/>
              </a:xfrm>
              <a:prstGeom prst="line">
                <a:avLst/>
              </a:prstGeom>
              <a:ln w="9525">
                <a:solidFill>
                  <a:sysClr val="windowText" lastClr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" name="Grupo 38">
              <a:extLst>
                <a:ext uri="{FF2B5EF4-FFF2-40B4-BE49-F238E27FC236}">
                  <a16:creationId xmlns:a16="http://schemas.microsoft.com/office/drawing/2014/main" id="{67F747E0-D82F-F2BD-1432-5E96EE58E305}"/>
                </a:ext>
              </a:extLst>
            </p:cNvPr>
            <p:cNvGrpSpPr/>
            <p:nvPr/>
          </p:nvGrpSpPr>
          <p:grpSpPr>
            <a:xfrm>
              <a:off x="3074232" y="475020"/>
              <a:ext cx="2335557" cy="363982"/>
              <a:chOff x="3074232" y="472676"/>
              <a:chExt cx="2335557" cy="371173"/>
            </a:xfrm>
          </p:grpSpPr>
          <p:sp>
            <p:nvSpPr>
              <p:cNvPr id="15" name="CuadroTexto 39">
                <a:extLst>
                  <a:ext uri="{FF2B5EF4-FFF2-40B4-BE49-F238E27FC236}">
                    <a16:creationId xmlns:a16="http://schemas.microsoft.com/office/drawing/2014/main" id="{F86FBC16-1C57-5319-A887-A9E41933709C}"/>
                  </a:ext>
                </a:extLst>
              </p:cNvPr>
              <p:cNvSpPr txBox="1"/>
              <p:nvPr/>
            </p:nvSpPr>
            <p:spPr>
              <a:xfrm>
                <a:off x="3074232" y="472676"/>
                <a:ext cx="780257" cy="87750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b="1" dirty="0"/>
                  <a:t>****</a:t>
                </a:r>
              </a:p>
            </p:txBody>
          </p:sp>
          <p:cxnSp>
            <p:nvCxnSpPr>
              <p:cNvPr id="16" name="Conector recto 40">
                <a:extLst>
                  <a:ext uri="{FF2B5EF4-FFF2-40B4-BE49-F238E27FC236}">
                    <a16:creationId xmlns:a16="http://schemas.microsoft.com/office/drawing/2014/main" id="{610FC356-ACEF-A062-5291-CFF03992385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90073" y="843849"/>
                <a:ext cx="1419716" cy="0"/>
              </a:xfrm>
              <a:prstGeom prst="line">
                <a:avLst/>
              </a:prstGeom>
              <a:ln w="9525">
                <a:solidFill>
                  <a:sysClr val="windowText" lastClr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B034BB3B-437E-24A5-803B-99D84AD3F84E}"/>
              </a:ext>
            </a:extLst>
          </p:cNvPr>
          <p:cNvSpPr txBox="1"/>
          <p:nvPr/>
        </p:nvSpPr>
        <p:spPr>
          <a:xfrm>
            <a:off x="2412384" y="4388055"/>
            <a:ext cx="22958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FNL1              IFNL2               IFNL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099C1AC-9B82-F308-528C-500BF9D7B62D}"/>
              </a:ext>
            </a:extLst>
          </p:cNvPr>
          <p:cNvSpPr txBox="1"/>
          <p:nvPr/>
        </p:nvSpPr>
        <p:spPr>
          <a:xfrm>
            <a:off x="8133734" y="4388054"/>
            <a:ext cx="20136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FNL1           IFNL2           IFNL3</a:t>
            </a: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2" name="Chart 1">
                <a:extLst>
                  <a:ext uri="{FF2B5EF4-FFF2-40B4-BE49-F238E27FC236}">
                    <a16:creationId xmlns:a16="http://schemas.microsoft.com/office/drawing/2014/main" id="{E041408F-EE07-4AA8-BC5C-66EC3781F178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4083971533"/>
                  </p:ext>
                </p:extLst>
              </p:nvPr>
            </p:nvGraphicFramePr>
            <p:xfrm>
              <a:off x="6883711" y="1458396"/>
              <a:ext cx="3952698" cy="2958268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5"/>
              </a:graphicData>
            </a:graphic>
          </p:graphicFrame>
        </mc:Choice>
        <mc:Fallback xmlns="">
          <p:pic>
            <p:nvPicPr>
              <p:cNvPr id="2" name="Chart 1">
                <a:extLst>
                  <a:ext uri="{FF2B5EF4-FFF2-40B4-BE49-F238E27FC236}">
                    <a16:creationId xmlns:a16="http://schemas.microsoft.com/office/drawing/2014/main" id="{E041408F-EE07-4AA8-BC5C-66EC3781F178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883711" y="1458396"/>
                <a:ext cx="3952698" cy="2958268"/>
              </a:xfrm>
              <a:prstGeom prst="rect">
                <a:avLst/>
              </a:prstGeom>
            </p:spPr>
          </p:pic>
        </mc:Fallback>
      </mc:AlternateContent>
      <p:sp>
        <p:nvSpPr>
          <p:cNvPr id="3" name="TextBox 2">
            <a:extLst>
              <a:ext uri="{FF2B5EF4-FFF2-40B4-BE49-F238E27FC236}">
                <a16:creationId xmlns:a16="http://schemas.microsoft.com/office/drawing/2014/main" id="{4FB4180B-89A2-8603-2D48-64527CC2719A}"/>
              </a:ext>
            </a:extLst>
          </p:cNvPr>
          <p:cNvSpPr txBox="1"/>
          <p:nvPr/>
        </p:nvSpPr>
        <p:spPr>
          <a:xfrm>
            <a:off x="991892" y="960899"/>
            <a:ext cx="8779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 Irish cohort (n=399)					    (b) UK cohort (n=56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B1C0CAD-25C9-D776-5D8D-76F3ECF10895}"/>
              </a:ext>
            </a:extLst>
          </p:cNvPr>
          <p:cNvSpPr txBox="1"/>
          <p:nvPr/>
        </p:nvSpPr>
        <p:spPr>
          <a:xfrm>
            <a:off x="421820" y="4984257"/>
            <a:ext cx="11348360" cy="1711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Circulating IFNL1, IFNL2 and IFNL3 cytokines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rom plasma of Irish (n=399) and UK (n=56) patients with COVID-19. Cytokines were measured by ELISA and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g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l values log normalized; standard box and whisker plots are shown.</a:t>
            </a:r>
            <a:r>
              <a:rPr lang="en-IE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mples were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ysed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y a paired one way ANOVA with Tukey’s test (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one way ANOVA with paired data with mixed effects analysis (b) ****P&lt;0.0001.</a:t>
            </a:r>
            <a:endParaRPr lang="en-I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24861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63CC86C-DEDC-B2BF-C088-9226B8130DE4}"/>
              </a:ext>
            </a:extLst>
          </p:cNvPr>
          <p:cNvSpPr txBox="1"/>
          <p:nvPr/>
        </p:nvSpPr>
        <p:spPr>
          <a:xfrm>
            <a:off x="560664" y="305196"/>
            <a:ext cx="57790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2: Median IFNL3 levels by </a:t>
            </a:r>
            <a:r>
              <a:rPr lang="en-US" dirty="0" err="1"/>
              <a:t>DfSO</a:t>
            </a:r>
            <a:r>
              <a:rPr lang="en-US" dirty="0"/>
              <a:t> and WHO groupings</a:t>
            </a:r>
          </a:p>
        </p:txBody>
      </p:sp>
      <p:graphicFrame>
        <p:nvGraphicFramePr>
          <p:cNvPr id="7" name="Table 7">
            <a:extLst>
              <a:ext uri="{FF2B5EF4-FFF2-40B4-BE49-F238E27FC236}">
                <a16:creationId xmlns:a16="http://schemas.microsoft.com/office/drawing/2014/main" id="{06B4F92F-D253-FDD3-0CEE-9EA0970AD76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1484883"/>
              </p:ext>
            </p:extLst>
          </p:nvPr>
        </p:nvGraphicFramePr>
        <p:xfrm>
          <a:off x="5732332" y="2172126"/>
          <a:ext cx="2687424" cy="1898307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671856">
                  <a:extLst>
                    <a:ext uri="{9D8B030D-6E8A-4147-A177-3AD203B41FA5}">
                      <a16:colId xmlns:a16="http://schemas.microsoft.com/office/drawing/2014/main" val="1624194942"/>
                    </a:ext>
                  </a:extLst>
                </a:gridCol>
                <a:gridCol w="671856">
                  <a:extLst>
                    <a:ext uri="{9D8B030D-6E8A-4147-A177-3AD203B41FA5}">
                      <a16:colId xmlns:a16="http://schemas.microsoft.com/office/drawing/2014/main" val="1341514871"/>
                    </a:ext>
                  </a:extLst>
                </a:gridCol>
                <a:gridCol w="671856">
                  <a:extLst>
                    <a:ext uri="{9D8B030D-6E8A-4147-A177-3AD203B41FA5}">
                      <a16:colId xmlns:a16="http://schemas.microsoft.com/office/drawing/2014/main" val="2049182624"/>
                    </a:ext>
                  </a:extLst>
                </a:gridCol>
                <a:gridCol w="671856">
                  <a:extLst>
                    <a:ext uri="{9D8B030D-6E8A-4147-A177-3AD203B41FA5}">
                      <a16:colId xmlns:a16="http://schemas.microsoft.com/office/drawing/2014/main" val="2465265562"/>
                    </a:ext>
                  </a:extLst>
                </a:gridCol>
              </a:tblGrid>
              <a:tr h="37510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n=183 →</a:t>
                      </a:r>
                    </a:p>
                    <a:p>
                      <a:pPr algn="ctr"/>
                      <a:r>
                        <a:rPr lang="en-US" sz="1000" dirty="0" err="1">
                          <a:solidFill>
                            <a:schemeClr val="tx1"/>
                          </a:solidFill>
                        </a:rPr>
                        <a:t>DfSO</a:t>
                      </a:r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  ↓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WHO1-2 (n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WHO 3-4 (n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WHO5-8 (n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1138857"/>
                  </a:ext>
                </a:extLst>
              </a:tr>
              <a:tr h="36860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d0-d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2444285"/>
                  </a:ext>
                </a:extLst>
              </a:tr>
              <a:tr h="37510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d8-d14</a:t>
                      </a:r>
                    </a:p>
                    <a:p>
                      <a:pPr algn="ctr"/>
                      <a:endParaRPr lang="en-US" sz="10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0626150"/>
                  </a:ext>
                </a:extLst>
              </a:tr>
              <a:tr h="36860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d15-d3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2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7888571"/>
                  </a:ext>
                </a:extLst>
              </a:tr>
              <a:tr h="36860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d31-d6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4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5860608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86E5E31E-AE5E-C566-E8E2-84FB8ED8242B}"/>
              </a:ext>
            </a:extLst>
          </p:cNvPr>
          <p:cNvSpPr txBox="1"/>
          <p:nvPr/>
        </p:nvSpPr>
        <p:spPr>
          <a:xfrm>
            <a:off x="464948" y="4881966"/>
            <a:ext cx="1142225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2.  IFNL3 was measured from plasma from Irish patients with COVID-19.  Patients were stratified for disease severity based on WHO clinical scores: WHO 1-2 (good), WHO 3-4 (mild) and WHO 5-8 (bad) outcomes as indicated by the </a:t>
            </a:r>
            <a:r>
              <a:rPr lang="en-US" dirty="0" err="1"/>
              <a:t>colour</a:t>
            </a:r>
            <a:r>
              <a:rPr lang="en-US" dirty="0"/>
              <a:t> key.  Information regarding days from symptom onset (</a:t>
            </a:r>
            <a:r>
              <a:rPr lang="en-US" dirty="0" err="1"/>
              <a:t>DfSO</a:t>
            </a:r>
            <a:r>
              <a:rPr lang="en-US" dirty="0"/>
              <a:t>) was available for n=183 patients, and data was further stratified based on sampling at d0-7, d8-14, d15-30 and d31-60 as indicated on the x-axis.  Bars shows the median levels of IFNL while the numbers of samples available for each of these columns is indicated in the Table to  the right of the figure.</a:t>
            </a: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57ACAF26-4AD1-6BBC-4F5A-BEAF7E8607D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97197579"/>
              </p:ext>
            </p:extLst>
          </p:nvPr>
        </p:nvGraphicFramePr>
        <p:xfrm>
          <a:off x="694765" y="17330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9236846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88027C49-5CF0-318D-4D2A-548DC24B6ECF}"/>
              </a:ext>
            </a:extLst>
          </p:cNvPr>
          <p:cNvSpPr txBox="1"/>
          <p:nvPr/>
        </p:nvSpPr>
        <p:spPr>
          <a:xfrm>
            <a:off x="304800" y="30480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9281DA3-BBC3-C166-5EF2-8C6FC737DF9A}"/>
              </a:ext>
            </a:extLst>
          </p:cNvPr>
          <p:cNvSpPr txBox="1"/>
          <p:nvPr/>
        </p:nvSpPr>
        <p:spPr>
          <a:xfrm>
            <a:off x="6705600" y="801510"/>
            <a:ext cx="49219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catter plots of IFNL1 (a), IFNL2 (b) and IFNL3 (c) by WHO score and by </a:t>
            </a:r>
            <a:r>
              <a:rPr lang="en-US" sz="1200" dirty="0" err="1"/>
              <a:t>DfSO</a:t>
            </a:r>
            <a:r>
              <a:rPr lang="en-US" sz="1200" dirty="0"/>
              <a:t>. 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DB6CBBB-0041-A248-73A1-B6A77D1DC732}"/>
              </a:ext>
            </a:extLst>
          </p:cNvPr>
          <p:cNvSpPr txBox="1"/>
          <p:nvPr/>
        </p:nvSpPr>
        <p:spPr>
          <a:xfrm>
            <a:off x="1501422" y="575733"/>
            <a:ext cx="4363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56F9C8E-DBE8-A323-27C7-A31692ACB531}"/>
              </a:ext>
            </a:extLst>
          </p:cNvPr>
          <p:cNvSpPr txBox="1"/>
          <p:nvPr/>
        </p:nvSpPr>
        <p:spPr>
          <a:xfrm>
            <a:off x="1514286" y="2492193"/>
            <a:ext cx="447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30BC8DD-93E1-5CAD-6135-B40E751B60C9}"/>
              </a:ext>
            </a:extLst>
          </p:cNvPr>
          <p:cNvSpPr txBox="1"/>
          <p:nvPr/>
        </p:nvSpPr>
        <p:spPr>
          <a:xfrm>
            <a:off x="1495812" y="4564357"/>
            <a:ext cx="423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c)</a:t>
            </a:r>
          </a:p>
        </p:txBody>
      </p:sp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48B4EECB-6BBC-2642-8922-BC6915A809A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9587544"/>
              </p:ext>
            </p:extLst>
          </p:nvPr>
        </p:nvGraphicFramePr>
        <p:xfrm>
          <a:off x="1707569" y="4374832"/>
          <a:ext cx="4594412" cy="26614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CC411CC4-846A-9C4B-ABCD-F4D6CD692D8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4611696"/>
              </p:ext>
            </p:extLst>
          </p:nvPr>
        </p:nvGraphicFramePr>
        <p:xfrm>
          <a:off x="1738065" y="2157707"/>
          <a:ext cx="4357935" cy="22171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5" name="Chart 14">
            <a:extLst>
              <a:ext uri="{FF2B5EF4-FFF2-40B4-BE49-F238E27FC236}">
                <a16:creationId xmlns:a16="http://schemas.microsoft.com/office/drawing/2014/main" id="{CC411CC4-846A-9C4B-ABCD-F4D6CD692D8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2211388"/>
              </p:ext>
            </p:extLst>
          </p:nvPr>
        </p:nvGraphicFramePr>
        <p:xfrm>
          <a:off x="1812320" y="88549"/>
          <a:ext cx="4170191" cy="19834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4963044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2E53F4D-34E1-69C4-4ACC-7D054E5DCA46}"/>
              </a:ext>
            </a:extLst>
          </p:cNvPr>
          <p:cNvSpPr txBox="1"/>
          <p:nvPr/>
        </p:nvSpPr>
        <p:spPr>
          <a:xfrm>
            <a:off x="827314" y="464457"/>
            <a:ext cx="8915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4: Chi squared analysis of IFNL1 and IFNL2 negative patients within patients who died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9C2CF352-5ACC-A131-8F7F-FF1E8C0C4D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3985439"/>
              </p:ext>
            </p:extLst>
          </p:nvPr>
        </p:nvGraphicFramePr>
        <p:xfrm>
          <a:off x="1224479" y="1914139"/>
          <a:ext cx="5020310" cy="121158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677670">
                  <a:extLst>
                    <a:ext uri="{9D8B030D-6E8A-4147-A177-3AD203B41FA5}">
                      <a16:colId xmlns:a16="http://schemas.microsoft.com/office/drawing/2014/main" val="1877151442"/>
                    </a:ext>
                  </a:extLst>
                </a:gridCol>
                <a:gridCol w="835660">
                  <a:extLst>
                    <a:ext uri="{9D8B030D-6E8A-4147-A177-3AD203B41FA5}">
                      <a16:colId xmlns:a16="http://schemas.microsoft.com/office/drawing/2014/main" val="3230475979"/>
                    </a:ext>
                  </a:extLst>
                </a:gridCol>
                <a:gridCol w="835660">
                  <a:extLst>
                    <a:ext uri="{9D8B030D-6E8A-4147-A177-3AD203B41FA5}">
                      <a16:colId xmlns:a16="http://schemas.microsoft.com/office/drawing/2014/main" val="1877460735"/>
                    </a:ext>
                  </a:extLst>
                </a:gridCol>
                <a:gridCol w="835660">
                  <a:extLst>
                    <a:ext uri="{9D8B030D-6E8A-4147-A177-3AD203B41FA5}">
                      <a16:colId xmlns:a16="http://schemas.microsoft.com/office/drawing/2014/main" val="2982033152"/>
                    </a:ext>
                  </a:extLst>
                </a:gridCol>
                <a:gridCol w="835660">
                  <a:extLst>
                    <a:ext uri="{9D8B030D-6E8A-4147-A177-3AD203B41FA5}">
                      <a16:colId xmlns:a16="http://schemas.microsoft.com/office/drawing/2014/main" val="4232203885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r>
                        <a:rPr lang="en-IE" sz="1100" kern="100" dirty="0">
                          <a:solidFill>
                            <a:schemeClr val="tx1"/>
                          </a:solidFill>
                          <a:effectLst/>
                        </a:rPr>
                        <a:t>Cytokine missing</a:t>
                      </a:r>
                      <a:endParaRPr lang="en-IE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WHO 1-2 (n=183)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WHO 3-4 (n=145)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WHO 5-7 (n=52)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WHO 8 (n=20)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270883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No IFNL1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47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59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20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12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118573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No IFNL2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40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38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16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11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634087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lang="en-IE" sz="1000" kern="100">
                          <a:solidFill>
                            <a:schemeClr val="tx1"/>
                          </a:solidFill>
                          <a:effectLst/>
                        </a:rPr>
                        <a:t>Missing either IFNL1 or IFNL2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70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48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28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16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690984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lang="en-IE" sz="1000" kern="100">
                          <a:solidFill>
                            <a:schemeClr val="tx1"/>
                          </a:solidFill>
                          <a:effectLst/>
                        </a:rPr>
                        <a:t>Missing both INFL1 and IFNL2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17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19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>
                          <a:solidFill>
                            <a:schemeClr val="tx1"/>
                          </a:solidFill>
                          <a:effectLst/>
                        </a:rPr>
                        <a:t>8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100" kern="100" dirty="0"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en-IE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9703506"/>
                  </a:ext>
                </a:extLst>
              </a:tr>
            </a:tbl>
          </a:graphicData>
        </a:graphic>
      </p:graphicFrame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AE67B1BA-6809-337F-C824-EC6577964F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18069881"/>
              </p:ext>
            </p:extLst>
          </p:nvPr>
        </p:nvGraphicFramePr>
        <p:xfrm>
          <a:off x="1251295" y="4206069"/>
          <a:ext cx="5323676" cy="14630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330919">
                  <a:extLst>
                    <a:ext uri="{9D8B030D-6E8A-4147-A177-3AD203B41FA5}">
                      <a16:colId xmlns:a16="http://schemas.microsoft.com/office/drawing/2014/main" val="996098385"/>
                    </a:ext>
                  </a:extLst>
                </a:gridCol>
                <a:gridCol w="1330919">
                  <a:extLst>
                    <a:ext uri="{9D8B030D-6E8A-4147-A177-3AD203B41FA5}">
                      <a16:colId xmlns:a16="http://schemas.microsoft.com/office/drawing/2014/main" val="4026653137"/>
                    </a:ext>
                  </a:extLst>
                </a:gridCol>
                <a:gridCol w="1330919">
                  <a:extLst>
                    <a:ext uri="{9D8B030D-6E8A-4147-A177-3AD203B41FA5}">
                      <a16:colId xmlns:a16="http://schemas.microsoft.com/office/drawing/2014/main" val="3330082281"/>
                    </a:ext>
                  </a:extLst>
                </a:gridCol>
                <a:gridCol w="1330919">
                  <a:extLst>
                    <a:ext uri="{9D8B030D-6E8A-4147-A177-3AD203B41FA5}">
                      <a16:colId xmlns:a16="http://schemas.microsoft.com/office/drawing/2014/main" val="3763491963"/>
                    </a:ext>
                  </a:extLst>
                </a:gridCol>
              </a:tblGrid>
              <a:tr h="302895">
                <a:tc>
                  <a:txBody>
                    <a:bodyPr/>
                    <a:lstStyle/>
                    <a:p>
                      <a:pPr algn="ctr"/>
                      <a:r>
                        <a:rPr lang="en-IE" sz="1200" kern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200" kern="0">
                          <a:solidFill>
                            <a:schemeClr val="tx1"/>
                          </a:solidFill>
                          <a:effectLst/>
                        </a:rPr>
                        <a:t>Observed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200" kern="0" dirty="0">
                          <a:solidFill>
                            <a:schemeClr val="tx1"/>
                          </a:solidFill>
                          <a:effectLst/>
                        </a:rPr>
                        <a:t>Expected</a:t>
                      </a:r>
                      <a:endParaRPr lang="en-IE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200" kern="0">
                          <a:solidFill>
                            <a:schemeClr val="tx1"/>
                          </a:solidFill>
                          <a:effectLst/>
                        </a:rPr>
                        <a:t>Chi-squared P-value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58924205"/>
                  </a:ext>
                </a:extLst>
              </a:tr>
              <a:tr h="302895">
                <a:tc>
                  <a:txBody>
                    <a:bodyPr/>
                    <a:lstStyle/>
                    <a:p>
                      <a:pPr algn="ctr"/>
                      <a:r>
                        <a:rPr lang="en-IE" sz="1200" kern="0">
                          <a:solidFill>
                            <a:schemeClr val="tx1"/>
                          </a:solidFill>
                          <a:effectLst/>
                        </a:rPr>
                        <a:t>Missing either IFNL1 or IFNL2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200" kern="0">
                          <a:solidFill>
                            <a:schemeClr val="tx1"/>
                          </a:solidFill>
                          <a:effectLst/>
                        </a:rPr>
                        <a:t>16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200" kern="0">
                          <a:solidFill>
                            <a:schemeClr val="tx1"/>
                          </a:solidFill>
                          <a:effectLst/>
                        </a:rPr>
                        <a:t>8.2*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IE" sz="1200" kern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ctr"/>
                      <a:r>
                        <a:rPr lang="en-IE" sz="1200" kern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ctr"/>
                      <a:r>
                        <a:rPr lang="en-IE" sz="1200" kern="0">
                          <a:solidFill>
                            <a:schemeClr val="tx1"/>
                          </a:solidFill>
                          <a:effectLst/>
                        </a:rPr>
                        <a:t>0.0004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5121201"/>
                  </a:ext>
                </a:extLst>
              </a:tr>
              <a:tr h="302895">
                <a:tc>
                  <a:txBody>
                    <a:bodyPr/>
                    <a:lstStyle/>
                    <a:p>
                      <a:pPr algn="ctr"/>
                      <a:r>
                        <a:rPr lang="en-IE" sz="1200" kern="0">
                          <a:solidFill>
                            <a:schemeClr val="tx1"/>
                          </a:solidFill>
                          <a:effectLst/>
                        </a:rPr>
                        <a:t>Having both IFNL1 and IFNL2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200" kern="0">
                          <a:solidFill>
                            <a:schemeClr val="tx1"/>
                          </a:solidFill>
                          <a:effectLst/>
                        </a:rPr>
                        <a:t>4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200" kern="0">
                          <a:solidFill>
                            <a:schemeClr val="tx1"/>
                          </a:solidFill>
                          <a:effectLst/>
                        </a:rPr>
                        <a:t>11.8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2038962"/>
                  </a:ext>
                </a:extLst>
              </a:tr>
              <a:tr h="302895">
                <a:tc>
                  <a:txBody>
                    <a:bodyPr/>
                    <a:lstStyle/>
                    <a:p>
                      <a:pPr algn="ctr"/>
                      <a:r>
                        <a:rPr lang="en-IE" sz="1200" kern="0">
                          <a:solidFill>
                            <a:schemeClr val="tx1"/>
                          </a:solidFill>
                          <a:effectLst/>
                        </a:rPr>
                        <a:t>Total patients who died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200" kern="0">
                          <a:solidFill>
                            <a:schemeClr val="tx1"/>
                          </a:solidFill>
                          <a:effectLst/>
                        </a:rPr>
                        <a:t>20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200" kern="0">
                          <a:solidFill>
                            <a:schemeClr val="tx1"/>
                          </a:solidFill>
                          <a:effectLst/>
                        </a:rPr>
                        <a:t>20</a:t>
                      </a:r>
                      <a:endParaRPr lang="en-IE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E" sz="1200" kern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IE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40670744"/>
                  </a:ext>
                </a:extLst>
              </a:tr>
            </a:tbl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15A29BFB-5C9B-332E-DF41-657659EB2103}"/>
              </a:ext>
            </a:extLst>
          </p:cNvPr>
          <p:cNvSpPr txBox="1"/>
          <p:nvPr/>
        </p:nvSpPr>
        <p:spPr>
          <a:xfrm>
            <a:off x="3657600" y="5689600"/>
            <a:ext cx="36458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 Based on the overall cohort of n=399 patients</a:t>
            </a:r>
          </a:p>
        </p:txBody>
      </p:sp>
    </p:spTree>
    <p:extLst>
      <p:ext uri="{BB962C8B-B14F-4D97-AF65-F5344CB8AC3E}">
        <p14:creationId xmlns:p14="http://schemas.microsoft.com/office/powerpoint/2010/main" val="6903326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4">
            <a:extLst>
              <a:ext uri="{FF2B5EF4-FFF2-40B4-BE49-F238E27FC236}">
                <a16:creationId xmlns:a16="http://schemas.microsoft.com/office/drawing/2014/main" id="{293D75BC-8BF4-F83D-3905-F8401470F1C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1837" t="25850" r="42296" b="18232"/>
          <a:stretch/>
        </p:blipFill>
        <p:spPr>
          <a:xfrm>
            <a:off x="662732" y="1659114"/>
            <a:ext cx="3847464" cy="46784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ítulo 1">
            <a:extLst>
              <a:ext uri="{FF2B5EF4-FFF2-40B4-BE49-F238E27FC236}">
                <a16:creationId xmlns:a16="http://schemas.microsoft.com/office/drawing/2014/main" id="{AC255921-220F-E46E-D588-D72CD67CD2B3}"/>
              </a:ext>
            </a:extLst>
          </p:cNvPr>
          <p:cNvSpPr txBox="1">
            <a:spLocks/>
          </p:cNvSpPr>
          <p:nvPr/>
        </p:nvSpPr>
        <p:spPr>
          <a:xfrm>
            <a:off x="838200" y="11785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endParaRPr lang="en-US" sz="3000" b="1"/>
          </a:p>
        </p:txBody>
      </p:sp>
      <p:graphicFrame>
        <p:nvGraphicFramePr>
          <p:cNvPr id="4" name="Table 14">
            <a:extLst>
              <a:ext uri="{FF2B5EF4-FFF2-40B4-BE49-F238E27FC236}">
                <a16:creationId xmlns:a16="http://schemas.microsoft.com/office/drawing/2014/main" id="{266D1F4C-FE7E-902E-06F8-BC9CF7BD85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7922165"/>
              </p:ext>
            </p:extLst>
          </p:nvPr>
        </p:nvGraphicFramePr>
        <p:xfrm>
          <a:off x="5243406" y="1136837"/>
          <a:ext cx="3901440" cy="433324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975360">
                  <a:extLst>
                    <a:ext uri="{9D8B030D-6E8A-4147-A177-3AD203B41FA5}">
                      <a16:colId xmlns:a16="http://schemas.microsoft.com/office/drawing/2014/main" val="879516353"/>
                    </a:ext>
                  </a:extLst>
                </a:gridCol>
                <a:gridCol w="975360">
                  <a:extLst>
                    <a:ext uri="{9D8B030D-6E8A-4147-A177-3AD203B41FA5}">
                      <a16:colId xmlns:a16="http://schemas.microsoft.com/office/drawing/2014/main" val="3313184578"/>
                    </a:ext>
                  </a:extLst>
                </a:gridCol>
                <a:gridCol w="975360">
                  <a:extLst>
                    <a:ext uri="{9D8B030D-6E8A-4147-A177-3AD203B41FA5}">
                      <a16:colId xmlns:a16="http://schemas.microsoft.com/office/drawing/2014/main" val="2025530176"/>
                    </a:ext>
                  </a:extLst>
                </a:gridCol>
                <a:gridCol w="975360">
                  <a:extLst>
                    <a:ext uri="{9D8B030D-6E8A-4147-A177-3AD203B41FA5}">
                      <a16:colId xmlns:a16="http://schemas.microsoft.com/office/drawing/2014/main" val="1569318703"/>
                    </a:ext>
                  </a:extLst>
                </a:gridCol>
              </a:tblGrid>
              <a:tr h="37084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Covid patient sample numbers per WHO groupings</a:t>
                      </a:r>
                    </a:p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379551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Irish cohort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UK cohort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2640237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Sample typ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Plasma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gDNA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gDNA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37017973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Total number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39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319*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24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4696187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Good outcome (WHO 1-2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8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14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43691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Mild outcome (WHO 3-4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45</a:t>
                      </a: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74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(</a:t>
                      </a:r>
                      <a:r>
                        <a:rPr lang="en-US" sz="1100" dirty="0" err="1"/>
                        <a:t>Hospitalised</a:t>
                      </a:r>
                      <a:r>
                        <a:rPr lang="en-US" sz="1100" dirty="0"/>
                        <a:t>)</a:t>
                      </a:r>
                    </a:p>
                    <a:p>
                      <a:pPr algn="ctr"/>
                      <a:r>
                        <a:rPr lang="en-US" sz="1100" dirty="0"/>
                        <a:t>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6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469813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Bad outcome (WHO 5-8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72</a:t>
                      </a: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7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32531048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201BB6C3-7A51-E71F-8E1D-A57B1AA9DC0A}"/>
              </a:ext>
            </a:extLst>
          </p:cNvPr>
          <p:cNvSpPr txBox="1"/>
          <p:nvPr/>
        </p:nvSpPr>
        <p:spPr>
          <a:xfrm>
            <a:off x="1632083" y="560424"/>
            <a:ext cx="802444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Table</a:t>
            </a:r>
            <a:r>
              <a:rPr lang="es-ES" sz="1800" b="1" dirty="0"/>
              <a:t> S1: WHO </a:t>
            </a:r>
            <a:r>
              <a:rPr lang="es-ES" sz="1800" b="1" dirty="0" err="1"/>
              <a:t>categories</a:t>
            </a:r>
            <a:r>
              <a:rPr lang="es-ES" sz="1800" b="1" dirty="0"/>
              <a:t> </a:t>
            </a:r>
            <a:r>
              <a:rPr lang="es-ES" sz="1800" b="1" dirty="0" err="1"/>
              <a:t>for</a:t>
            </a:r>
            <a:r>
              <a:rPr lang="es-ES" sz="1800" b="1" dirty="0"/>
              <a:t> </a:t>
            </a:r>
            <a:r>
              <a:rPr lang="es-ES" sz="1800" b="1" dirty="0" err="1"/>
              <a:t>clinical</a:t>
            </a:r>
            <a:r>
              <a:rPr lang="es-ES" sz="1800" b="1" dirty="0"/>
              <a:t> </a:t>
            </a:r>
            <a:r>
              <a:rPr lang="es-ES" sz="1800" b="1" dirty="0" err="1"/>
              <a:t>outcomes</a:t>
            </a:r>
            <a:r>
              <a:rPr lang="es-ES" sz="1800" b="1" dirty="0"/>
              <a:t> and </a:t>
            </a:r>
            <a:r>
              <a:rPr lang="es-ES" sz="1800" b="1" dirty="0" err="1"/>
              <a:t>numbers</a:t>
            </a:r>
            <a:r>
              <a:rPr lang="es-ES" sz="1800" b="1" dirty="0"/>
              <a:t> </a:t>
            </a:r>
            <a:r>
              <a:rPr lang="es-ES" sz="1800" b="1" dirty="0" err="1"/>
              <a:t>of</a:t>
            </a:r>
            <a:r>
              <a:rPr lang="es-ES" sz="1800" b="1" dirty="0"/>
              <a:t> </a:t>
            </a:r>
            <a:r>
              <a:rPr lang="es-ES" sz="1800" b="1" dirty="0" err="1"/>
              <a:t>samples</a:t>
            </a:r>
            <a:r>
              <a:rPr lang="es-ES" sz="1800" b="1" dirty="0"/>
              <a:t> per </a:t>
            </a:r>
            <a:r>
              <a:rPr lang="es-ES" sz="1800" b="1" dirty="0" err="1"/>
              <a:t>group</a:t>
            </a:r>
            <a:endParaRPr lang="en-US" sz="1800" b="1" dirty="0"/>
          </a:p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0FAF225-B27F-6176-61DB-EEA07797D7F7}"/>
              </a:ext>
            </a:extLst>
          </p:cNvPr>
          <p:cNvSpPr txBox="1"/>
          <p:nvPr/>
        </p:nvSpPr>
        <p:spPr>
          <a:xfrm>
            <a:off x="478465" y="1329070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(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EC0BBB6-0537-0155-8D6E-B5C7AB4FDFA9}"/>
              </a:ext>
            </a:extLst>
          </p:cNvPr>
          <p:cNvSpPr txBox="1"/>
          <p:nvPr/>
        </p:nvSpPr>
        <p:spPr>
          <a:xfrm>
            <a:off x="4749307" y="1489187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(b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3BCF42B-990C-EA10-5DB5-E752A8FE508A}"/>
              </a:ext>
            </a:extLst>
          </p:cNvPr>
          <p:cNvSpPr txBox="1"/>
          <p:nvPr/>
        </p:nvSpPr>
        <p:spPr>
          <a:xfrm>
            <a:off x="6351156" y="5447109"/>
            <a:ext cx="21365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Slightly overlapping</a:t>
            </a:r>
          </a:p>
        </p:txBody>
      </p:sp>
    </p:spTree>
    <p:extLst>
      <p:ext uri="{BB962C8B-B14F-4D97-AF65-F5344CB8AC3E}">
        <p14:creationId xmlns:p14="http://schemas.microsoft.com/office/powerpoint/2010/main" val="1524925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928</TotalTime>
  <Words>564</Words>
  <Application>Microsoft Macintosh PowerPoint</Application>
  <PresentationFormat>Widescreen</PresentationFormat>
  <Paragraphs>120</Paragraphs>
  <Slides>5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air Gardiner</dc:creator>
  <cp:lastModifiedBy>Clair Gardiner</cp:lastModifiedBy>
  <cp:revision>11</cp:revision>
  <cp:lastPrinted>2023-09-07T14:20:51Z</cp:lastPrinted>
  <dcterms:created xsi:type="dcterms:W3CDTF">2023-07-18T09:28:08Z</dcterms:created>
  <dcterms:modified xsi:type="dcterms:W3CDTF">2024-05-22T13:57:57Z</dcterms:modified>
</cp:coreProperties>
</file>